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4" autoAdjust="0"/>
    <p:restoredTop sz="94660"/>
  </p:normalViewPr>
  <p:slideViewPr>
    <p:cSldViewPr snapToGrid="0">
      <p:cViewPr varScale="1">
        <p:scale>
          <a:sx n="85" d="100"/>
          <a:sy n="85" d="100"/>
        </p:scale>
        <p:origin x="122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D8488F9-CA59-4E1E-B78A-7EDD09AFBBAA}" type="doc">
      <dgm:prSet loTypeId="urn:microsoft.com/office/officeart/2008/layout/HorizontalMultiLevelHierarchy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US"/>
        </a:p>
      </dgm:t>
    </dgm:pt>
    <dgm:pt modelId="{DB863807-68D1-48D1-835B-44DE16AEECF3}">
      <dgm:prSet phldrT="[Text]"/>
      <dgm:spPr/>
      <dgm:t>
        <a:bodyPr/>
        <a:lstStyle/>
        <a:p>
          <a:r>
            <a:rPr lang="en-US" dirty="0" smtClean="0">
              <a:latin typeface="Arial" panose="020B0604020202020204" pitchFamily="34" charset="0"/>
              <a:cs typeface="Arial" panose="020B0604020202020204" pitchFamily="34" charset="0"/>
            </a:rPr>
            <a:t>50 </a:t>
          </a:r>
          <a:r>
            <a:rPr lang="en-US" dirty="0">
              <a:latin typeface="Arial" panose="020B0604020202020204" pitchFamily="34" charset="0"/>
              <a:cs typeface="Arial" panose="020B0604020202020204" pitchFamily="34" charset="0"/>
            </a:rPr>
            <a:t>unique trials</a:t>
          </a:r>
        </a:p>
      </dgm:t>
    </dgm:pt>
    <dgm:pt modelId="{F8B7C80A-DFE3-4DC5-A260-772411889970}" type="parTrans" cxnId="{7EAA1C39-8BDB-46C2-A2F7-89A99F00C85F}">
      <dgm:prSet/>
      <dgm:spPr/>
      <dgm:t>
        <a:bodyPr/>
        <a:lstStyle/>
        <a:p>
          <a:endParaRPr lang="en-US"/>
        </a:p>
      </dgm:t>
    </dgm:pt>
    <dgm:pt modelId="{235ECEC0-A1BF-4B9B-807F-7AD239930831}" type="sibTrans" cxnId="{7EAA1C39-8BDB-46C2-A2F7-89A99F00C85F}">
      <dgm:prSet/>
      <dgm:spPr/>
      <dgm:t>
        <a:bodyPr/>
        <a:lstStyle/>
        <a:p>
          <a:endParaRPr lang="en-US"/>
        </a:p>
      </dgm:t>
    </dgm:pt>
    <dgm:pt modelId="{9F0DA4E6-6AB7-41FE-8070-50C4E5B8715E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17 indications</a:t>
          </a:r>
        </a:p>
      </dgm:t>
    </dgm:pt>
    <dgm:pt modelId="{7A2808FA-D9CF-4A80-967D-2DB8C6585047}" type="parTrans" cxnId="{440E977B-7358-4101-80BF-25EAEB109892}">
      <dgm:prSet/>
      <dgm:spPr/>
      <dgm:t>
        <a:bodyPr/>
        <a:lstStyle/>
        <a:p>
          <a:endParaRPr lang="en-US"/>
        </a:p>
      </dgm:t>
    </dgm:pt>
    <dgm:pt modelId="{BA4AFD99-B3C2-4E4F-83C1-4A5E752EDE8F}" type="sibTrans" cxnId="{440E977B-7358-4101-80BF-25EAEB109892}">
      <dgm:prSet/>
      <dgm:spPr/>
      <dgm:t>
        <a:bodyPr/>
        <a:lstStyle/>
        <a:p>
          <a:endParaRPr lang="en-US"/>
        </a:p>
      </dgm:t>
    </dgm:pt>
    <dgm:pt modelId="{3B38241B-4131-4EA3-9B03-5AA80B152DAA}">
      <dgm:prSet phldrT="[Text]" custT="1"/>
      <dgm:spPr/>
      <dgm:t>
        <a:bodyPr/>
        <a:lstStyle/>
        <a:p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Not yet recruiting (2)</a:t>
          </a:r>
          <a:b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Recruiting (</a:t>
          </a:r>
          <a:r>
            <a:rPr lang="en-US" sz="900" dirty="0" smtClean="0">
              <a:latin typeface="Arial" panose="020B0604020202020204" pitchFamily="34" charset="0"/>
              <a:cs typeface="Arial" panose="020B0604020202020204" pitchFamily="34" charset="0"/>
            </a:rPr>
            <a:t>24)</a:t>
          </a: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/>
          </a:r>
          <a:b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Active (13)</a:t>
          </a:r>
          <a:b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Completed </a:t>
          </a:r>
          <a:r>
            <a:rPr lang="en-US" sz="900" dirty="0" smtClean="0">
              <a:latin typeface="Arial" panose="020B0604020202020204" pitchFamily="34" charset="0"/>
              <a:cs typeface="Arial" panose="020B0604020202020204" pitchFamily="34" charset="0"/>
            </a:rPr>
            <a:t>(11)</a:t>
          </a:r>
          <a:endParaRPr lang="en-US" sz="9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DD62CB5-CFDD-4840-B8F5-CF1D6DC06C6E}" type="parTrans" cxnId="{2AB5EC62-ABB4-4583-BFB0-11965B6019EC}">
      <dgm:prSet/>
      <dgm:spPr/>
      <dgm:t>
        <a:bodyPr/>
        <a:lstStyle/>
        <a:p>
          <a:endParaRPr lang="en-US"/>
        </a:p>
      </dgm:t>
    </dgm:pt>
    <dgm:pt modelId="{D6507A19-53DB-4084-A7E3-6AE11FFF9340}" type="sibTrans" cxnId="{2AB5EC62-ABB4-4583-BFB0-11965B6019EC}">
      <dgm:prSet/>
      <dgm:spPr/>
      <dgm:t>
        <a:bodyPr/>
        <a:lstStyle/>
        <a:p>
          <a:endParaRPr lang="en-US"/>
        </a:p>
      </dgm:t>
    </dgm:pt>
    <dgm:pt modelId="{0E36E291-16E4-4737-92AE-1583297C9CA4}">
      <dgm:prSet phldrT="[Text]" custT="1"/>
      <dgm:spPr/>
      <dgm:t>
        <a:bodyPr/>
        <a:lstStyle/>
        <a:p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Europe (</a:t>
          </a:r>
          <a:r>
            <a:rPr lang="en-US" sz="900" dirty="0" smtClean="0">
              <a:latin typeface="Arial" panose="020B0604020202020204" pitchFamily="34" charset="0"/>
              <a:cs typeface="Arial" panose="020B0604020202020204" pitchFamily="34" charset="0"/>
            </a:rPr>
            <a:t>13)</a:t>
          </a: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/>
          </a:r>
          <a:b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North America </a:t>
          </a:r>
          <a:r>
            <a:rPr lang="en-US" sz="900" dirty="0" smtClean="0">
              <a:latin typeface="Arial" panose="020B0604020202020204" pitchFamily="34" charset="0"/>
              <a:cs typeface="Arial" panose="020B0604020202020204" pitchFamily="34" charset="0"/>
            </a:rPr>
            <a:t>(21)</a:t>
          </a: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/>
          </a:r>
          <a:b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Cross-continent </a:t>
          </a:r>
          <a:r>
            <a:rPr lang="en-US" sz="900" dirty="0" smtClean="0">
              <a:latin typeface="Arial" panose="020B0604020202020204" pitchFamily="34" charset="0"/>
              <a:cs typeface="Arial" panose="020B0604020202020204" pitchFamily="34" charset="0"/>
            </a:rPr>
            <a:t>(10)</a:t>
          </a: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/>
          </a:r>
          <a:b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No details (2)</a:t>
          </a:r>
          <a:b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Other </a:t>
          </a:r>
          <a:r>
            <a:rPr lang="en-US" sz="900" dirty="0" smtClean="0">
              <a:latin typeface="Arial" panose="020B0604020202020204" pitchFamily="34" charset="0"/>
              <a:cs typeface="Arial" panose="020B0604020202020204" pitchFamily="34" charset="0"/>
            </a:rPr>
            <a:t>(4)</a:t>
          </a:r>
          <a:endParaRPr lang="en-US" sz="9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EC7BC250-206D-4415-BEA1-374E010C5787}" type="parTrans" cxnId="{E8E58ADF-5A3E-458E-BA04-20F74872BA9E}">
      <dgm:prSet/>
      <dgm:spPr/>
      <dgm:t>
        <a:bodyPr/>
        <a:lstStyle/>
        <a:p>
          <a:endParaRPr lang="en-US"/>
        </a:p>
      </dgm:t>
    </dgm:pt>
    <dgm:pt modelId="{930E4A1C-0B54-4B2D-B91F-CFE2184ADD3E}" type="sibTrans" cxnId="{E8E58ADF-5A3E-458E-BA04-20F74872BA9E}">
      <dgm:prSet/>
      <dgm:spPr/>
      <dgm:t>
        <a:bodyPr/>
        <a:lstStyle/>
        <a:p>
          <a:endParaRPr lang="en-US"/>
        </a:p>
      </dgm:t>
    </dgm:pt>
    <dgm:pt modelId="{907B1B9B-ECA6-4BEE-A722-EC2FFB3680D0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Achromatopia CNGA3 (2); CNGB3 (2)</a:t>
          </a:r>
        </a:p>
      </dgm:t>
    </dgm:pt>
    <dgm:pt modelId="{D3042A99-D4F2-41B5-8F86-40C7CAE69AB2}" type="parTrans" cxnId="{9D125D1D-DC21-493E-B062-8947D4D1FA05}">
      <dgm:prSet/>
      <dgm:spPr/>
      <dgm:t>
        <a:bodyPr/>
        <a:lstStyle/>
        <a:p>
          <a:endParaRPr lang="en-US"/>
        </a:p>
      </dgm:t>
    </dgm:pt>
    <dgm:pt modelId="{D980D24C-9655-4DA7-9AC9-E7D028D586A2}" type="sibTrans" cxnId="{9D125D1D-DC21-493E-B062-8947D4D1FA05}">
      <dgm:prSet/>
      <dgm:spPr/>
      <dgm:t>
        <a:bodyPr/>
        <a:lstStyle/>
        <a:p>
          <a:endParaRPr lang="en-US"/>
        </a:p>
      </dgm:t>
    </dgm:pt>
    <dgm:pt modelId="{B8F951F1-0876-4D5D-8FDC-E1892E3FDD52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Choroideremia (8)</a:t>
          </a:r>
        </a:p>
      </dgm:t>
    </dgm:pt>
    <dgm:pt modelId="{DC379277-C327-44BA-8E38-7721D3680BBF}" type="parTrans" cxnId="{732EDAB2-A5C5-4D9B-87DC-3693C946A119}">
      <dgm:prSet/>
      <dgm:spPr/>
      <dgm:t>
        <a:bodyPr/>
        <a:lstStyle/>
        <a:p>
          <a:endParaRPr lang="en-US"/>
        </a:p>
      </dgm:t>
    </dgm:pt>
    <dgm:pt modelId="{11BE97A4-CCE9-42B0-8556-8FAFCC3E3460}" type="sibTrans" cxnId="{732EDAB2-A5C5-4D9B-87DC-3693C946A119}">
      <dgm:prSet/>
      <dgm:spPr/>
      <dgm:t>
        <a:bodyPr/>
        <a:lstStyle/>
        <a:p>
          <a:endParaRPr lang="en-US"/>
        </a:p>
      </dgm:t>
    </dgm:pt>
    <dgm:pt modelId="{7AC16027-874A-4B00-9484-F5A42AA27E4F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LCA RPE65 (9); CEP290 (1)</a:t>
          </a:r>
        </a:p>
      </dgm:t>
    </dgm:pt>
    <dgm:pt modelId="{C658F482-DF29-4B3B-A07B-AD14AD1D5C69}" type="parTrans" cxnId="{F45BCBF4-C1C2-4180-B5C2-A3251DD2C9EA}">
      <dgm:prSet/>
      <dgm:spPr/>
      <dgm:t>
        <a:bodyPr/>
        <a:lstStyle/>
        <a:p>
          <a:endParaRPr lang="en-US"/>
        </a:p>
      </dgm:t>
    </dgm:pt>
    <dgm:pt modelId="{EABB49BA-5F5C-40AC-84E7-B9D676BA3C92}" type="sibTrans" cxnId="{F45BCBF4-C1C2-4180-B5C2-A3251DD2C9EA}">
      <dgm:prSet/>
      <dgm:spPr/>
      <dgm:t>
        <a:bodyPr/>
        <a:lstStyle/>
        <a:p>
          <a:endParaRPr lang="en-US"/>
        </a:p>
      </dgm:t>
    </dgm:pt>
    <dgm:pt modelId="{2AA0A808-362A-4E43-9B46-3F766B5220BB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LHON (8)</a:t>
          </a:r>
        </a:p>
      </dgm:t>
    </dgm:pt>
    <dgm:pt modelId="{7F9A3AFF-8CE4-4C74-A22E-97A3AB34FDCF}" type="parTrans" cxnId="{53EAAD50-CFC1-46B5-A5F1-C64AA283344F}">
      <dgm:prSet/>
      <dgm:spPr/>
      <dgm:t>
        <a:bodyPr/>
        <a:lstStyle/>
        <a:p>
          <a:endParaRPr lang="en-US"/>
        </a:p>
      </dgm:t>
    </dgm:pt>
    <dgm:pt modelId="{AED33D2D-88F7-4CEF-9FFC-6CECC09DB2F9}" type="sibTrans" cxnId="{53EAAD50-CFC1-46B5-A5F1-C64AA283344F}">
      <dgm:prSet/>
      <dgm:spPr/>
      <dgm:t>
        <a:bodyPr/>
        <a:lstStyle/>
        <a:p>
          <a:endParaRPr lang="en-US"/>
        </a:p>
      </dgm:t>
    </dgm:pt>
    <dgm:pt modelId="{163272B5-FA91-4958-99F0-01272988D46C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RP RPGR (3); MERTK (1); PDE6</a:t>
          </a:r>
          <a:r>
            <a:rPr lang="el-GR" sz="900">
              <a:latin typeface="Arial" panose="020B0604020202020204" pitchFamily="34" charset="0"/>
              <a:cs typeface="Arial" panose="020B0604020202020204" pitchFamily="34" charset="0"/>
            </a:rPr>
            <a:t>β</a:t>
          </a:r>
          <a:r>
            <a:rPr lang="en-GB" sz="900">
              <a:latin typeface="Arial" panose="020B0604020202020204" pitchFamily="34" charset="0"/>
              <a:cs typeface="Arial" panose="020B0604020202020204" pitchFamily="34" charset="0"/>
            </a:rPr>
            <a:t> (1); RLBP1 (1); Non-syndromic (1); Advanced RP (1)</a:t>
          </a:r>
          <a:endParaRPr lang="en-US" sz="9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682C0709-9E9D-41F8-B06D-3E7341C52348}" type="parTrans" cxnId="{491AFAAD-C0E1-4E94-856F-4B955E2966C1}">
      <dgm:prSet/>
      <dgm:spPr/>
      <dgm:t>
        <a:bodyPr/>
        <a:lstStyle/>
        <a:p>
          <a:endParaRPr lang="en-US"/>
        </a:p>
      </dgm:t>
    </dgm:pt>
    <dgm:pt modelId="{7614C7FC-E14D-41E3-925B-8C1EBD1CAD63}" type="sibTrans" cxnId="{491AFAAD-C0E1-4E94-856F-4B955E2966C1}">
      <dgm:prSet/>
      <dgm:spPr/>
      <dgm:t>
        <a:bodyPr/>
        <a:lstStyle/>
        <a:p>
          <a:endParaRPr lang="en-US"/>
        </a:p>
      </dgm:t>
    </dgm:pt>
    <dgm:pt modelId="{4F824936-EEAE-477A-94E1-085DAC5C9D3C}" type="asst">
      <dgm:prSet phldrT="[Text]" custT="1"/>
      <dgm:spPr/>
      <dgm:t>
        <a:bodyPr/>
        <a:lstStyle/>
        <a:p>
          <a:r>
            <a:rPr lang="en-US" sz="900" dirty="0" err="1" smtClean="0">
              <a:latin typeface="Arial" panose="020B0604020202020204" pitchFamily="34" charset="0"/>
              <a:cs typeface="Arial" panose="020B0604020202020204" pitchFamily="34" charset="0"/>
            </a:rPr>
            <a:t>Stagardts</a:t>
          </a:r>
          <a:r>
            <a:rPr lang="en-US" sz="900" dirty="0" smtClean="0">
              <a:latin typeface="Arial" panose="020B0604020202020204" pitchFamily="34" charset="0"/>
              <a:cs typeface="Arial" panose="020B0604020202020204" pitchFamily="34" charset="0"/>
            </a:rPr>
            <a:t> (1)</a:t>
          </a:r>
          <a:endParaRPr lang="en-US" sz="9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5228426-4069-4FD3-B1B6-2A6131818E5A}" type="parTrans" cxnId="{4127DB69-3C00-4930-9252-70D711642816}">
      <dgm:prSet/>
      <dgm:spPr/>
      <dgm:t>
        <a:bodyPr/>
        <a:lstStyle/>
        <a:p>
          <a:endParaRPr lang="en-US"/>
        </a:p>
      </dgm:t>
    </dgm:pt>
    <dgm:pt modelId="{F246A413-1DCA-422A-91D4-1E5396A68C63}" type="sibTrans" cxnId="{4127DB69-3C00-4930-9252-70D711642816}">
      <dgm:prSet/>
      <dgm:spPr/>
      <dgm:t>
        <a:bodyPr/>
        <a:lstStyle/>
        <a:p>
          <a:endParaRPr lang="en-US"/>
        </a:p>
      </dgm:t>
    </dgm:pt>
    <dgm:pt modelId="{04694563-0CDC-44CE-A9A0-707A504A5839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X-linked retinoschisis (1)</a:t>
          </a:r>
        </a:p>
      </dgm:t>
    </dgm:pt>
    <dgm:pt modelId="{10EC9B84-4143-4860-B9E4-8C811825C3C2}" type="parTrans" cxnId="{0953E2FE-9B61-41BD-A8C9-99BF795BD3DC}">
      <dgm:prSet/>
      <dgm:spPr/>
      <dgm:t>
        <a:bodyPr/>
        <a:lstStyle/>
        <a:p>
          <a:endParaRPr lang="en-US"/>
        </a:p>
      </dgm:t>
    </dgm:pt>
    <dgm:pt modelId="{07F7B919-387F-4E49-9F6C-6B1C1456EF10}" type="sibTrans" cxnId="{0953E2FE-9B61-41BD-A8C9-99BF795BD3DC}">
      <dgm:prSet/>
      <dgm:spPr/>
      <dgm:t>
        <a:bodyPr/>
        <a:lstStyle/>
        <a:p>
          <a:endParaRPr lang="en-US"/>
        </a:p>
      </dgm:t>
    </dgm:pt>
    <dgm:pt modelId="{C9E29CE9-D9ED-4EB6-875D-B2713E1107BB}" type="asst">
      <dgm:prSet phldrT="[Text]" custT="1"/>
      <dgm:spPr/>
      <dgm:t>
        <a:bodyPr/>
        <a:lstStyle/>
        <a:p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AMD dry (1); </a:t>
          </a:r>
          <a:r>
            <a:rPr lang="en-US" sz="900" dirty="0" err="1">
              <a:latin typeface="Arial" panose="020B0604020202020204" pitchFamily="34" charset="0"/>
              <a:cs typeface="Arial" panose="020B0604020202020204" pitchFamily="34" charset="0"/>
            </a:rPr>
            <a:t>neovascular</a:t>
          </a:r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 (4)</a:t>
          </a:r>
        </a:p>
      </dgm:t>
    </dgm:pt>
    <dgm:pt modelId="{6752D7DA-2AC0-42AF-BBAE-E5D7A2A38F52}" type="parTrans" cxnId="{A000E859-6DAE-4764-8F13-0C09E9756DB3}">
      <dgm:prSet/>
      <dgm:spPr/>
      <dgm:t>
        <a:bodyPr/>
        <a:lstStyle/>
        <a:p>
          <a:endParaRPr lang="en-US"/>
        </a:p>
      </dgm:t>
    </dgm:pt>
    <dgm:pt modelId="{730FE39C-81A9-4009-B615-F5FB2F1E53FA}" type="sibTrans" cxnId="{A000E859-6DAE-4764-8F13-0C09E9756DB3}">
      <dgm:prSet/>
      <dgm:spPr/>
      <dgm:t>
        <a:bodyPr/>
        <a:lstStyle/>
        <a:p>
          <a:endParaRPr lang="en-US"/>
        </a:p>
      </dgm:t>
    </dgm:pt>
    <dgm:pt modelId="{AAFEDFF3-7262-457D-868C-3B7CC5E9E6FD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/2</a:t>
          </a:r>
        </a:p>
      </dgm:t>
    </dgm:pt>
    <dgm:pt modelId="{02B85F9D-5D86-40C8-9FBB-51DBE1475DDB}" type="parTrans" cxnId="{B7E9AD71-2E8F-4F9A-A556-A0DE9487C54E}">
      <dgm:prSet/>
      <dgm:spPr/>
      <dgm:t>
        <a:bodyPr/>
        <a:lstStyle/>
        <a:p>
          <a:endParaRPr lang="en-US"/>
        </a:p>
      </dgm:t>
    </dgm:pt>
    <dgm:pt modelId="{2CD73C8F-4036-455C-9509-885147F64FCF}" type="sibTrans" cxnId="{B7E9AD71-2E8F-4F9A-A556-A0DE9487C54E}">
      <dgm:prSet/>
      <dgm:spPr/>
      <dgm:t>
        <a:bodyPr/>
        <a:lstStyle/>
        <a:p>
          <a:endParaRPr lang="en-US"/>
        </a:p>
      </dgm:t>
    </dgm:pt>
    <dgm:pt modelId="{12B7AA39-7294-49E2-9AD1-5D9B28ABBCD0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/2 (3)</a:t>
          </a:r>
        </a:p>
      </dgm:t>
    </dgm:pt>
    <dgm:pt modelId="{DFD75553-0E6E-46BA-A20F-4B82AE13638E}" type="parTrans" cxnId="{08167016-4DEC-4237-9226-969E31DF68CF}">
      <dgm:prSet/>
      <dgm:spPr/>
      <dgm:t>
        <a:bodyPr/>
        <a:lstStyle/>
        <a:p>
          <a:endParaRPr lang="en-US"/>
        </a:p>
      </dgm:t>
    </dgm:pt>
    <dgm:pt modelId="{9B6342D8-EEC7-4B1F-844E-0BD3AA1D5EBF}" type="sibTrans" cxnId="{08167016-4DEC-4237-9226-969E31DF68CF}">
      <dgm:prSet/>
      <dgm:spPr/>
      <dgm:t>
        <a:bodyPr/>
        <a:lstStyle/>
        <a:p>
          <a:endParaRPr lang="en-US"/>
        </a:p>
      </dgm:t>
    </dgm:pt>
    <dgm:pt modelId="{31548E82-F2D1-424A-A955-20ADDF32729A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2 (4)</a:t>
          </a:r>
        </a:p>
      </dgm:t>
    </dgm:pt>
    <dgm:pt modelId="{5540D525-2741-4CAB-A8BD-E9C7F6576A9A}" type="parTrans" cxnId="{131DA9F6-3FAA-4D35-8337-D6BC1B7593EA}">
      <dgm:prSet/>
      <dgm:spPr/>
      <dgm:t>
        <a:bodyPr/>
        <a:lstStyle/>
        <a:p>
          <a:endParaRPr lang="en-US"/>
        </a:p>
      </dgm:t>
    </dgm:pt>
    <dgm:pt modelId="{64D465D4-903E-48AE-9E4E-CFE97F8FCAF1}" type="sibTrans" cxnId="{131DA9F6-3FAA-4D35-8337-D6BC1B7593EA}">
      <dgm:prSet/>
      <dgm:spPr/>
      <dgm:t>
        <a:bodyPr/>
        <a:lstStyle/>
        <a:p>
          <a:endParaRPr lang="en-US"/>
        </a:p>
      </dgm:t>
    </dgm:pt>
    <dgm:pt modelId="{D9CB76B7-43FE-49B8-A1A5-3F399C0DBC76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3 (1)</a:t>
          </a:r>
        </a:p>
      </dgm:t>
    </dgm:pt>
    <dgm:pt modelId="{914F4210-5B9E-4980-97F7-9832C4DD30E8}" type="parTrans" cxnId="{0D97F2FC-9758-495C-9242-532A07A3BC99}">
      <dgm:prSet/>
      <dgm:spPr/>
      <dgm:t>
        <a:bodyPr/>
        <a:lstStyle/>
        <a:p>
          <a:endParaRPr lang="en-US"/>
        </a:p>
      </dgm:t>
    </dgm:pt>
    <dgm:pt modelId="{91AA9908-8FEA-40CB-90F0-61CDC289A405}" type="sibTrans" cxnId="{0D97F2FC-9758-495C-9242-532A07A3BC99}">
      <dgm:prSet/>
      <dgm:spPr/>
      <dgm:t>
        <a:bodyPr/>
        <a:lstStyle/>
        <a:p>
          <a:endParaRPr lang="en-US"/>
        </a:p>
      </dgm:t>
    </dgm:pt>
    <dgm:pt modelId="{241D139F-6324-4ACF-AA63-C03946F4B69B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 (3)</a:t>
          </a:r>
        </a:p>
      </dgm:t>
    </dgm:pt>
    <dgm:pt modelId="{FE75DAA3-E36C-4224-AF68-160B569ADEA1}" type="parTrans" cxnId="{313C53F2-2739-4CF3-AFE4-508CB6DB655D}">
      <dgm:prSet/>
      <dgm:spPr/>
      <dgm:t>
        <a:bodyPr/>
        <a:lstStyle/>
        <a:p>
          <a:endParaRPr lang="en-US"/>
        </a:p>
      </dgm:t>
    </dgm:pt>
    <dgm:pt modelId="{A6B35C58-E779-4555-80A1-75FC4FA9BDB9}" type="sibTrans" cxnId="{313C53F2-2739-4CF3-AFE4-508CB6DB655D}">
      <dgm:prSet/>
      <dgm:spPr/>
      <dgm:t>
        <a:bodyPr/>
        <a:lstStyle/>
        <a:p>
          <a:endParaRPr lang="en-US"/>
        </a:p>
      </dgm:t>
    </dgm:pt>
    <dgm:pt modelId="{EA7CE3B7-DE08-411B-B462-44DB760A778C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/2 (5)</a:t>
          </a:r>
        </a:p>
      </dgm:t>
    </dgm:pt>
    <dgm:pt modelId="{74B95A49-6389-4C00-9037-4D593ECB2321}" type="parTrans" cxnId="{AE0ED4C0-5CA1-491C-9168-CD39B6B8AF52}">
      <dgm:prSet/>
      <dgm:spPr/>
      <dgm:t>
        <a:bodyPr/>
        <a:lstStyle/>
        <a:p>
          <a:endParaRPr lang="en-US"/>
        </a:p>
      </dgm:t>
    </dgm:pt>
    <dgm:pt modelId="{49FF4827-2986-47FC-A00F-1F8F5BDF0589}" type="sibTrans" cxnId="{AE0ED4C0-5CA1-491C-9168-CD39B6B8AF52}">
      <dgm:prSet/>
      <dgm:spPr/>
      <dgm:t>
        <a:bodyPr/>
        <a:lstStyle/>
        <a:p>
          <a:endParaRPr lang="en-US"/>
        </a:p>
      </dgm:t>
    </dgm:pt>
    <dgm:pt modelId="{C20BB801-8511-462F-849B-48B8148621D5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3 (1)</a:t>
          </a:r>
        </a:p>
      </dgm:t>
    </dgm:pt>
    <dgm:pt modelId="{965BA46E-FDDC-4058-922A-312962713AE0}" type="parTrans" cxnId="{F05E0773-AFF5-4E02-84C8-ACD3FFD00AE8}">
      <dgm:prSet/>
      <dgm:spPr/>
      <dgm:t>
        <a:bodyPr/>
        <a:lstStyle/>
        <a:p>
          <a:endParaRPr lang="en-US"/>
        </a:p>
      </dgm:t>
    </dgm:pt>
    <dgm:pt modelId="{394E5467-DA77-4BBF-966D-89A8582F2EE2}" type="sibTrans" cxnId="{F05E0773-AFF5-4E02-84C8-ACD3FFD00AE8}">
      <dgm:prSet/>
      <dgm:spPr/>
      <dgm:t>
        <a:bodyPr/>
        <a:lstStyle/>
        <a:p>
          <a:endParaRPr lang="en-US"/>
        </a:p>
      </dgm:t>
    </dgm:pt>
    <dgm:pt modelId="{89904C7D-191B-44E6-8B73-8B4A4666B243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 (1)</a:t>
          </a:r>
        </a:p>
      </dgm:t>
    </dgm:pt>
    <dgm:pt modelId="{B3E97CCC-D8F2-4A81-991C-51C9BF2A6F43}" type="parTrans" cxnId="{C8EDF35B-CA7E-44DC-90F0-B11F585F36EE}">
      <dgm:prSet/>
      <dgm:spPr/>
      <dgm:t>
        <a:bodyPr/>
        <a:lstStyle/>
        <a:p>
          <a:endParaRPr lang="en-US"/>
        </a:p>
      </dgm:t>
    </dgm:pt>
    <dgm:pt modelId="{BF480FDD-70EC-4CF5-B917-F2A20EDFA41C}" type="sibTrans" cxnId="{C8EDF35B-CA7E-44DC-90F0-B11F585F36EE}">
      <dgm:prSet/>
      <dgm:spPr/>
      <dgm:t>
        <a:bodyPr/>
        <a:lstStyle/>
        <a:p>
          <a:endParaRPr lang="en-US"/>
        </a:p>
      </dgm:t>
    </dgm:pt>
    <dgm:pt modelId="{E74928B5-AAE7-4EE8-81D7-514794113F1A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/2 (2)</a:t>
          </a:r>
        </a:p>
      </dgm:t>
    </dgm:pt>
    <dgm:pt modelId="{15419740-8019-43E9-B6B0-C06F14B37B04}" type="parTrans" cxnId="{8025CFD1-EF0D-4179-B8DA-621D731161B4}">
      <dgm:prSet/>
      <dgm:spPr/>
      <dgm:t>
        <a:bodyPr/>
        <a:lstStyle/>
        <a:p>
          <a:endParaRPr lang="en-US"/>
        </a:p>
      </dgm:t>
    </dgm:pt>
    <dgm:pt modelId="{7A2C0B21-747F-41C6-AF9E-7C0BBECB8F79}" type="sibTrans" cxnId="{8025CFD1-EF0D-4179-B8DA-621D731161B4}">
      <dgm:prSet/>
      <dgm:spPr/>
      <dgm:t>
        <a:bodyPr/>
        <a:lstStyle/>
        <a:p>
          <a:endParaRPr lang="en-US"/>
        </a:p>
      </dgm:t>
    </dgm:pt>
    <dgm:pt modelId="{F9BB6BB1-7D55-459B-AF73-859533C8E860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2/3 (1)</a:t>
          </a:r>
        </a:p>
      </dgm:t>
    </dgm:pt>
    <dgm:pt modelId="{043607C2-812B-4762-B64A-5CD082B12B08}" type="parTrans" cxnId="{2C25C959-1D89-426B-A29E-D25B3D4BE695}">
      <dgm:prSet/>
      <dgm:spPr/>
      <dgm:t>
        <a:bodyPr/>
        <a:lstStyle/>
        <a:p>
          <a:endParaRPr lang="en-US"/>
        </a:p>
      </dgm:t>
    </dgm:pt>
    <dgm:pt modelId="{15206345-544A-4E5F-B86A-442B039EBF6E}" type="sibTrans" cxnId="{2C25C959-1D89-426B-A29E-D25B3D4BE695}">
      <dgm:prSet/>
      <dgm:spPr/>
      <dgm:t>
        <a:bodyPr/>
        <a:lstStyle/>
        <a:p>
          <a:endParaRPr lang="en-US"/>
        </a:p>
      </dgm:t>
    </dgm:pt>
    <dgm:pt modelId="{662C0AE4-FF05-4D26-A34F-AF2104520F5D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3 (3)</a:t>
          </a:r>
        </a:p>
      </dgm:t>
    </dgm:pt>
    <dgm:pt modelId="{8E358C9A-6C64-4EE5-9066-85B40192709A}" type="parTrans" cxnId="{51F42BC1-CEB6-4CE2-98A6-E0909F09261E}">
      <dgm:prSet/>
      <dgm:spPr/>
      <dgm:t>
        <a:bodyPr/>
        <a:lstStyle/>
        <a:p>
          <a:endParaRPr lang="en-US"/>
        </a:p>
      </dgm:t>
    </dgm:pt>
    <dgm:pt modelId="{BF932F64-EB13-4223-90E5-E183BCC55BF2}" type="sibTrans" cxnId="{51F42BC1-CEB6-4CE2-98A6-E0909F09261E}">
      <dgm:prSet/>
      <dgm:spPr/>
      <dgm:t>
        <a:bodyPr/>
        <a:lstStyle/>
        <a:p>
          <a:endParaRPr lang="en-US"/>
        </a:p>
      </dgm:t>
    </dgm:pt>
    <dgm:pt modelId="{C21058F5-47B6-4297-8195-25FAC184670C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Unspecified (2)</a:t>
          </a:r>
        </a:p>
      </dgm:t>
    </dgm:pt>
    <dgm:pt modelId="{9DC8773C-3093-411F-BF47-518C239FBFCA}" type="parTrans" cxnId="{B9CF7E9B-5B07-4388-B905-B8F0664760B2}">
      <dgm:prSet/>
      <dgm:spPr/>
      <dgm:t>
        <a:bodyPr/>
        <a:lstStyle/>
        <a:p>
          <a:endParaRPr lang="en-US"/>
        </a:p>
      </dgm:t>
    </dgm:pt>
    <dgm:pt modelId="{D055AE86-B3E5-4C74-92AA-D6292B26E156}" type="sibTrans" cxnId="{B9CF7E9B-5B07-4388-B905-B8F0664760B2}">
      <dgm:prSet/>
      <dgm:spPr/>
      <dgm:t>
        <a:bodyPr/>
        <a:lstStyle/>
        <a:p>
          <a:endParaRPr lang="en-US"/>
        </a:p>
      </dgm:t>
    </dgm:pt>
    <dgm:pt modelId="{14A1D4EB-D46A-4EAA-9058-A0F03BEE701D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 (1)</a:t>
          </a:r>
        </a:p>
      </dgm:t>
    </dgm:pt>
    <dgm:pt modelId="{71EF7A92-5EF4-4681-B8F2-D60279767D5E}" type="parTrans" cxnId="{293522AA-0D73-4145-83AF-E6E749AEED05}">
      <dgm:prSet/>
      <dgm:spPr/>
      <dgm:t>
        <a:bodyPr/>
        <a:lstStyle/>
        <a:p>
          <a:endParaRPr lang="en-US"/>
        </a:p>
      </dgm:t>
    </dgm:pt>
    <dgm:pt modelId="{BCAFF64B-EF41-42EA-B33A-3DEC990853FE}" type="sibTrans" cxnId="{293522AA-0D73-4145-83AF-E6E749AEED05}">
      <dgm:prSet/>
      <dgm:spPr/>
      <dgm:t>
        <a:bodyPr/>
        <a:lstStyle/>
        <a:p>
          <a:endParaRPr lang="en-US"/>
        </a:p>
      </dgm:t>
    </dgm:pt>
    <dgm:pt modelId="{071AAAAD-8791-457E-8470-D878A59BD241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/2 ()</a:t>
          </a:r>
        </a:p>
      </dgm:t>
    </dgm:pt>
    <dgm:pt modelId="{CC8DED40-504F-4A4D-B60D-0E822D5048E2}" type="parTrans" cxnId="{76E5CBB8-4193-4A72-88F9-E72E043F7551}">
      <dgm:prSet/>
      <dgm:spPr/>
      <dgm:t>
        <a:bodyPr/>
        <a:lstStyle/>
        <a:p>
          <a:endParaRPr lang="en-US"/>
        </a:p>
      </dgm:t>
    </dgm:pt>
    <dgm:pt modelId="{997C293A-EABB-40E8-8CA8-02553900164D}" type="sibTrans" cxnId="{76E5CBB8-4193-4A72-88F9-E72E043F7551}">
      <dgm:prSet/>
      <dgm:spPr/>
      <dgm:t>
        <a:bodyPr/>
        <a:lstStyle/>
        <a:p>
          <a:endParaRPr lang="en-US"/>
        </a:p>
      </dgm:t>
    </dgm:pt>
    <dgm:pt modelId="{F43AACF9-221E-4BD7-8472-436B58689816}" type="asst">
      <dgm:prSet phldrT="[Text]" custT="1"/>
      <dgm:spPr/>
      <dgm:t>
        <a:bodyPr/>
        <a:lstStyle/>
        <a:p>
          <a:r>
            <a:rPr lang="en-US" sz="900" dirty="0">
              <a:latin typeface="Arial" panose="020B0604020202020204" pitchFamily="34" charset="0"/>
              <a:cs typeface="Arial" panose="020B0604020202020204" pitchFamily="34" charset="0"/>
            </a:rPr>
            <a:t>Phase 1/2</a:t>
          </a:r>
        </a:p>
      </dgm:t>
    </dgm:pt>
    <dgm:pt modelId="{1F2D1459-DF4F-4534-BD50-8CA02C19177D}" type="parTrans" cxnId="{E8D22FCB-5A63-4907-BFED-7783A8C1003D}">
      <dgm:prSet/>
      <dgm:spPr/>
      <dgm:t>
        <a:bodyPr/>
        <a:lstStyle/>
        <a:p>
          <a:endParaRPr lang="en-US"/>
        </a:p>
      </dgm:t>
    </dgm:pt>
    <dgm:pt modelId="{49BED331-0427-4141-9934-E75AF2FB0D8E}" type="sibTrans" cxnId="{E8D22FCB-5A63-4907-BFED-7783A8C1003D}">
      <dgm:prSet/>
      <dgm:spPr/>
      <dgm:t>
        <a:bodyPr/>
        <a:lstStyle/>
        <a:p>
          <a:endParaRPr lang="en-US"/>
        </a:p>
      </dgm:t>
    </dgm:pt>
    <dgm:pt modelId="{C21B325D-FB32-4F11-BA86-37F754BB16FF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/2</a:t>
          </a:r>
        </a:p>
      </dgm:t>
    </dgm:pt>
    <dgm:pt modelId="{B6ADC0EF-4DE2-49AA-BC86-AD69D14FBB20}" type="parTrans" cxnId="{1ADB41AE-EC9F-4DC1-A8CF-775E9467FDAD}">
      <dgm:prSet/>
      <dgm:spPr/>
      <dgm:t>
        <a:bodyPr/>
        <a:lstStyle/>
        <a:p>
          <a:endParaRPr lang="en-US"/>
        </a:p>
      </dgm:t>
    </dgm:pt>
    <dgm:pt modelId="{9D24EF50-F866-4C4A-BC09-91BD19701C81}" type="sibTrans" cxnId="{1ADB41AE-EC9F-4DC1-A8CF-775E9467FDAD}">
      <dgm:prSet/>
      <dgm:spPr/>
      <dgm:t>
        <a:bodyPr/>
        <a:lstStyle/>
        <a:p>
          <a:endParaRPr lang="en-US"/>
        </a:p>
      </dgm:t>
    </dgm:pt>
    <dgm:pt modelId="{EB106A67-DB70-4226-8605-1052C09DA4E6}" type="asst">
      <dgm:prSet phldrT="[Text]"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 (5)</a:t>
          </a:r>
        </a:p>
      </dgm:t>
    </dgm:pt>
    <dgm:pt modelId="{EFFFF2CC-B614-45BF-9375-15ED5B8AAFA3}" type="parTrans" cxnId="{9421050C-BA42-4924-8C80-2E6E17056BB7}">
      <dgm:prSet/>
      <dgm:spPr/>
      <dgm:t>
        <a:bodyPr/>
        <a:lstStyle/>
        <a:p>
          <a:endParaRPr lang="en-US"/>
        </a:p>
      </dgm:t>
    </dgm:pt>
    <dgm:pt modelId="{6946FADF-4963-43FB-9C7C-EA0810ED3671}" type="sibTrans" cxnId="{9421050C-BA42-4924-8C80-2E6E17056BB7}">
      <dgm:prSet/>
      <dgm:spPr/>
      <dgm:t>
        <a:bodyPr/>
        <a:lstStyle/>
        <a:p>
          <a:endParaRPr lang="en-US"/>
        </a:p>
      </dgm:t>
    </dgm:pt>
    <dgm:pt modelId="{BE2240EA-4EA6-4066-ABD8-A340FBEBDE12}">
      <dgm:prSet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Ushers syndrome 1B</a:t>
          </a:r>
        </a:p>
      </dgm:t>
    </dgm:pt>
    <dgm:pt modelId="{F2AFAC63-15C8-4981-9A67-F1DE8DC0153F}" type="parTrans" cxnId="{DDB4DF60-0C81-4CDF-8F93-171EA81F8B5E}">
      <dgm:prSet/>
      <dgm:spPr/>
      <dgm:t>
        <a:bodyPr/>
        <a:lstStyle/>
        <a:p>
          <a:endParaRPr lang="en-US"/>
        </a:p>
      </dgm:t>
    </dgm:pt>
    <dgm:pt modelId="{FC920B73-D4CE-4900-BE63-E374A9D4F749}" type="sibTrans" cxnId="{DDB4DF60-0C81-4CDF-8F93-171EA81F8B5E}">
      <dgm:prSet/>
      <dgm:spPr/>
      <dgm:t>
        <a:bodyPr/>
        <a:lstStyle/>
        <a:p>
          <a:endParaRPr lang="en-US"/>
        </a:p>
      </dgm:t>
    </dgm:pt>
    <dgm:pt modelId="{0657636B-EFF1-416F-9BD5-2691D2A75023}">
      <dgm:prSet custT="1"/>
      <dgm:spPr/>
      <dgm:t>
        <a:bodyPr/>
        <a:lstStyle/>
        <a:p>
          <a:r>
            <a:rPr lang="en-US" sz="900">
              <a:latin typeface="Arial" panose="020B0604020202020204" pitchFamily="34" charset="0"/>
              <a:cs typeface="Arial" panose="020B0604020202020204" pitchFamily="34" charset="0"/>
            </a:rPr>
            <a:t>Phase 1/2</a:t>
          </a:r>
        </a:p>
      </dgm:t>
    </dgm:pt>
    <dgm:pt modelId="{744304DD-CC18-4659-B854-EE14F8BA0780}" type="parTrans" cxnId="{81AD324B-560B-4CB8-A49E-D98B0EF95B59}">
      <dgm:prSet/>
      <dgm:spPr/>
      <dgm:t>
        <a:bodyPr/>
        <a:lstStyle/>
        <a:p>
          <a:endParaRPr lang="en-US"/>
        </a:p>
      </dgm:t>
    </dgm:pt>
    <dgm:pt modelId="{095CBC92-DE9B-4FEA-967F-0F1498F442DE}" type="sibTrans" cxnId="{81AD324B-560B-4CB8-A49E-D98B0EF95B59}">
      <dgm:prSet/>
      <dgm:spPr/>
      <dgm:t>
        <a:bodyPr/>
        <a:lstStyle/>
        <a:p>
          <a:endParaRPr lang="en-US"/>
        </a:p>
      </dgm:t>
    </dgm:pt>
    <dgm:pt modelId="{D5D4FB50-B364-42DC-BEFD-E40B7198D856}" type="asst">
      <dgm:prSet/>
      <dgm:spPr/>
      <dgm:t>
        <a:bodyPr/>
        <a:lstStyle/>
        <a:p>
          <a:r>
            <a:rPr lang="en-US" dirty="0" smtClean="0">
              <a:latin typeface="Arial" panose="020B0604020202020204" pitchFamily="34" charset="0"/>
              <a:cs typeface="Arial" panose="020B0604020202020204" pitchFamily="34" charset="0"/>
            </a:rPr>
            <a:t>Gyrate atrophy (1)</a:t>
          </a:r>
          <a:endParaRPr lang="en-US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D6FEC866-8B8D-4B3F-9C64-E41CE3FA1A6B}" type="parTrans" cxnId="{DB0C5E18-CB39-4630-A95D-59AA84D13AD8}">
      <dgm:prSet/>
      <dgm:spPr/>
      <dgm:t>
        <a:bodyPr/>
        <a:lstStyle/>
        <a:p>
          <a:endParaRPr lang="en-US"/>
        </a:p>
      </dgm:t>
    </dgm:pt>
    <dgm:pt modelId="{8C948AF1-C6B4-4214-BE77-EE24898ACF3B}" type="sibTrans" cxnId="{DB0C5E18-CB39-4630-A95D-59AA84D13AD8}">
      <dgm:prSet/>
      <dgm:spPr/>
      <dgm:t>
        <a:bodyPr/>
        <a:lstStyle/>
        <a:p>
          <a:endParaRPr lang="en-US"/>
        </a:p>
      </dgm:t>
    </dgm:pt>
    <dgm:pt modelId="{64FB4822-5D01-405E-A2FC-6C9581874534}">
      <dgm:prSet/>
      <dgm:spPr/>
      <dgm:t>
        <a:bodyPr/>
        <a:lstStyle/>
        <a:p>
          <a:r>
            <a:rPr lang="en-US" dirty="0" smtClean="0">
              <a:latin typeface="Arial" panose="020B0604020202020204" pitchFamily="34" charset="0"/>
              <a:cs typeface="Arial" panose="020B0604020202020204" pitchFamily="34" charset="0"/>
            </a:rPr>
            <a:t>Phase I</a:t>
          </a:r>
          <a:endParaRPr lang="en-US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11B4C912-86B2-426D-9B12-5566593C72E7}" type="parTrans" cxnId="{66800EF4-D803-4611-955B-F56B86B33776}">
      <dgm:prSet/>
      <dgm:spPr/>
      <dgm:t>
        <a:bodyPr/>
        <a:lstStyle/>
        <a:p>
          <a:endParaRPr lang="en-US"/>
        </a:p>
      </dgm:t>
    </dgm:pt>
    <dgm:pt modelId="{DFC7F15E-C9FB-46CE-BC56-870677B79A5B}" type="sibTrans" cxnId="{66800EF4-D803-4611-955B-F56B86B33776}">
      <dgm:prSet/>
      <dgm:spPr/>
      <dgm:t>
        <a:bodyPr/>
        <a:lstStyle/>
        <a:p>
          <a:endParaRPr lang="en-US"/>
        </a:p>
      </dgm:t>
    </dgm:pt>
    <dgm:pt modelId="{170A78D5-93C1-4672-A2D6-72EF750020EB}" type="pres">
      <dgm:prSet presAssocID="{CD8488F9-CA59-4E1E-B78A-7EDD09AFBBAA}" presName="Name0" presStyleCnt="0">
        <dgm:presLayoutVars>
          <dgm:chPref val="1"/>
          <dgm:dir/>
          <dgm:animOne val="branch"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02B8A451-AC2C-4436-84F6-65C3A7F002C7}" type="pres">
      <dgm:prSet presAssocID="{DB863807-68D1-48D1-835B-44DE16AEECF3}" presName="root1" presStyleCnt="0"/>
      <dgm:spPr/>
    </dgm:pt>
    <dgm:pt modelId="{1358FD25-A296-417B-8C32-0545935AECEA}" type="pres">
      <dgm:prSet presAssocID="{DB863807-68D1-48D1-835B-44DE16AEECF3}" presName="LevelOneTextNode" presStyleLbl="node0" presStyleIdx="0" presStyleCnt="1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64D5179-8A0A-40FC-BD45-DB24978D6F15}" type="pres">
      <dgm:prSet presAssocID="{DB863807-68D1-48D1-835B-44DE16AEECF3}" presName="level2hierChild" presStyleCnt="0"/>
      <dgm:spPr/>
    </dgm:pt>
    <dgm:pt modelId="{C3824F10-A10E-4549-B7A9-1C8ED929AE83}" type="pres">
      <dgm:prSet presAssocID="{7A2808FA-D9CF-4A80-967D-2DB8C6585047}" presName="conn2-1" presStyleLbl="parChTrans1D2" presStyleIdx="0" presStyleCnt="3"/>
      <dgm:spPr/>
      <dgm:t>
        <a:bodyPr/>
        <a:lstStyle/>
        <a:p>
          <a:endParaRPr lang="en-US"/>
        </a:p>
      </dgm:t>
    </dgm:pt>
    <dgm:pt modelId="{4A680F8A-FBBC-4BF5-9FFF-0E20FF8A2653}" type="pres">
      <dgm:prSet presAssocID="{7A2808FA-D9CF-4A80-967D-2DB8C6585047}" presName="connTx" presStyleLbl="parChTrans1D2" presStyleIdx="0" presStyleCnt="3"/>
      <dgm:spPr/>
      <dgm:t>
        <a:bodyPr/>
        <a:lstStyle/>
        <a:p>
          <a:endParaRPr lang="en-US"/>
        </a:p>
      </dgm:t>
    </dgm:pt>
    <dgm:pt modelId="{77664059-FFF8-416B-A751-CC7D3303F271}" type="pres">
      <dgm:prSet presAssocID="{9F0DA4E6-6AB7-41FE-8070-50C4E5B8715E}" presName="root2" presStyleCnt="0"/>
      <dgm:spPr/>
    </dgm:pt>
    <dgm:pt modelId="{5950EC2C-60B2-40BD-A6A0-E7A8BAC442F1}" type="pres">
      <dgm:prSet presAssocID="{9F0DA4E6-6AB7-41FE-8070-50C4E5B8715E}" presName="LevelTwoTextNode" presStyleLbl="asst1" presStyleIdx="0" presStyleCnt="27" custScaleX="233781" custScaleY="12194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2E62747-30D6-4D1D-BB89-7F1C84ED7D04}" type="pres">
      <dgm:prSet presAssocID="{9F0DA4E6-6AB7-41FE-8070-50C4E5B8715E}" presName="level3hierChild" presStyleCnt="0"/>
      <dgm:spPr/>
    </dgm:pt>
    <dgm:pt modelId="{3EA92CF5-981D-4617-8805-BD784484C463}" type="pres">
      <dgm:prSet presAssocID="{D3042A99-D4F2-41B5-8F86-40C7CAE69AB2}" presName="conn2-1" presStyleLbl="parChTrans1D3" presStyleIdx="0" presStyleCnt="10"/>
      <dgm:spPr/>
      <dgm:t>
        <a:bodyPr/>
        <a:lstStyle/>
        <a:p>
          <a:endParaRPr lang="en-US"/>
        </a:p>
      </dgm:t>
    </dgm:pt>
    <dgm:pt modelId="{15DEE82D-2EBD-424B-B4D5-9B60623B048E}" type="pres">
      <dgm:prSet presAssocID="{D3042A99-D4F2-41B5-8F86-40C7CAE69AB2}" presName="connTx" presStyleLbl="parChTrans1D3" presStyleIdx="0" presStyleCnt="10"/>
      <dgm:spPr/>
      <dgm:t>
        <a:bodyPr/>
        <a:lstStyle/>
        <a:p>
          <a:endParaRPr lang="en-US"/>
        </a:p>
      </dgm:t>
    </dgm:pt>
    <dgm:pt modelId="{FB3B054B-D947-42FD-B51F-11DF716CC292}" type="pres">
      <dgm:prSet presAssocID="{907B1B9B-ECA6-4BEE-A722-EC2FFB3680D0}" presName="root2" presStyleCnt="0"/>
      <dgm:spPr/>
    </dgm:pt>
    <dgm:pt modelId="{20D5FBEA-911F-425D-A3CA-BF1B3A8EE1DA}" type="pres">
      <dgm:prSet presAssocID="{907B1B9B-ECA6-4BEE-A722-EC2FFB3680D0}" presName="LevelTwoTextNode" presStyleLbl="asst1" presStyleIdx="1" presStyleCnt="27" custScaleX="136200" custScaleY="233778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EA19026D-C0E9-45E3-A915-A80C3D7913FE}" type="pres">
      <dgm:prSet presAssocID="{907B1B9B-ECA6-4BEE-A722-EC2FFB3680D0}" presName="level3hierChild" presStyleCnt="0"/>
      <dgm:spPr/>
    </dgm:pt>
    <dgm:pt modelId="{AA29A888-0A17-4B4C-870A-E5E95ABD4FAA}" type="pres">
      <dgm:prSet presAssocID="{02B85F9D-5D86-40C8-9FBB-51DBE1475DDB}" presName="conn2-1" presStyleLbl="parChTrans1D4" presStyleIdx="0" presStyleCnt="19"/>
      <dgm:spPr/>
      <dgm:t>
        <a:bodyPr/>
        <a:lstStyle/>
        <a:p>
          <a:endParaRPr lang="en-US"/>
        </a:p>
      </dgm:t>
    </dgm:pt>
    <dgm:pt modelId="{15F6125B-B568-4421-B0DC-F55286F024FF}" type="pres">
      <dgm:prSet presAssocID="{02B85F9D-5D86-40C8-9FBB-51DBE1475DDB}" presName="connTx" presStyleLbl="parChTrans1D4" presStyleIdx="0" presStyleCnt="19"/>
      <dgm:spPr/>
      <dgm:t>
        <a:bodyPr/>
        <a:lstStyle/>
        <a:p>
          <a:endParaRPr lang="en-US"/>
        </a:p>
      </dgm:t>
    </dgm:pt>
    <dgm:pt modelId="{ABD03198-5AE2-48C0-9398-1BD6BBCB5F91}" type="pres">
      <dgm:prSet presAssocID="{AAFEDFF3-7262-457D-868C-3B7CC5E9E6FD}" presName="root2" presStyleCnt="0"/>
      <dgm:spPr/>
    </dgm:pt>
    <dgm:pt modelId="{034CFA1F-7B89-45F2-B399-AD34489603B2}" type="pres">
      <dgm:prSet presAssocID="{AAFEDFF3-7262-457D-868C-3B7CC5E9E6FD}" presName="LevelTwoTextNode" presStyleLbl="asst1" presStyleIdx="2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FAD9C84A-4DDD-4965-8A9B-D38BF2A2E54F}" type="pres">
      <dgm:prSet presAssocID="{AAFEDFF3-7262-457D-868C-3B7CC5E9E6FD}" presName="level3hierChild" presStyleCnt="0"/>
      <dgm:spPr/>
    </dgm:pt>
    <dgm:pt modelId="{FFB10C08-8AB4-475C-A934-5DA1E07ACD7C}" type="pres">
      <dgm:prSet presAssocID="{DC379277-C327-44BA-8E38-7721D3680BBF}" presName="conn2-1" presStyleLbl="parChTrans1D3" presStyleIdx="1" presStyleCnt="10"/>
      <dgm:spPr/>
      <dgm:t>
        <a:bodyPr/>
        <a:lstStyle/>
        <a:p>
          <a:endParaRPr lang="en-US"/>
        </a:p>
      </dgm:t>
    </dgm:pt>
    <dgm:pt modelId="{D6B8B294-83DE-452C-825B-2D17F4DEC758}" type="pres">
      <dgm:prSet presAssocID="{DC379277-C327-44BA-8E38-7721D3680BBF}" presName="connTx" presStyleLbl="parChTrans1D3" presStyleIdx="1" presStyleCnt="10"/>
      <dgm:spPr/>
      <dgm:t>
        <a:bodyPr/>
        <a:lstStyle/>
        <a:p>
          <a:endParaRPr lang="en-US"/>
        </a:p>
      </dgm:t>
    </dgm:pt>
    <dgm:pt modelId="{4D9D6197-5B45-4EFC-A55B-31EBB68AF734}" type="pres">
      <dgm:prSet presAssocID="{B8F951F1-0876-4D5D-8FDC-E1892E3FDD52}" presName="root2" presStyleCnt="0"/>
      <dgm:spPr/>
    </dgm:pt>
    <dgm:pt modelId="{833AEC7A-B99D-48C0-871D-A4179B8964EB}" type="pres">
      <dgm:prSet presAssocID="{B8F951F1-0876-4D5D-8FDC-E1892E3FDD52}" presName="LevelTwoTextNode" presStyleLbl="asst1" presStyleIdx="3" presStyleCnt="27" custScaleX="15536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9BF7422-43E5-4A9C-A905-CB23037EBDA7}" type="pres">
      <dgm:prSet presAssocID="{B8F951F1-0876-4D5D-8FDC-E1892E3FDD52}" presName="level3hierChild" presStyleCnt="0"/>
      <dgm:spPr/>
    </dgm:pt>
    <dgm:pt modelId="{145B8CA3-BB26-4DB4-AC81-AFBE26AF21EB}" type="pres">
      <dgm:prSet presAssocID="{DFD75553-0E6E-46BA-A20F-4B82AE13638E}" presName="conn2-1" presStyleLbl="parChTrans1D4" presStyleIdx="1" presStyleCnt="19"/>
      <dgm:spPr/>
      <dgm:t>
        <a:bodyPr/>
        <a:lstStyle/>
        <a:p>
          <a:endParaRPr lang="en-US"/>
        </a:p>
      </dgm:t>
    </dgm:pt>
    <dgm:pt modelId="{FB2D46A2-1817-4DCE-B72E-E6F9B2BAE590}" type="pres">
      <dgm:prSet presAssocID="{DFD75553-0E6E-46BA-A20F-4B82AE13638E}" presName="connTx" presStyleLbl="parChTrans1D4" presStyleIdx="1" presStyleCnt="19"/>
      <dgm:spPr/>
      <dgm:t>
        <a:bodyPr/>
        <a:lstStyle/>
        <a:p>
          <a:endParaRPr lang="en-US"/>
        </a:p>
      </dgm:t>
    </dgm:pt>
    <dgm:pt modelId="{0D133FD9-9FB5-4731-AAA7-5998ADA5A215}" type="pres">
      <dgm:prSet presAssocID="{12B7AA39-7294-49E2-9AD1-5D9B28ABBCD0}" presName="root2" presStyleCnt="0"/>
      <dgm:spPr/>
    </dgm:pt>
    <dgm:pt modelId="{2CBD4155-2ED1-46FA-83BC-97CAA04F9980}" type="pres">
      <dgm:prSet presAssocID="{12B7AA39-7294-49E2-9AD1-5D9B28ABBCD0}" presName="LevelTwoTextNode" presStyleLbl="asst1" presStyleIdx="4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6160B20-8915-4EF2-87A0-097E2222A302}" type="pres">
      <dgm:prSet presAssocID="{12B7AA39-7294-49E2-9AD1-5D9B28ABBCD0}" presName="level3hierChild" presStyleCnt="0"/>
      <dgm:spPr/>
    </dgm:pt>
    <dgm:pt modelId="{A4E749FA-28E1-4471-ACD8-81F784E93244}" type="pres">
      <dgm:prSet presAssocID="{5540D525-2741-4CAB-A8BD-E9C7F6576A9A}" presName="conn2-1" presStyleLbl="parChTrans1D4" presStyleIdx="2" presStyleCnt="19"/>
      <dgm:spPr/>
      <dgm:t>
        <a:bodyPr/>
        <a:lstStyle/>
        <a:p>
          <a:endParaRPr lang="en-US"/>
        </a:p>
      </dgm:t>
    </dgm:pt>
    <dgm:pt modelId="{1A97882B-88EC-4ACB-9DC7-C524B4434DD2}" type="pres">
      <dgm:prSet presAssocID="{5540D525-2741-4CAB-A8BD-E9C7F6576A9A}" presName="connTx" presStyleLbl="parChTrans1D4" presStyleIdx="2" presStyleCnt="19"/>
      <dgm:spPr/>
      <dgm:t>
        <a:bodyPr/>
        <a:lstStyle/>
        <a:p>
          <a:endParaRPr lang="en-US"/>
        </a:p>
      </dgm:t>
    </dgm:pt>
    <dgm:pt modelId="{83F0C548-B70F-4C1A-8A80-4CA15A5E11B7}" type="pres">
      <dgm:prSet presAssocID="{31548E82-F2D1-424A-A955-20ADDF32729A}" presName="root2" presStyleCnt="0"/>
      <dgm:spPr/>
    </dgm:pt>
    <dgm:pt modelId="{32191076-4C62-4EFB-974A-465CDC7D6560}" type="pres">
      <dgm:prSet presAssocID="{31548E82-F2D1-424A-A955-20ADDF32729A}" presName="LevelTwoTextNode" presStyleLbl="asst1" presStyleIdx="5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4B49978-767C-4836-91E7-8A773EAEB142}" type="pres">
      <dgm:prSet presAssocID="{31548E82-F2D1-424A-A955-20ADDF32729A}" presName="level3hierChild" presStyleCnt="0"/>
      <dgm:spPr/>
    </dgm:pt>
    <dgm:pt modelId="{59EFD662-F5B9-4E51-96F1-5AF65A05E852}" type="pres">
      <dgm:prSet presAssocID="{914F4210-5B9E-4980-97F7-9832C4DD30E8}" presName="conn2-1" presStyleLbl="parChTrans1D4" presStyleIdx="3" presStyleCnt="19"/>
      <dgm:spPr/>
      <dgm:t>
        <a:bodyPr/>
        <a:lstStyle/>
        <a:p>
          <a:endParaRPr lang="en-US"/>
        </a:p>
      </dgm:t>
    </dgm:pt>
    <dgm:pt modelId="{57EACCEA-F453-4574-9F35-453FAAE65FAE}" type="pres">
      <dgm:prSet presAssocID="{914F4210-5B9E-4980-97F7-9832C4DD30E8}" presName="connTx" presStyleLbl="parChTrans1D4" presStyleIdx="3" presStyleCnt="19"/>
      <dgm:spPr/>
      <dgm:t>
        <a:bodyPr/>
        <a:lstStyle/>
        <a:p>
          <a:endParaRPr lang="en-US"/>
        </a:p>
      </dgm:t>
    </dgm:pt>
    <dgm:pt modelId="{C5C4D434-5A0F-431C-8080-57B36CD346AE}" type="pres">
      <dgm:prSet presAssocID="{D9CB76B7-43FE-49B8-A1A5-3F399C0DBC76}" presName="root2" presStyleCnt="0"/>
      <dgm:spPr/>
    </dgm:pt>
    <dgm:pt modelId="{F3622D4E-BCD1-4B03-B6CA-2B65BC37B6F2}" type="pres">
      <dgm:prSet presAssocID="{D9CB76B7-43FE-49B8-A1A5-3F399C0DBC76}" presName="LevelTwoTextNode" presStyleLbl="asst1" presStyleIdx="6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F1BB4D31-91E7-4BDA-B802-D657606724B6}" type="pres">
      <dgm:prSet presAssocID="{D9CB76B7-43FE-49B8-A1A5-3F399C0DBC76}" presName="level3hierChild" presStyleCnt="0"/>
      <dgm:spPr/>
    </dgm:pt>
    <dgm:pt modelId="{C8FC8D5D-30F7-471E-B8B8-5F224FEE8B53}" type="pres">
      <dgm:prSet presAssocID="{C658F482-DF29-4B3B-A07B-AD14AD1D5C69}" presName="conn2-1" presStyleLbl="parChTrans1D3" presStyleIdx="2" presStyleCnt="10"/>
      <dgm:spPr/>
      <dgm:t>
        <a:bodyPr/>
        <a:lstStyle/>
        <a:p>
          <a:endParaRPr lang="en-US"/>
        </a:p>
      </dgm:t>
    </dgm:pt>
    <dgm:pt modelId="{5342639D-3AF5-4D66-A9BD-D9379B93D203}" type="pres">
      <dgm:prSet presAssocID="{C658F482-DF29-4B3B-A07B-AD14AD1D5C69}" presName="connTx" presStyleLbl="parChTrans1D3" presStyleIdx="2" presStyleCnt="10"/>
      <dgm:spPr/>
      <dgm:t>
        <a:bodyPr/>
        <a:lstStyle/>
        <a:p>
          <a:endParaRPr lang="en-US"/>
        </a:p>
      </dgm:t>
    </dgm:pt>
    <dgm:pt modelId="{1E8EBB80-319D-4E65-BF00-32ABDA32C187}" type="pres">
      <dgm:prSet presAssocID="{7AC16027-874A-4B00-9484-F5A42AA27E4F}" presName="root2" presStyleCnt="0"/>
      <dgm:spPr/>
    </dgm:pt>
    <dgm:pt modelId="{1127B8D7-3CD0-4F1D-9C2C-F99E8698E420}" type="pres">
      <dgm:prSet presAssocID="{7AC16027-874A-4B00-9484-F5A42AA27E4F}" presName="LevelTwoTextNode" presStyleLbl="asst1" presStyleIdx="7" presStyleCnt="27" custScaleX="12348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2C4B51F-C124-4830-802D-9567EFF4261B}" type="pres">
      <dgm:prSet presAssocID="{7AC16027-874A-4B00-9484-F5A42AA27E4F}" presName="level3hierChild" presStyleCnt="0"/>
      <dgm:spPr/>
    </dgm:pt>
    <dgm:pt modelId="{80816A0F-AC68-4311-884A-5F8A58F08D7A}" type="pres">
      <dgm:prSet presAssocID="{FE75DAA3-E36C-4224-AF68-160B569ADEA1}" presName="conn2-1" presStyleLbl="parChTrans1D4" presStyleIdx="4" presStyleCnt="19"/>
      <dgm:spPr/>
      <dgm:t>
        <a:bodyPr/>
        <a:lstStyle/>
        <a:p>
          <a:endParaRPr lang="en-US"/>
        </a:p>
      </dgm:t>
    </dgm:pt>
    <dgm:pt modelId="{9F40458A-8537-45BD-A0BA-E3C93C1910FD}" type="pres">
      <dgm:prSet presAssocID="{FE75DAA3-E36C-4224-AF68-160B569ADEA1}" presName="connTx" presStyleLbl="parChTrans1D4" presStyleIdx="4" presStyleCnt="19"/>
      <dgm:spPr/>
      <dgm:t>
        <a:bodyPr/>
        <a:lstStyle/>
        <a:p>
          <a:endParaRPr lang="en-US"/>
        </a:p>
      </dgm:t>
    </dgm:pt>
    <dgm:pt modelId="{41B9F395-6A34-4E93-BE57-D9FA94787FDB}" type="pres">
      <dgm:prSet presAssocID="{241D139F-6324-4ACF-AA63-C03946F4B69B}" presName="root2" presStyleCnt="0"/>
      <dgm:spPr/>
    </dgm:pt>
    <dgm:pt modelId="{C3950836-6B16-410D-AB8D-A64C6FAB238C}" type="pres">
      <dgm:prSet presAssocID="{241D139F-6324-4ACF-AA63-C03946F4B69B}" presName="LevelTwoTextNode" presStyleLbl="asst1" presStyleIdx="8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CC44E0EF-F249-43A4-88BF-09221F711D61}" type="pres">
      <dgm:prSet presAssocID="{241D139F-6324-4ACF-AA63-C03946F4B69B}" presName="level3hierChild" presStyleCnt="0"/>
      <dgm:spPr/>
    </dgm:pt>
    <dgm:pt modelId="{641C7868-5C94-4B0C-AE68-14A543E74986}" type="pres">
      <dgm:prSet presAssocID="{74B95A49-6389-4C00-9037-4D593ECB2321}" presName="conn2-1" presStyleLbl="parChTrans1D4" presStyleIdx="5" presStyleCnt="19"/>
      <dgm:spPr/>
      <dgm:t>
        <a:bodyPr/>
        <a:lstStyle/>
        <a:p>
          <a:endParaRPr lang="en-US"/>
        </a:p>
      </dgm:t>
    </dgm:pt>
    <dgm:pt modelId="{E2616EF7-4194-4236-85F9-832BC8793282}" type="pres">
      <dgm:prSet presAssocID="{74B95A49-6389-4C00-9037-4D593ECB2321}" presName="connTx" presStyleLbl="parChTrans1D4" presStyleIdx="5" presStyleCnt="19"/>
      <dgm:spPr/>
      <dgm:t>
        <a:bodyPr/>
        <a:lstStyle/>
        <a:p>
          <a:endParaRPr lang="en-US"/>
        </a:p>
      </dgm:t>
    </dgm:pt>
    <dgm:pt modelId="{C123B81C-35F4-4152-8BBF-E13B02C20AE1}" type="pres">
      <dgm:prSet presAssocID="{EA7CE3B7-DE08-411B-B462-44DB760A778C}" presName="root2" presStyleCnt="0"/>
      <dgm:spPr/>
    </dgm:pt>
    <dgm:pt modelId="{1933C373-9436-497B-AC32-4A55FA51135A}" type="pres">
      <dgm:prSet presAssocID="{EA7CE3B7-DE08-411B-B462-44DB760A778C}" presName="LevelTwoTextNode" presStyleLbl="asst1" presStyleIdx="9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3A7C383-13FD-45DD-8991-5911F2B4C3F6}" type="pres">
      <dgm:prSet presAssocID="{EA7CE3B7-DE08-411B-B462-44DB760A778C}" presName="level3hierChild" presStyleCnt="0"/>
      <dgm:spPr/>
    </dgm:pt>
    <dgm:pt modelId="{0690BAF6-2E3E-48F7-B419-76D80DEF1285}" type="pres">
      <dgm:prSet presAssocID="{965BA46E-FDDC-4058-922A-312962713AE0}" presName="conn2-1" presStyleLbl="parChTrans1D4" presStyleIdx="6" presStyleCnt="19"/>
      <dgm:spPr/>
      <dgm:t>
        <a:bodyPr/>
        <a:lstStyle/>
        <a:p>
          <a:endParaRPr lang="en-US"/>
        </a:p>
      </dgm:t>
    </dgm:pt>
    <dgm:pt modelId="{644B0916-88CC-4E2D-8F8B-61CB7AB19F11}" type="pres">
      <dgm:prSet presAssocID="{965BA46E-FDDC-4058-922A-312962713AE0}" presName="connTx" presStyleLbl="parChTrans1D4" presStyleIdx="6" presStyleCnt="19"/>
      <dgm:spPr/>
      <dgm:t>
        <a:bodyPr/>
        <a:lstStyle/>
        <a:p>
          <a:endParaRPr lang="en-US"/>
        </a:p>
      </dgm:t>
    </dgm:pt>
    <dgm:pt modelId="{68694253-D1E0-407A-B177-0918469B193A}" type="pres">
      <dgm:prSet presAssocID="{C20BB801-8511-462F-849B-48B8148621D5}" presName="root2" presStyleCnt="0"/>
      <dgm:spPr/>
    </dgm:pt>
    <dgm:pt modelId="{4BB45888-D1DE-4D55-A070-864FDC435C39}" type="pres">
      <dgm:prSet presAssocID="{C20BB801-8511-462F-849B-48B8148621D5}" presName="LevelTwoTextNode" presStyleLbl="asst1" presStyleIdx="10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3689A1F5-2C46-45BB-83EF-65EF9225403F}" type="pres">
      <dgm:prSet presAssocID="{C20BB801-8511-462F-849B-48B8148621D5}" presName="level3hierChild" presStyleCnt="0"/>
      <dgm:spPr/>
    </dgm:pt>
    <dgm:pt modelId="{50582FA0-BBE9-41F5-B774-DF272A2E7640}" type="pres">
      <dgm:prSet presAssocID="{7F9A3AFF-8CE4-4C74-A22E-97A3AB34FDCF}" presName="conn2-1" presStyleLbl="parChTrans1D3" presStyleIdx="3" presStyleCnt="10"/>
      <dgm:spPr/>
      <dgm:t>
        <a:bodyPr/>
        <a:lstStyle/>
        <a:p>
          <a:endParaRPr lang="en-US"/>
        </a:p>
      </dgm:t>
    </dgm:pt>
    <dgm:pt modelId="{9A9420DC-F1B7-4C0C-8BF0-C2E0C4CBC93F}" type="pres">
      <dgm:prSet presAssocID="{7F9A3AFF-8CE4-4C74-A22E-97A3AB34FDCF}" presName="connTx" presStyleLbl="parChTrans1D3" presStyleIdx="3" presStyleCnt="10"/>
      <dgm:spPr/>
      <dgm:t>
        <a:bodyPr/>
        <a:lstStyle/>
        <a:p>
          <a:endParaRPr lang="en-US"/>
        </a:p>
      </dgm:t>
    </dgm:pt>
    <dgm:pt modelId="{AABEFBD3-3754-4F01-A1BF-46CB69D73338}" type="pres">
      <dgm:prSet presAssocID="{2AA0A808-362A-4E43-9B46-3F766B5220BB}" presName="root2" presStyleCnt="0"/>
      <dgm:spPr/>
    </dgm:pt>
    <dgm:pt modelId="{5388DEAC-EED5-488A-BF01-C492E1548169}" type="pres">
      <dgm:prSet presAssocID="{2AA0A808-362A-4E43-9B46-3F766B5220BB}" presName="LevelTwoTextNode" presStyleLbl="asst1" presStyleIdx="11" presStyleCnt="27" custScaleX="29265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A78D691-3734-4953-AAF8-5F3F17A404FF}" type="pres">
      <dgm:prSet presAssocID="{2AA0A808-362A-4E43-9B46-3F766B5220BB}" presName="level3hierChild" presStyleCnt="0"/>
      <dgm:spPr/>
    </dgm:pt>
    <dgm:pt modelId="{85680CD6-D861-4B8C-B4BB-D395BF852CF2}" type="pres">
      <dgm:prSet presAssocID="{B3E97CCC-D8F2-4A81-991C-51C9BF2A6F43}" presName="conn2-1" presStyleLbl="parChTrans1D4" presStyleIdx="7" presStyleCnt="19"/>
      <dgm:spPr/>
      <dgm:t>
        <a:bodyPr/>
        <a:lstStyle/>
        <a:p>
          <a:endParaRPr lang="en-US"/>
        </a:p>
      </dgm:t>
    </dgm:pt>
    <dgm:pt modelId="{BC6A27C1-C76C-49EA-979A-2A521D1FCCEF}" type="pres">
      <dgm:prSet presAssocID="{B3E97CCC-D8F2-4A81-991C-51C9BF2A6F43}" presName="connTx" presStyleLbl="parChTrans1D4" presStyleIdx="7" presStyleCnt="19"/>
      <dgm:spPr/>
      <dgm:t>
        <a:bodyPr/>
        <a:lstStyle/>
        <a:p>
          <a:endParaRPr lang="en-US"/>
        </a:p>
      </dgm:t>
    </dgm:pt>
    <dgm:pt modelId="{CC37B35B-BD55-4306-8506-765DE81C5E17}" type="pres">
      <dgm:prSet presAssocID="{89904C7D-191B-44E6-8B73-8B4A4666B243}" presName="root2" presStyleCnt="0"/>
      <dgm:spPr/>
    </dgm:pt>
    <dgm:pt modelId="{C1DDE8C2-4167-4CB5-9227-79BD5883663D}" type="pres">
      <dgm:prSet presAssocID="{89904C7D-191B-44E6-8B73-8B4A4666B243}" presName="LevelTwoTextNode" presStyleLbl="asst1" presStyleIdx="12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162417E9-3DE1-4B42-91DD-63E08D47F6E5}" type="pres">
      <dgm:prSet presAssocID="{89904C7D-191B-44E6-8B73-8B4A4666B243}" presName="level3hierChild" presStyleCnt="0"/>
      <dgm:spPr/>
    </dgm:pt>
    <dgm:pt modelId="{D8521D54-7213-4694-BBC0-4F888AA592CD}" type="pres">
      <dgm:prSet presAssocID="{15419740-8019-43E9-B6B0-C06F14B37B04}" presName="conn2-1" presStyleLbl="parChTrans1D4" presStyleIdx="8" presStyleCnt="19"/>
      <dgm:spPr/>
      <dgm:t>
        <a:bodyPr/>
        <a:lstStyle/>
        <a:p>
          <a:endParaRPr lang="en-US"/>
        </a:p>
      </dgm:t>
    </dgm:pt>
    <dgm:pt modelId="{12E003C6-4AFF-4D58-B542-ECD9CE0A59CB}" type="pres">
      <dgm:prSet presAssocID="{15419740-8019-43E9-B6B0-C06F14B37B04}" presName="connTx" presStyleLbl="parChTrans1D4" presStyleIdx="8" presStyleCnt="19"/>
      <dgm:spPr/>
      <dgm:t>
        <a:bodyPr/>
        <a:lstStyle/>
        <a:p>
          <a:endParaRPr lang="en-US"/>
        </a:p>
      </dgm:t>
    </dgm:pt>
    <dgm:pt modelId="{DC900C20-41B6-4088-B8D1-CC6AD8650876}" type="pres">
      <dgm:prSet presAssocID="{E74928B5-AAE7-4EE8-81D7-514794113F1A}" presName="root2" presStyleCnt="0"/>
      <dgm:spPr/>
    </dgm:pt>
    <dgm:pt modelId="{9A8BBF3E-80F7-4CDC-8949-9486CC82C37E}" type="pres">
      <dgm:prSet presAssocID="{E74928B5-AAE7-4EE8-81D7-514794113F1A}" presName="LevelTwoTextNode" presStyleLbl="asst1" presStyleIdx="13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64B40F7-0EE1-4AB5-9EFB-EBF4DBFF85F9}" type="pres">
      <dgm:prSet presAssocID="{E74928B5-AAE7-4EE8-81D7-514794113F1A}" presName="level3hierChild" presStyleCnt="0"/>
      <dgm:spPr/>
    </dgm:pt>
    <dgm:pt modelId="{F33BF1B9-AED9-42A3-BD05-2C4D658A0E82}" type="pres">
      <dgm:prSet presAssocID="{043607C2-812B-4762-B64A-5CD082B12B08}" presName="conn2-1" presStyleLbl="parChTrans1D4" presStyleIdx="9" presStyleCnt="19"/>
      <dgm:spPr/>
      <dgm:t>
        <a:bodyPr/>
        <a:lstStyle/>
        <a:p>
          <a:endParaRPr lang="en-US"/>
        </a:p>
      </dgm:t>
    </dgm:pt>
    <dgm:pt modelId="{4CFC7A54-D56C-4532-BDF0-561B996C1A7B}" type="pres">
      <dgm:prSet presAssocID="{043607C2-812B-4762-B64A-5CD082B12B08}" presName="connTx" presStyleLbl="parChTrans1D4" presStyleIdx="9" presStyleCnt="19"/>
      <dgm:spPr/>
      <dgm:t>
        <a:bodyPr/>
        <a:lstStyle/>
        <a:p>
          <a:endParaRPr lang="en-US"/>
        </a:p>
      </dgm:t>
    </dgm:pt>
    <dgm:pt modelId="{76AFCB5B-F3DE-41B1-AD17-6323C40DFC6B}" type="pres">
      <dgm:prSet presAssocID="{F9BB6BB1-7D55-459B-AF73-859533C8E860}" presName="root2" presStyleCnt="0"/>
      <dgm:spPr/>
    </dgm:pt>
    <dgm:pt modelId="{597BC5DD-74CC-47C5-AD40-3A868FED9E4F}" type="pres">
      <dgm:prSet presAssocID="{F9BB6BB1-7D55-459B-AF73-859533C8E860}" presName="LevelTwoTextNode" presStyleLbl="asst1" presStyleIdx="14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5790AFD-0455-43D4-8705-9562D4BB16FA}" type="pres">
      <dgm:prSet presAssocID="{F9BB6BB1-7D55-459B-AF73-859533C8E860}" presName="level3hierChild" presStyleCnt="0"/>
      <dgm:spPr/>
    </dgm:pt>
    <dgm:pt modelId="{EC21EC01-6866-4C21-816F-7D5367748A93}" type="pres">
      <dgm:prSet presAssocID="{8E358C9A-6C64-4EE5-9066-85B40192709A}" presName="conn2-1" presStyleLbl="parChTrans1D4" presStyleIdx="10" presStyleCnt="19"/>
      <dgm:spPr/>
      <dgm:t>
        <a:bodyPr/>
        <a:lstStyle/>
        <a:p>
          <a:endParaRPr lang="en-US"/>
        </a:p>
      </dgm:t>
    </dgm:pt>
    <dgm:pt modelId="{E6261245-03D0-4B1C-AF98-52998D9808BB}" type="pres">
      <dgm:prSet presAssocID="{8E358C9A-6C64-4EE5-9066-85B40192709A}" presName="connTx" presStyleLbl="parChTrans1D4" presStyleIdx="10" presStyleCnt="19"/>
      <dgm:spPr/>
      <dgm:t>
        <a:bodyPr/>
        <a:lstStyle/>
        <a:p>
          <a:endParaRPr lang="en-US"/>
        </a:p>
      </dgm:t>
    </dgm:pt>
    <dgm:pt modelId="{C92D9193-E447-41C0-953C-7061B22064FF}" type="pres">
      <dgm:prSet presAssocID="{662C0AE4-FF05-4D26-A34F-AF2104520F5D}" presName="root2" presStyleCnt="0"/>
      <dgm:spPr/>
    </dgm:pt>
    <dgm:pt modelId="{D95317B9-76BE-4111-8A76-04456BE5B4E4}" type="pres">
      <dgm:prSet presAssocID="{662C0AE4-FF05-4D26-A34F-AF2104520F5D}" presName="LevelTwoTextNode" presStyleLbl="asst1" presStyleIdx="15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23D969F-C806-4309-8ACC-CA58FDDC5F77}" type="pres">
      <dgm:prSet presAssocID="{662C0AE4-FF05-4D26-A34F-AF2104520F5D}" presName="level3hierChild" presStyleCnt="0"/>
      <dgm:spPr/>
    </dgm:pt>
    <dgm:pt modelId="{E68CF398-FB37-46D5-AE40-35211BBBB345}" type="pres">
      <dgm:prSet presAssocID="{9DC8773C-3093-411F-BF47-518C239FBFCA}" presName="conn2-1" presStyleLbl="parChTrans1D4" presStyleIdx="11" presStyleCnt="19"/>
      <dgm:spPr/>
      <dgm:t>
        <a:bodyPr/>
        <a:lstStyle/>
        <a:p>
          <a:endParaRPr lang="en-US"/>
        </a:p>
      </dgm:t>
    </dgm:pt>
    <dgm:pt modelId="{9DB92DDD-27F6-4497-9884-A177005DC173}" type="pres">
      <dgm:prSet presAssocID="{9DC8773C-3093-411F-BF47-518C239FBFCA}" presName="connTx" presStyleLbl="parChTrans1D4" presStyleIdx="11" presStyleCnt="19"/>
      <dgm:spPr/>
      <dgm:t>
        <a:bodyPr/>
        <a:lstStyle/>
        <a:p>
          <a:endParaRPr lang="en-US"/>
        </a:p>
      </dgm:t>
    </dgm:pt>
    <dgm:pt modelId="{C250F5E4-B080-4565-B1E2-BEF4540A6EC8}" type="pres">
      <dgm:prSet presAssocID="{C21058F5-47B6-4297-8195-25FAC184670C}" presName="root2" presStyleCnt="0"/>
      <dgm:spPr/>
    </dgm:pt>
    <dgm:pt modelId="{D2BED35C-0932-451D-A00D-15E358B75803}" type="pres">
      <dgm:prSet presAssocID="{C21058F5-47B6-4297-8195-25FAC184670C}" presName="LevelTwoTextNode" presStyleLbl="asst1" presStyleIdx="16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1CE47C3-124A-44CE-AE01-A2EB8BF68428}" type="pres">
      <dgm:prSet presAssocID="{C21058F5-47B6-4297-8195-25FAC184670C}" presName="level3hierChild" presStyleCnt="0"/>
      <dgm:spPr/>
    </dgm:pt>
    <dgm:pt modelId="{EDB39F50-E6A5-4BE9-B9EE-7CBD1C48E142}" type="pres">
      <dgm:prSet presAssocID="{682C0709-9E9D-41F8-B06D-3E7341C52348}" presName="conn2-1" presStyleLbl="parChTrans1D3" presStyleIdx="4" presStyleCnt="10"/>
      <dgm:spPr/>
      <dgm:t>
        <a:bodyPr/>
        <a:lstStyle/>
        <a:p>
          <a:endParaRPr lang="en-US"/>
        </a:p>
      </dgm:t>
    </dgm:pt>
    <dgm:pt modelId="{65F74B9C-4346-41F3-B001-FCEFA52E5536}" type="pres">
      <dgm:prSet presAssocID="{682C0709-9E9D-41F8-B06D-3E7341C52348}" presName="connTx" presStyleLbl="parChTrans1D3" presStyleIdx="4" presStyleCnt="10"/>
      <dgm:spPr/>
      <dgm:t>
        <a:bodyPr/>
        <a:lstStyle/>
        <a:p>
          <a:endParaRPr lang="en-US"/>
        </a:p>
      </dgm:t>
    </dgm:pt>
    <dgm:pt modelId="{A60DB8F9-6EF7-497F-B504-A3903AE671B1}" type="pres">
      <dgm:prSet presAssocID="{163272B5-FA91-4958-99F0-01272988D46C}" presName="root2" presStyleCnt="0"/>
      <dgm:spPr/>
    </dgm:pt>
    <dgm:pt modelId="{21F2160D-B234-45C3-831F-32DA92F9E092}" type="pres">
      <dgm:prSet presAssocID="{163272B5-FA91-4958-99F0-01272988D46C}" presName="LevelTwoTextNode" presStyleLbl="asst1" presStyleIdx="17" presStyleCnt="27" custScaleX="146654" custScaleY="31547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B2206FB-670A-4D16-8ACF-B793FDFD8F30}" type="pres">
      <dgm:prSet presAssocID="{163272B5-FA91-4958-99F0-01272988D46C}" presName="level3hierChild" presStyleCnt="0"/>
      <dgm:spPr/>
    </dgm:pt>
    <dgm:pt modelId="{E963BCA4-358F-4E84-A754-9B3BA2A663D7}" type="pres">
      <dgm:prSet presAssocID="{71EF7A92-5EF4-4681-B8F2-D60279767D5E}" presName="conn2-1" presStyleLbl="parChTrans1D4" presStyleIdx="12" presStyleCnt="19"/>
      <dgm:spPr/>
      <dgm:t>
        <a:bodyPr/>
        <a:lstStyle/>
        <a:p>
          <a:endParaRPr lang="en-US"/>
        </a:p>
      </dgm:t>
    </dgm:pt>
    <dgm:pt modelId="{B761E77C-728A-4EC0-A339-32A91B1D0DA7}" type="pres">
      <dgm:prSet presAssocID="{71EF7A92-5EF4-4681-B8F2-D60279767D5E}" presName="connTx" presStyleLbl="parChTrans1D4" presStyleIdx="12" presStyleCnt="19"/>
      <dgm:spPr/>
      <dgm:t>
        <a:bodyPr/>
        <a:lstStyle/>
        <a:p>
          <a:endParaRPr lang="en-US"/>
        </a:p>
      </dgm:t>
    </dgm:pt>
    <dgm:pt modelId="{83451D17-F717-4767-9525-2BC49CA719EE}" type="pres">
      <dgm:prSet presAssocID="{14A1D4EB-D46A-4EAA-9058-A0F03BEE701D}" presName="root2" presStyleCnt="0"/>
      <dgm:spPr/>
    </dgm:pt>
    <dgm:pt modelId="{AEC6F2D4-95D5-48AD-82E9-6283D5B7C839}" type="pres">
      <dgm:prSet presAssocID="{14A1D4EB-D46A-4EAA-9058-A0F03BEE701D}" presName="LevelTwoTextNode" presStyleLbl="asst1" presStyleIdx="18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F4D2FF32-6AD0-40FA-8337-382547582211}" type="pres">
      <dgm:prSet presAssocID="{14A1D4EB-D46A-4EAA-9058-A0F03BEE701D}" presName="level3hierChild" presStyleCnt="0"/>
      <dgm:spPr/>
    </dgm:pt>
    <dgm:pt modelId="{0B1934E3-BED7-41C6-8334-56CDE0C18457}" type="pres">
      <dgm:prSet presAssocID="{CC8DED40-504F-4A4D-B60D-0E822D5048E2}" presName="conn2-1" presStyleLbl="parChTrans1D4" presStyleIdx="13" presStyleCnt="19"/>
      <dgm:spPr/>
      <dgm:t>
        <a:bodyPr/>
        <a:lstStyle/>
        <a:p>
          <a:endParaRPr lang="en-US"/>
        </a:p>
      </dgm:t>
    </dgm:pt>
    <dgm:pt modelId="{BF296AFE-DE93-43D0-880D-C426CF8D691B}" type="pres">
      <dgm:prSet presAssocID="{CC8DED40-504F-4A4D-B60D-0E822D5048E2}" presName="connTx" presStyleLbl="parChTrans1D4" presStyleIdx="13" presStyleCnt="19"/>
      <dgm:spPr/>
      <dgm:t>
        <a:bodyPr/>
        <a:lstStyle/>
        <a:p>
          <a:endParaRPr lang="en-US"/>
        </a:p>
      </dgm:t>
    </dgm:pt>
    <dgm:pt modelId="{255222B5-2B81-40BD-886F-B2A617096CED}" type="pres">
      <dgm:prSet presAssocID="{071AAAAD-8791-457E-8470-D878A59BD241}" presName="root2" presStyleCnt="0"/>
      <dgm:spPr/>
    </dgm:pt>
    <dgm:pt modelId="{0ED870BF-DE06-43B1-B8FD-733691756967}" type="pres">
      <dgm:prSet presAssocID="{071AAAAD-8791-457E-8470-D878A59BD241}" presName="LevelTwoTextNode" presStyleLbl="asst1" presStyleIdx="19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7282136F-CB13-49A8-B751-63F79A8A2202}" type="pres">
      <dgm:prSet presAssocID="{071AAAAD-8791-457E-8470-D878A59BD241}" presName="level3hierChild" presStyleCnt="0"/>
      <dgm:spPr/>
    </dgm:pt>
    <dgm:pt modelId="{1CE5CB39-D3E9-4A7B-9C67-A233A6D7A627}" type="pres">
      <dgm:prSet presAssocID="{95228426-4069-4FD3-B1B6-2A6131818E5A}" presName="conn2-1" presStyleLbl="parChTrans1D3" presStyleIdx="5" presStyleCnt="10"/>
      <dgm:spPr/>
      <dgm:t>
        <a:bodyPr/>
        <a:lstStyle/>
        <a:p>
          <a:endParaRPr lang="en-US"/>
        </a:p>
      </dgm:t>
    </dgm:pt>
    <dgm:pt modelId="{F5E475E5-8A42-4579-B194-FAF922E7809E}" type="pres">
      <dgm:prSet presAssocID="{95228426-4069-4FD3-B1B6-2A6131818E5A}" presName="connTx" presStyleLbl="parChTrans1D3" presStyleIdx="5" presStyleCnt="10"/>
      <dgm:spPr/>
      <dgm:t>
        <a:bodyPr/>
        <a:lstStyle/>
        <a:p>
          <a:endParaRPr lang="en-US"/>
        </a:p>
      </dgm:t>
    </dgm:pt>
    <dgm:pt modelId="{763EAE49-7C61-4605-A145-5FBC1B89EEA3}" type="pres">
      <dgm:prSet presAssocID="{4F824936-EEAE-477A-94E1-085DAC5C9D3C}" presName="root2" presStyleCnt="0"/>
      <dgm:spPr/>
    </dgm:pt>
    <dgm:pt modelId="{B3C580F2-FB1F-46D6-A574-03FF7B6D6BE1}" type="pres">
      <dgm:prSet presAssocID="{4F824936-EEAE-477A-94E1-085DAC5C9D3C}" presName="LevelTwoTextNode" presStyleLbl="asst1" presStyleIdx="20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C1BEBA0A-CC87-4654-8400-27B248D42296}" type="pres">
      <dgm:prSet presAssocID="{4F824936-EEAE-477A-94E1-085DAC5C9D3C}" presName="level3hierChild" presStyleCnt="0"/>
      <dgm:spPr/>
    </dgm:pt>
    <dgm:pt modelId="{960E4D89-EE87-4C6C-A706-B7013A8D6463}" type="pres">
      <dgm:prSet presAssocID="{1F2D1459-DF4F-4534-BD50-8CA02C19177D}" presName="conn2-1" presStyleLbl="parChTrans1D4" presStyleIdx="14" presStyleCnt="19"/>
      <dgm:spPr/>
      <dgm:t>
        <a:bodyPr/>
        <a:lstStyle/>
        <a:p>
          <a:endParaRPr lang="en-US"/>
        </a:p>
      </dgm:t>
    </dgm:pt>
    <dgm:pt modelId="{F6EBD4E4-F1B7-411F-B620-3CCDA123E074}" type="pres">
      <dgm:prSet presAssocID="{1F2D1459-DF4F-4534-BD50-8CA02C19177D}" presName="connTx" presStyleLbl="parChTrans1D4" presStyleIdx="14" presStyleCnt="19"/>
      <dgm:spPr/>
      <dgm:t>
        <a:bodyPr/>
        <a:lstStyle/>
        <a:p>
          <a:endParaRPr lang="en-US"/>
        </a:p>
      </dgm:t>
    </dgm:pt>
    <dgm:pt modelId="{CD587DE8-D871-4BCB-9F6C-0DE8AFDD2E56}" type="pres">
      <dgm:prSet presAssocID="{F43AACF9-221E-4BD7-8472-436B58689816}" presName="root2" presStyleCnt="0"/>
      <dgm:spPr/>
    </dgm:pt>
    <dgm:pt modelId="{85DBA0F4-5A3C-4403-96FB-0B04850D1882}" type="pres">
      <dgm:prSet presAssocID="{F43AACF9-221E-4BD7-8472-436B58689816}" presName="LevelTwoTextNode" presStyleLbl="asst1" presStyleIdx="21" presStyleCnt="27" custScaleY="93979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83EE9A9-C493-4CEC-BD2D-92DEE641C1D6}" type="pres">
      <dgm:prSet presAssocID="{F43AACF9-221E-4BD7-8472-436B58689816}" presName="level3hierChild" presStyleCnt="0"/>
      <dgm:spPr/>
    </dgm:pt>
    <dgm:pt modelId="{2FCF096E-BB8B-4040-A659-ADA3B7C0E269}" type="pres">
      <dgm:prSet presAssocID="{D6FEC866-8B8D-4B3F-9C64-E41CE3FA1A6B}" presName="conn2-1" presStyleLbl="parChTrans1D3" presStyleIdx="6" presStyleCnt="10"/>
      <dgm:spPr/>
      <dgm:t>
        <a:bodyPr/>
        <a:lstStyle/>
        <a:p>
          <a:endParaRPr lang="en-US"/>
        </a:p>
      </dgm:t>
    </dgm:pt>
    <dgm:pt modelId="{2258EE37-1D25-4656-A586-D82B3DE9DEE3}" type="pres">
      <dgm:prSet presAssocID="{D6FEC866-8B8D-4B3F-9C64-E41CE3FA1A6B}" presName="connTx" presStyleLbl="parChTrans1D3" presStyleIdx="6" presStyleCnt="10"/>
      <dgm:spPr/>
      <dgm:t>
        <a:bodyPr/>
        <a:lstStyle/>
        <a:p>
          <a:endParaRPr lang="en-US"/>
        </a:p>
      </dgm:t>
    </dgm:pt>
    <dgm:pt modelId="{F8568201-E9E4-4241-84FC-66092235000D}" type="pres">
      <dgm:prSet presAssocID="{D5D4FB50-B364-42DC-BEFD-E40B7198D856}" presName="root2" presStyleCnt="0"/>
      <dgm:spPr/>
    </dgm:pt>
    <dgm:pt modelId="{72636010-4576-474C-8CDC-44780E4BDC8F}" type="pres">
      <dgm:prSet presAssocID="{D5D4FB50-B364-42DC-BEFD-E40B7198D856}" presName="LevelTwoTextNode" presStyleLbl="asst1" presStyleIdx="22" presStyleCnt="27" custScaleX="136971" custScaleY="53846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EEF8E53-0025-4912-9C49-78ACDA0A8A00}" type="pres">
      <dgm:prSet presAssocID="{D5D4FB50-B364-42DC-BEFD-E40B7198D856}" presName="level3hierChild" presStyleCnt="0"/>
      <dgm:spPr/>
    </dgm:pt>
    <dgm:pt modelId="{E9416659-BBF5-4BD3-BE43-3B132573EE58}" type="pres">
      <dgm:prSet presAssocID="{11B4C912-86B2-426D-9B12-5566593C72E7}" presName="conn2-1" presStyleLbl="parChTrans1D4" presStyleIdx="15" presStyleCnt="19"/>
      <dgm:spPr/>
      <dgm:t>
        <a:bodyPr/>
        <a:lstStyle/>
        <a:p>
          <a:endParaRPr lang="en-US"/>
        </a:p>
      </dgm:t>
    </dgm:pt>
    <dgm:pt modelId="{6E490DE4-E453-43A4-ACC8-9745E76655F8}" type="pres">
      <dgm:prSet presAssocID="{11B4C912-86B2-426D-9B12-5566593C72E7}" presName="connTx" presStyleLbl="parChTrans1D4" presStyleIdx="15" presStyleCnt="19"/>
      <dgm:spPr/>
      <dgm:t>
        <a:bodyPr/>
        <a:lstStyle/>
        <a:p>
          <a:endParaRPr lang="en-US"/>
        </a:p>
      </dgm:t>
    </dgm:pt>
    <dgm:pt modelId="{E96CC648-9DC1-4423-A3C0-2C7D1D2A3F3B}" type="pres">
      <dgm:prSet presAssocID="{64FB4822-5D01-405E-A2FC-6C9581874534}" presName="root2" presStyleCnt="0"/>
      <dgm:spPr/>
    </dgm:pt>
    <dgm:pt modelId="{ED81DF27-18D8-4CB1-B441-682B76EBC6C3}" type="pres">
      <dgm:prSet presAssocID="{64FB4822-5D01-405E-A2FC-6C9581874534}" presName="LevelTwoTextNode" presStyleLbl="node4" presStyleIdx="0" presStyleCnt="2" custScaleY="6629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2C27B3A-1770-4990-9723-93C951B08088}" type="pres">
      <dgm:prSet presAssocID="{64FB4822-5D01-405E-A2FC-6C9581874534}" presName="level3hierChild" presStyleCnt="0"/>
      <dgm:spPr/>
    </dgm:pt>
    <dgm:pt modelId="{576E1488-9ED3-4594-83C4-9410252E7C78}" type="pres">
      <dgm:prSet presAssocID="{10EC9B84-4143-4860-B9E4-8C811825C3C2}" presName="conn2-1" presStyleLbl="parChTrans1D3" presStyleIdx="7" presStyleCnt="10"/>
      <dgm:spPr/>
      <dgm:t>
        <a:bodyPr/>
        <a:lstStyle/>
        <a:p>
          <a:endParaRPr lang="en-US"/>
        </a:p>
      </dgm:t>
    </dgm:pt>
    <dgm:pt modelId="{3638F33C-3AFC-4822-AD4D-20D5F3841C21}" type="pres">
      <dgm:prSet presAssocID="{10EC9B84-4143-4860-B9E4-8C811825C3C2}" presName="connTx" presStyleLbl="parChTrans1D3" presStyleIdx="7" presStyleCnt="10"/>
      <dgm:spPr/>
      <dgm:t>
        <a:bodyPr/>
        <a:lstStyle/>
        <a:p>
          <a:endParaRPr lang="en-US"/>
        </a:p>
      </dgm:t>
    </dgm:pt>
    <dgm:pt modelId="{B5EB13AC-85C5-45A6-8002-140E68E0250C}" type="pres">
      <dgm:prSet presAssocID="{04694563-0CDC-44CE-A9A0-707A504A5839}" presName="root2" presStyleCnt="0"/>
      <dgm:spPr/>
    </dgm:pt>
    <dgm:pt modelId="{41832CCF-0117-4FEC-B465-24629687F834}" type="pres">
      <dgm:prSet presAssocID="{04694563-0CDC-44CE-A9A0-707A504A5839}" presName="LevelTwoTextNode" presStyleLbl="asst1" presStyleIdx="23" presStyleCnt="27" custScaleX="193993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13F3CDB7-7F17-401D-B8F8-E2751E77BB8F}" type="pres">
      <dgm:prSet presAssocID="{04694563-0CDC-44CE-A9A0-707A504A5839}" presName="level3hierChild" presStyleCnt="0"/>
      <dgm:spPr/>
    </dgm:pt>
    <dgm:pt modelId="{F518CB70-8FC6-45C6-9986-0BCFA38267AE}" type="pres">
      <dgm:prSet presAssocID="{B6ADC0EF-4DE2-49AA-BC86-AD69D14FBB20}" presName="conn2-1" presStyleLbl="parChTrans1D4" presStyleIdx="16" presStyleCnt="19"/>
      <dgm:spPr/>
      <dgm:t>
        <a:bodyPr/>
        <a:lstStyle/>
        <a:p>
          <a:endParaRPr lang="en-US"/>
        </a:p>
      </dgm:t>
    </dgm:pt>
    <dgm:pt modelId="{1C9106B8-FEA9-4C06-B02A-4FC549A768D8}" type="pres">
      <dgm:prSet presAssocID="{B6ADC0EF-4DE2-49AA-BC86-AD69D14FBB20}" presName="connTx" presStyleLbl="parChTrans1D4" presStyleIdx="16" presStyleCnt="19"/>
      <dgm:spPr/>
      <dgm:t>
        <a:bodyPr/>
        <a:lstStyle/>
        <a:p>
          <a:endParaRPr lang="en-US"/>
        </a:p>
      </dgm:t>
    </dgm:pt>
    <dgm:pt modelId="{F839E571-6132-40A8-A084-BC9BABC7B794}" type="pres">
      <dgm:prSet presAssocID="{C21B325D-FB32-4F11-BA86-37F754BB16FF}" presName="root2" presStyleCnt="0"/>
      <dgm:spPr/>
    </dgm:pt>
    <dgm:pt modelId="{00C4BBE0-EBF3-4395-A6F4-1E6BC19228B5}" type="pres">
      <dgm:prSet presAssocID="{C21B325D-FB32-4F11-BA86-37F754BB16FF}" presName="LevelTwoTextNode" presStyleLbl="asst1" presStyleIdx="24" presStyleCnt="27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4EC0461-9E2D-40DA-9A11-EC98094CA867}" type="pres">
      <dgm:prSet presAssocID="{C21B325D-FB32-4F11-BA86-37F754BB16FF}" presName="level3hierChild" presStyleCnt="0"/>
      <dgm:spPr/>
    </dgm:pt>
    <dgm:pt modelId="{6BCA1F02-8423-418F-9214-DC6DF4276FFE}" type="pres">
      <dgm:prSet presAssocID="{6752D7DA-2AC0-42AF-BBAE-E5D7A2A38F52}" presName="conn2-1" presStyleLbl="parChTrans1D3" presStyleIdx="8" presStyleCnt="10"/>
      <dgm:spPr/>
      <dgm:t>
        <a:bodyPr/>
        <a:lstStyle/>
        <a:p>
          <a:endParaRPr lang="en-US"/>
        </a:p>
      </dgm:t>
    </dgm:pt>
    <dgm:pt modelId="{5D1B088A-A6CF-436C-847E-34048BAA346B}" type="pres">
      <dgm:prSet presAssocID="{6752D7DA-2AC0-42AF-BBAE-E5D7A2A38F52}" presName="connTx" presStyleLbl="parChTrans1D3" presStyleIdx="8" presStyleCnt="10"/>
      <dgm:spPr/>
      <dgm:t>
        <a:bodyPr/>
        <a:lstStyle/>
        <a:p>
          <a:endParaRPr lang="en-US"/>
        </a:p>
      </dgm:t>
    </dgm:pt>
    <dgm:pt modelId="{396B2AA2-6C08-4E7A-A836-7AEB28A67016}" type="pres">
      <dgm:prSet presAssocID="{C9E29CE9-D9ED-4EB6-875D-B2713E1107BB}" presName="root2" presStyleCnt="0"/>
      <dgm:spPr/>
    </dgm:pt>
    <dgm:pt modelId="{61CF67B4-D647-467C-824B-AF05E62F23FB}" type="pres">
      <dgm:prSet presAssocID="{C9E29CE9-D9ED-4EB6-875D-B2713E1107BB}" presName="LevelTwoTextNode" presStyleLbl="asst1" presStyleIdx="25" presStyleCnt="27" custScaleX="238028" custScaleY="171597" custLinFactY="67867" custLinFactNeighborX="4356" custLinFactNeighborY="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75CC12B-0811-443A-915D-ACFDF90823DB}" type="pres">
      <dgm:prSet presAssocID="{C9E29CE9-D9ED-4EB6-875D-B2713E1107BB}" presName="level3hierChild" presStyleCnt="0"/>
      <dgm:spPr/>
    </dgm:pt>
    <dgm:pt modelId="{78B80AB1-7240-47D1-922D-C9649794E709}" type="pres">
      <dgm:prSet presAssocID="{EFFFF2CC-B614-45BF-9375-15ED5B8AAFA3}" presName="conn2-1" presStyleLbl="parChTrans1D4" presStyleIdx="17" presStyleCnt="19"/>
      <dgm:spPr/>
      <dgm:t>
        <a:bodyPr/>
        <a:lstStyle/>
        <a:p>
          <a:endParaRPr lang="en-US"/>
        </a:p>
      </dgm:t>
    </dgm:pt>
    <dgm:pt modelId="{002E5ACD-8ABF-455A-8C9E-D93151678682}" type="pres">
      <dgm:prSet presAssocID="{EFFFF2CC-B614-45BF-9375-15ED5B8AAFA3}" presName="connTx" presStyleLbl="parChTrans1D4" presStyleIdx="17" presStyleCnt="19"/>
      <dgm:spPr/>
      <dgm:t>
        <a:bodyPr/>
        <a:lstStyle/>
        <a:p>
          <a:endParaRPr lang="en-US"/>
        </a:p>
      </dgm:t>
    </dgm:pt>
    <dgm:pt modelId="{076FDF0A-567C-43B7-8744-615E84133173}" type="pres">
      <dgm:prSet presAssocID="{EB106A67-DB70-4226-8605-1052C09DA4E6}" presName="root2" presStyleCnt="0"/>
      <dgm:spPr/>
    </dgm:pt>
    <dgm:pt modelId="{7ECB0AE2-150A-4134-A298-5547C3F26CC0}" type="pres">
      <dgm:prSet presAssocID="{EB106A67-DB70-4226-8605-1052C09DA4E6}" presName="LevelTwoTextNode" presStyleLbl="asst1" presStyleIdx="26" presStyleCnt="27" custLinFactY="67867" custLinFactNeighborX="8711" custLinFactNeighborY="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737CAAA-B37D-4951-A10B-3E1CE4C783CF}" type="pres">
      <dgm:prSet presAssocID="{EB106A67-DB70-4226-8605-1052C09DA4E6}" presName="level3hierChild" presStyleCnt="0"/>
      <dgm:spPr/>
    </dgm:pt>
    <dgm:pt modelId="{33744C96-8DA5-4082-B453-52DC4E69799B}" type="pres">
      <dgm:prSet presAssocID="{F2AFAC63-15C8-4981-9A67-F1DE8DC0153F}" presName="conn2-1" presStyleLbl="parChTrans1D3" presStyleIdx="9" presStyleCnt="10"/>
      <dgm:spPr/>
      <dgm:t>
        <a:bodyPr/>
        <a:lstStyle/>
        <a:p>
          <a:endParaRPr lang="en-US"/>
        </a:p>
      </dgm:t>
    </dgm:pt>
    <dgm:pt modelId="{395AD0D9-A03B-44EE-82E5-6516F1FB7018}" type="pres">
      <dgm:prSet presAssocID="{F2AFAC63-15C8-4981-9A67-F1DE8DC0153F}" presName="connTx" presStyleLbl="parChTrans1D3" presStyleIdx="9" presStyleCnt="10"/>
      <dgm:spPr/>
      <dgm:t>
        <a:bodyPr/>
        <a:lstStyle/>
        <a:p>
          <a:endParaRPr lang="en-US"/>
        </a:p>
      </dgm:t>
    </dgm:pt>
    <dgm:pt modelId="{92D70978-EB02-49BF-89EE-74845B611F58}" type="pres">
      <dgm:prSet presAssocID="{BE2240EA-4EA6-4066-ABD8-A340FBEBDE12}" presName="root2" presStyleCnt="0"/>
      <dgm:spPr/>
    </dgm:pt>
    <dgm:pt modelId="{C02522A6-04F2-4AE6-8CAF-62FE2C1A4E36}" type="pres">
      <dgm:prSet presAssocID="{BE2240EA-4EA6-4066-ABD8-A340FBEBDE12}" presName="LevelTwoTextNode" presStyleLbl="node3" presStyleIdx="0" presStyleCnt="1" custScaleX="170684" custScaleY="115266" custLinFactY="-75010" custLinFactNeighborX="5445" custLinFactNeighborY="-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3AF969D-AD8B-419B-9197-222F9B5EE5CD}" type="pres">
      <dgm:prSet presAssocID="{BE2240EA-4EA6-4066-ABD8-A340FBEBDE12}" presName="level3hierChild" presStyleCnt="0"/>
      <dgm:spPr/>
    </dgm:pt>
    <dgm:pt modelId="{AAB712C3-60DD-4845-987A-871BB6E7CBC6}" type="pres">
      <dgm:prSet presAssocID="{744304DD-CC18-4659-B854-EE14F8BA0780}" presName="conn2-1" presStyleLbl="parChTrans1D4" presStyleIdx="18" presStyleCnt="19"/>
      <dgm:spPr/>
      <dgm:t>
        <a:bodyPr/>
        <a:lstStyle/>
        <a:p>
          <a:endParaRPr lang="en-US"/>
        </a:p>
      </dgm:t>
    </dgm:pt>
    <dgm:pt modelId="{52AB65B6-28A3-4533-A9EF-7617A8BF08E3}" type="pres">
      <dgm:prSet presAssocID="{744304DD-CC18-4659-B854-EE14F8BA0780}" presName="connTx" presStyleLbl="parChTrans1D4" presStyleIdx="18" presStyleCnt="19"/>
      <dgm:spPr/>
      <dgm:t>
        <a:bodyPr/>
        <a:lstStyle/>
        <a:p>
          <a:endParaRPr lang="en-US"/>
        </a:p>
      </dgm:t>
    </dgm:pt>
    <dgm:pt modelId="{1ED3D240-D738-488A-8D27-E1C77EC10FE8}" type="pres">
      <dgm:prSet presAssocID="{0657636B-EFF1-416F-9BD5-2691D2A75023}" presName="root2" presStyleCnt="0"/>
      <dgm:spPr/>
    </dgm:pt>
    <dgm:pt modelId="{4F5011DB-67AE-4DCB-A763-22674F8C3D79}" type="pres">
      <dgm:prSet presAssocID="{0657636B-EFF1-416F-9BD5-2691D2A75023}" presName="LevelTwoTextNode" presStyleLbl="node4" presStyleIdx="1" presStyleCnt="2" custLinFactY="-74478" custLinFactNeighborX="4342" custLinFactNeighborY="-1000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C45CDFC-9AD9-4E56-8356-EAE71E0568C7}" type="pres">
      <dgm:prSet presAssocID="{0657636B-EFF1-416F-9BD5-2691D2A75023}" presName="level3hierChild" presStyleCnt="0"/>
      <dgm:spPr/>
    </dgm:pt>
    <dgm:pt modelId="{C6F9E6C5-B465-4544-8E33-CD9BD0A1F830}" type="pres">
      <dgm:prSet presAssocID="{3DD62CB5-CFDD-4840-B8F5-CF1D6DC06C6E}" presName="conn2-1" presStyleLbl="parChTrans1D2" presStyleIdx="1" presStyleCnt="3"/>
      <dgm:spPr/>
      <dgm:t>
        <a:bodyPr/>
        <a:lstStyle/>
        <a:p>
          <a:endParaRPr lang="en-US"/>
        </a:p>
      </dgm:t>
    </dgm:pt>
    <dgm:pt modelId="{81ECD647-6338-4A37-8423-A264D2E2EB4E}" type="pres">
      <dgm:prSet presAssocID="{3DD62CB5-CFDD-4840-B8F5-CF1D6DC06C6E}" presName="connTx" presStyleLbl="parChTrans1D2" presStyleIdx="1" presStyleCnt="3"/>
      <dgm:spPr/>
      <dgm:t>
        <a:bodyPr/>
        <a:lstStyle/>
        <a:p>
          <a:endParaRPr lang="en-US"/>
        </a:p>
      </dgm:t>
    </dgm:pt>
    <dgm:pt modelId="{88F5CEF5-0C27-464B-B6BD-9E09561C064D}" type="pres">
      <dgm:prSet presAssocID="{3B38241B-4131-4EA3-9B03-5AA80B152DAA}" presName="root2" presStyleCnt="0"/>
      <dgm:spPr/>
    </dgm:pt>
    <dgm:pt modelId="{17ABBCEC-A837-48DB-99C5-BD19A8A746C1}" type="pres">
      <dgm:prSet presAssocID="{3B38241B-4131-4EA3-9B03-5AA80B152DAA}" presName="LevelTwoTextNode" presStyleLbl="node2" presStyleIdx="0" presStyleCnt="2" custScaleX="233053" custScaleY="534332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B847E7E4-4A05-4B83-8B59-BEBC0C50AB29}" type="pres">
      <dgm:prSet presAssocID="{3B38241B-4131-4EA3-9B03-5AA80B152DAA}" presName="level3hierChild" presStyleCnt="0"/>
      <dgm:spPr/>
    </dgm:pt>
    <dgm:pt modelId="{830B9FBE-FD6D-4E41-8F80-CDFE00D42519}" type="pres">
      <dgm:prSet presAssocID="{EC7BC250-206D-4415-BEA1-374E010C5787}" presName="conn2-1" presStyleLbl="parChTrans1D2" presStyleIdx="2" presStyleCnt="3"/>
      <dgm:spPr/>
      <dgm:t>
        <a:bodyPr/>
        <a:lstStyle/>
        <a:p>
          <a:endParaRPr lang="en-US"/>
        </a:p>
      </dgm:t>
    </dgm:pt>
    <dgm:pt modelId="{CFF7D72D-25B0-47E4-B9D9-793E1490B4AC}" type="pres">
      <dgm:prSet presAssocID="{EC7BC250-206D-4415-BEA1-374E010C5787}" presName="connTx" presStyleLbl="parChTrans1D2" presStyleIdx="2" presStyleCnt="3"/>
      <dgm:spPr/>
      <dgm:t>
        <a:bodyPr/>
        <a:lstStyle/>
        <a:p>
          <a:endParaRPr lang="en-US"/>
        </a:p>
      </dgm:t>
    </dgm:pt>
    <dgm:pt modelId="{8DC67C18-53C7-422A-B9E1-68B09239E91A}" type="pres">
      <dgm:prSet presAssocID="{0E36E291-16E4-4737-92AE-1583297C9CA4}" presName="root2" presStyleCnt="0"/>
      <dgm:spPr/>
    </dgm:pt>
    <dgm:pt modelId="{B526AE86-C759-48C4-8513-9B514B692BF9}" type="pres">
      <dgm:prSet presAssocID="{0E36E291-16E4-4737-92AE-1583297C9CA4}" presName="LevelTwoTextNode" presStyleLbl="node2" presStyleIdx="1" presStyleCnt="2" custScaleX="231648" custScaleY="56774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1D96A57B-F3F1-4163-88AD-354FCB61DAA9}" type="pres">
      <dgm:prSet presAssocID="{0E36E291-16E4-4737-92AE-1583297C9CA4}" presName="level3hierChild" presStyleCnt="0"/>
      <dgm:spPr/>
    </dgm:pt>
  </dgm:ptLst>
  <dgm:cxnLst>
    <dgm:cxn modelId="{3466A3BD-51B4-2641-8691-AD32FF971D87}" type="presOf" srcId="{4F824936-EEAE-477A-94E1-085DAC5C9D3C}" destId="{B3C580F2-FB1F-46D6-A574-03FF7B6D6BE1}" srcOrd="0" destOrd="0" presId="urn:microsoft.com/office/officeart/2008/layout/HorizontalMultiLevelHierarchy"/>
    <dgm:cxn modelId="{D072EDFB-A778-0A4B-A656-F6752CFFDA6A}" type="presOf" srcId="{71EF7A92-5EF4-4681-B8F2-D60279767D5E}" destId="{B761E77C-728A-4EC0-A339-32A91B1D0DA7}" srcOrd="1" destOrd="0" presId="urn:microsoft.com/office/officeart/2008/layout/HorizontalMultiLevelHierarchy"/>
    <dgm:cxn modelId="{08167016-4DEC-4237-9226-969E31DF68CF}" srcId="{B8F951F1-0876-4D5D-8FDC-E1892E3FDD52}" destId="{12B7AA39-7294-49E2-9AD1-5D9B28ABBCD0}" srcOrd="0" destOrd="0" parTransId="{DFD75553-0E6E-46BA-A20F-4B82AE13638E}" sibTransId="{9B6342D8-EEC7-4B1F-844E-0BD3AA1D5EBF}"/>
    <dgm:cxn modelId="{8025CFD1-EF0D-4179-B8DA-621D731161B4}" srcId="{2AA0A808-362A-4E43-9B46-3F766B5220BB}" destId="{E74928B5-AAE7-4EE8-81D7-514794113F1A}" srcOrd="1" destOrd="0" parTransId="{15419740-8019-43E9-B6B0-C06F14B37B04}" sibTransId="{7A2C0B21-747F-41C6-AF9E-7C0BBECB8F79}"/>
    <dgm:cxn modelId="{A3DBE352-106E-E844-AE16-29E6A4FDD110}" type="presOf" srcId="{AAFEDFF3-7262-457D-868C-3B7CC5E9E6FD}" destId="{034CFA1F-7B89-45F2-B399-AD34489603B2}" srcOrd="0" destOrd="0" presId="urn:microsoft.com/office/officeart/2008/layout/HorizontalMultiLevelHierarchy"/>
    <dgm:cxn modelId="{2883279A-359C-F240-9CEA-2FDDC25ABBDE}" type="presOf" srcId="{043607C2-812B-4762-B64A-5CD082B12B08}" destId="{F33BF1B9-AED9-42A3-BD05-2C4D658A0E82}" srcOrd="0" destOrd="0" presId="urn:microsoft.com/office/officeart/2008/layout/HorizontalMultiLevelHierarchy"/>
    <dgm:cxn modelId="{A87CE654-B892-F947-ADC8-8A53B62CD98A}" type="presOf" srcId="{744304DD-CC18-4659-B854-EE14F8BA0780}" destId="{52AB65B6-28A3-4533-A9EF-7617A8BF08E3}" srcOrd="1" destOrd="0" presId="urn:microsoft.com/office/officeart/2008/layout/HorizontalMultiLevelHierarchy"/>
    <dgm:cxn modelId="{1424CC43-995B-6141-992F-0F0A45F527F9}" type="presOf" srcId="{B6ADC0EF-4DE2-49AA-BC86-AD69D14FBB20}" destId="{1C9106B8-FEA9-4C06-B02A-4FC549A768D8}" srcOrd="1" destOrd="0" presId="urn:microsoft.com/office/officeart/2008/layout/HorizontalMultiLevelHierarchy"/>
    <dgm:cxn modelId="{440E977B-7358-4101-80BF-25EAEB109892}" srcId="{DB863807-68D1-48D1-835B-44DE16AEECF3}" destId="{9F0DA4E6-6AB7-41FE-8070-50C4E5B8715E}" srcOrd="0" destOrd="0" parTransId="{7A2808FA-D9CF-4A80-967D-2DB8C6585047}" sibTransId="{BA4AFD99-B3C2-4E4F-83C1-4A5E752EDE8F}"/>
    <dgm:cxn modelId="{E8E58ADF-5A3E-458E-BA04-20F74872BA9E}" srcId="{DB863807-68D1-48D1-835B-44DE16AEECF3}" destId="{0E36E291-16E4-4737-92AE-1583297C9CA4}" srcOrd="2" destOrd="0" parTransId="{EC7BC250-206D-4415-BEA1-374E010C5787}" sibTransId="{930E4A1C-0B54-4B2D-B91F-CFE2184ADD3E}"/>
    <dgm:cxn modelId="{6EFE45F7-A603-6A40-8FEF-874C008EED6F}" type="presOf" srcId="{043607C2-812B-4762-B64A-5CD082B12B08}" destId="{4CFC7A54-D56C-4532-BDF0-561B996C1A7B}" srcOrd="1" destOrd="0" presId="urn:microsoft.com/office/officeart/2008/layout/HorizontalMultiLevelHierarchy"/>
    <dgm:cxn modelId="{B9CF7E9B-5B07-4388-B905-B8F0664760B2}" srcId="{2AA0A808-362A-4E43-9B46-3F766B5220BB}" destId="{C21058F5-47B6-4297-8195-25FAC184670C}" srcOrd="4" destOrd="0" parTransId="{9DC8773C-3093-411F-BF47-518C239FBFCA}" sibTransId="{D055AE86-B3E5-4C74-92AA-D6292B26E156}"/>
    <dgm:cxn modelId="{2AB5EC62-ABB4-4583-BFB0-11965B6019EC}" srcId="{DB863807-68D1-48D1-835B-44DE16AEECF3}" destId="{3B38241B-4131-4EA3-9B03-5AA80B152DAA}" srcOrd="1" destOrd="0" parTransId="{3DD62CB5-CFDD-4840-B8F5-CF1D6DC06C6E}" sibTransId="{D6507A19-53DB-4084-A7E3-6AE11FFF9340}"/>
    <dgm:cxn modelId="{7BC68AC5-694C-D74E-ACB7-FAF82C58604F}" type="presOf" srcId="{6752D7DA-2AC0-42AF-BBAE-E5D7A2A38F52}" destId="{6BCA1F02-8423-418F-9214-DC6DF4276FFE}" srcOrd="0" destOrd="0" presId="urn:microsoft.com/office/officeart/2008/layout/HorizontalMultiLevelHierarchy"/>
    <dgm:cxn modelId="{58C45559-2889-074E-AB1A-0F63A8D755AE}" type="presOf" srcId="{965BA46E-FDDC-4058-922A-312962713AE0}" destId="{0690BAF6-2E3E-48F7-B419-76D80DEF1285}" srcOrd="0" destOrd="0" presId="urn:microsoft.com/office/officeart/2008/layout/HorizontalMultiLevelHierarchy"/>
    <dgm:cxn modelId="{9C38206D-8970-0D44-BAEE-75781B3FF17B}" type="presOf" srcId="{907B1B9B-ECA6-4BEE-A722-EC2FFB3680D0}" destId="{20D5FBEA-911F-425D-A3CA-BF1B3A8EE1DA}" srcOrd="0" destOrd="0" presId="urn:microsoft.com/office/officeart/2008/layout/HorizontalMultiLevelHierarchy"/>
    <dgm:cxn modelId="{86BFCBC7-EF59-6248-8DC8-EA2A4E6C79B5}" type="presOf" srcId="{D3042A99-D4F2-41B5-8F86-40C7CAE69AB2}" destId="{3EA92CF5-981D-4617-8805-BD784484C463}" srcOrd="0" destOrd="0" presId="urn:microsoft.com/office/officeart/2008/layout/HorizontalMultiLevelHierarchy"/>
    <dgm:cxn modelId="{B26C6B4B-30EC-7D4D-A9A0-55C19DE3D796}" type="presOf" srcId="{5540D525-2741-4CAB-A8BD-E9C7F6576A9A}" destId="{1A97882B-88EC-4ACB-9DC7-C524B4434DD2}" srcOrd="1" destOrd="0" presId="urn:microsoft.com/office/officeart/2008/layout/HorizontalMultiLevelHierarchy"/>
    <dgm:cxn modelId="{213781FC-BA9D-4037-BCE1-977F2AABE448}" type="presOf" srcId="{11B4C912-86B2-426D-9B12-5566593C72E7}" destId="{E9416659-BBF5-4BD3-BE43-3B132573EE58}" srcOrd="0" destOrd="0" presId="urn:microsoft.com/office/officeart/2008/layout/HorizontalMultiLevelHierarchy"/>
    <dgm:cxn modelId="{92FE6F69-6656-3C40-B171-9059A0731F5C}" type="presOf" srcId="{914F4210-5B9E-4980-97F7-9832C4DD30E8}" destId="{57EACCEA-F453-4574-9F35-453FAAE65FAE}" srcOrd="1" destOrd="0" presId="urn:microsoft.com/office/officeart/2008/layout/HorizontalMultiLevelHierarchy"/>
    <dgm:cxn modelId="{1449B03D-C833-BD4A-8E4A-D2CED9F915DD}" type="presOf" srcId="{744304DD-CC18-4659-B854-EE14F8BA0780}" destId="{AAB712C3-60DD-4845-987A-871BB6E7CBC6}" srcOrd="0" destOrd="0" presId="urn:microsoft.com/office/officeart/2008/layout/HorizontalMultiLevelHierarchy"/>
    <dgm:cxn modelId="{4127DB69-3C00-4930-9252-70D711642816}" srcId="{9F0DA4E6-6AB7-41FE-8070-50C4E5B8715E}" destId="{4F824936-EEAE-477A-94E1-085DAC5C9D3C}" srcOrd="5" destOrd="0" parTransId="{95228426-4069-4FD3-B1B6-2A6131818E5A}" sibTransId="{F246A413-1DCA-422A-91D4-1E5396A68C63}"/>
    <dgm:cxn modelId="{02FFF324-F989-8D4F-9199-E87F1CC12DA4}" type="presOf" srcId="{DFD75553-0E6E-46BA-A20F-4B82AE13638E}" destId="{145B8CA3-BB26-4DB4-AC81-AFBE26AF21EB}" srcOrd="0" destOrd="0" presId="urn:microsoft.com/office/officeart/2008/layout/HorizontalMultiLevelHierarchy"/>
    <dgm:cxn modelId="{BB6DC666-A8F3-5E4F-A5D9-9358DCF88BAB}" type="presOf" srcId="{662C0AE4-FF05-4D26-A34F-AF2104520F5D}" destId="{D95317B9-76BE-4111-8A76-04456BE5B4E4}" srcOrd="0" destOrd="0" presId="urn:microsoft.com/office/officeart/2008/layout/HorizontalMultiLevelHierarchy"/>
    <dgm:cxn modelId="{7BC93EAB-3AF7-2A46-884E-074F000C7BDC}" type="presOf" srcId="{15419740-8019-43E9-B6B0-C06F14B37B04}" destId="{12E003C6-4AFF-4D58-B542-ECD9CE0A59CB}" srcOrd="1" destOrd="0" presId="urn:microsoft.com/office/officeart/2008/layout/HorizontalMultiLevelHierarchy"/>
    <dgm:cxn modelId="{7BF24411-8635-0342-AD99-2EDD1A53918A}" type="presOf" srcId="{74B95A49-6389-4C00-9037-4D593ECB2321}" destId="{E2616EF7-4194-4236-85F9-832BC8793282}" srcOrd="1" destOrd="0" presId="urn:microsoft.com/office/officeart/2008/layout/HorizontalMultiLevelHierarchy"/>
    <dgm:cxn modelId="{7C819175-7B0C-674A-9540-EAE5D59D59C6}" type="presOf" srcId="{C9E29CE9-D9ED-4EB6-875D-B2713E1107BB}" destId="{61CF67B4-D647-467C-824B-AF05E62F23FB}" srcOrd="0" destOrd="0" presId="urn:microsoft.com/office/officeart/2008/layout/HorizontalMultiLevelHierarchy"/>
    <dgm:cxn modelId="{8CC6888A-0BBC-4C44-A379-106CB3660CAC}" type="presOf" srcId="{EA7CE3B7-DE08-411B-B462-44DB760A778C}" destId="{1933C373-9436-497B-AC32-4A55FA51135A}" srcOrd="0" destOrd="0" presId="urn:microsoft.com/office/officeart/2008/layout/HorizontalMultiLevelHierarchy"/>
    <dgm:cxn modelId="{7995E57C-7AC0-0C41-BF28-707BBDB0B020}" type="presOf" srcId="{B3E97CCC-D8F2-4A81-991C-51C9BF2A6F43}" destId="{BC6A27C1-C76C-49EA-979A-2A521D1FCCEF}" srcOrd="1" destOrd="0" presId="urn:microsoft.com/office/officeart/2008/layout/HorizontalMultiLevelHierarchy"/>
    <dgm:cxn modelId="{5BB1E736-441B-2F43-AA37-DB63496A8998}" type="presOf" srcId="{B3E97CCC-D8F2-4A81-991C-51C9BF2A6F43}" destId="{85680CD6-D861-4B8C-B4BB-D395BF852CF2}" srcOrd="0" destOrd="0" presId="urn:microsoft.com/office/officeart/2008/layout/HorizontalMultiLevelHierarchy"/>
    <dgm:cxn modelId="{5F94369B-7427-B647-B496-A171635A462D}" type="presOf" srcId="{5540D525-2741-4CAB-A8BD-E9C7F6576A9A}" destId="{A4E749FA-28E1-4471-ACD8-81F784E93244}" srcOrd="0" destOrd="0" presId="urn:microsoft.com/office/officeart/2008/layout/HorizontalMultiLevelHierarchy"/>
    <dgm:cxn modelId="{9D125D1D-DC21-493E-B062-8947D4D1FA05}" srcId="{9F0DA4E6-6AB7-41FE-8070-50C4E5B8715E}" destId="{907B1B9B-ECA6-4BEE-A722-EC2FFB3680D0}" srcOrd="0" destOrd="0" parTransId="{D3042A99-D4F2-41B5-8F86-40C7CAE69AB2}" sibTransId="{D980D24C-9655-4DA7-9AC9-E7D028D586A2}"/>
    <dgm:cxn modelId="{9A42903E-96C6-E842-B75E-B5FE1584D57C}" type="presOf" srcId="{C658F482-DF29-4B3B-A07B-AD14AD1D5C69}" destId="{C8FC8D5D-30F7-471E-B8B8-5F224FEE8B53}" srcOrd="0" destOrd="0" presId="urn:microsoft.com/office/officeart/2008/layout/HorizontalMultiLevelHierarchy"/>
    <dgm:cxn modelId="{34BF847F-0792-524E-941F-4A439180752C}" type="presOf" srcId="{9F0DA4E6-6AB7-41FE-8070-50C4E5B8715E}" destId="{5950EC2C-60B2-40BD-A6A0-E7A8BAC442F1}" srcOrd="0" destOrd="0" presId="urn:microsoft.com/office/officeart/2008/layout/HorizontalMultiLevelHierarchy"/>
    <dgm:cxn modelId="{082723EB-864B-BD4F-B7B3-E3FB20C41AEF}" type="presOf" srcId="{12B7AA39-7294-49E2-9AD1-5D9B28ABBCD0}" destId="{2CBD4155-2ED1-46FA-83BC-97CAA04F9980}" srcOrd="0" destOrd="0" presId="urn:microsoft.com/office/officeart/2008/layout/HorizontalMultiLevelHierarchy"/>
    <dgm:cxn modelId="{0953E2FE-9B61-41BD-A8C9-99BF795BD3DC}" srcId="{9F0DA4E6-6AB7-41FE-8070-50C4E5B8715E}" destId="{04694563-0CDC-44CE-A9A0-707A504A5839}" srcOrd="7" destOrd="0" parTransId="{10EC9B84-4143-4860-B9E4-8C811825C3C2}" sibTransId="{07F7B919-387F-4E49-9F6C-6B1C1456EF10}"/>
    <dgm:cxn modelId="{B7E9AD71-2E8F-4F9A-A556-A0DE9487C54E}" srcId="{907B1B9B-ECA6-4BEE-A722-EC2FFB3680D0}" destId="{AAFEDFF3-7262-457D-868C-3B7CC5E9E6FD}" srcOrd="0" destOrd="0" parTransId="{02B85F9D-5D86-40C8-9FBB-51DBE1475DDB}" sibTransId="{2CD73C8F-4036-455C-9509-885147F64FCF}"/>
    <dgm:cxn modelId="{55DF9A40-27D5-4308-B070-1E29B4B4CA61}" type="presOf" srcId="{D6FEC866-8B8D-4B3F-9C64-E41CE3FA1A6B}" destId="{2FCF096E-BB8B-4040-A659-ADA3B7C0E269}" srcOrd="0" destOrd="0" presId="urn:microsoft.com/office/officeart/2008/layout/HorizontalMultiLevelHierarchy"/>
    <dgm:cxn modelId="{66800EF4-D803-4611-955B-F56B86B33776}" srcId="{D5D4FB50-B364-42DC-BEFD-E40B7198D856}" destId="{64FB4822-5D01-405E-A2FC-6C9581874534}" srcOrd="0" destOrd="0" parTransId="{11B4C912-86B2-426D-9B12-5566593C72E7}" sibTransId="{DFC7F15E-C9FB-46CE-BC56-870677B79A5B}"/>
    <dgm:cxn modelId="{0802D1A8-29EB-A74F-9DB1-5067A45ECEE2}" type="presOf" srcId="{965BA46E-FDDC-4058-922A-312962713AE0}" destId="{644B0916-88CC-4E2D-8F8B-61CB7AB19F11}" srcOrd="1" destOrd="0" presId="urn:microsoft.com/office/officeart/2008/layout/HorizontalMultiLevelHierarchy"/>
    <dgm:cxn modelId="{65233A00-5FDA-3741-B36E-3D50D761757F}" type="presOf" srcId="{95228426-4069-4FD3-B1B6-2A6131818E5A}" destId="{F5E475E5-8A42-4579-B194-FAF922E7809E}" srcOrd="1" destOrd="0" presId="urn:microsoft.com/office/officeart/2008/layout/HorizontalMultiLevelHierarchy"/>
    <dgm:cxn modelId="{3B96AAF8-C097-694F-A6AB-96D5165B2D12}" type="presOf" srcId="{D3042A99-D4F2-41B5-8F86-40C7CAE69AB2}" destId="{15DEE82D-2EBD-424B-B4D5-9B60623B048E}" srcOrd="1" destOrd="0" presId="urn:microsoft.com/office/officeart/2008/layout/HorizontalMultiLevelHierarchy"/>
    <dgm:cxn modelId="{B924A0DC-5C2D-FB4C-85CC-2DBEFE352133}" type="presOf" srcId="{EC7BC250-206D-4415-BEA1-374E010C5787}" destId="{830B9FBE-FD6D-4E41-8F80-CDFE00D42519}" srcOrd="0" destOrd="0" presId="urn:microsoft.com/office/officeart/2008/layout/HorizontalMultiLevelHierarchy"/>
    <dgm:cxn modelId="{6183E97D-7D2A-DF44-9C35-33DF8A393568}" type="presOf" srcId="{C21058F5-47B6-4297-8195-25FAC184670C}" destId="{D2BED35C-0932-451D-A00D-15E358B75803}" srcOrd="0" destOrd="0" presId="urn:microsoft.com/office/officeart/2008/layout/HorizontalMultiLevelHierarchy"/>
    <dgm:cxn modelId="{491AFAAD-C0E1-4E94-856F-4B955E2966C1}" srcId="{9F0DA4E6-6AB7-41FE-8070-50C4E5B8715E}" destId="{163272B5-FA91-4958-99F0-01272988D46C}" srcOrd="4" destOrd="0" parTransId="{682C0709-9E9D-41F8-B06D-3E7341C52348}" sibTransId="{7614C7FC-E14D-41E3-925B-8C1EBD1CAD63}"/>
    <dgm:cxn modelId="{8965BA67-0353-454C-B612-B3C91C74B26E}" type="presOf" srcId="{31548E82-F2D1-424A-A955-20ADDF32729A}" destId="{32191076-4C62-4EFB-974A-465CDC7D6560}" srcOrd="0" destOrd="0" presId="urn:microsoft.com/office/officeart/2008/layout/HorizontalMultiLevelHierarchy"/>
    <dgm:cxn modelId="{81AD324B-560B-4CB8-A49E-D98B0EF95B59}" srcId="{BE2240EA-4EA6-4066-ABD8-A340FBEBDE12}" destId="{0657636B-EFF1-416F-9BD5-2691D2A75023}" srcOrd="0" destOrd="0" parTransId="{744304DD-CC18-4659-B854-EE14F8BA0780}" sibTransId="{095CBC92-DE9B-4FEA-967F-0F1498F442DE}"/>
    <dgm:cxn modelId="{2FE62D41-37DF-6E4A-91FE-37B2BFE9242C}" type="presOf" srcId="{04694563-0CDC-44CE-A9A0-707A504A5839}" destId="{41832CCF-0117-4FEC-B465-24629687F834}" srcOrd="0" destOrd="0" presId="urn:microsoft.com/office/officeart/2008/layout/HorizontalMultiLevelHierarchy"/>
    <dgm:cxn modelId="{1B2707EB-5A21-0A48-BAED-5C757EAB4A24}" type="presOf" srcId="{02B85F9D-5D86-40C8-9FBB-51DBE1475DDB}" destId="{15F6125B-B568-4421-B0DC-F55286F024FF}" srcOrd="1" destOrd="0" presId="urn:microsoft.com/office/officeart/2008/layout/HorizontalMultiLevelHierarchy"/>
    <dgm:cxn modelId="{F45BCBF4-C1C2-4180-B5C2-A3251DD2C9EA}" srcId="{9F0DA4E6-6AB7-41FE-8070-50C4E5B8715E}" destId="{7AC16027-874A-4B00-9484-F5A42AA27E4F}" srcOrd="2" destOrd="0" parTransId="{C658F482-DF29-4B3B-A07B-AD14AD1D5C69}" sibTransId="{EABB49BA-5F5C-40AC-84E7-B9D676BA3C92}"/>
    <dgm:cxn modelId="{A66D9511-1BD3-BF4C-994E-E0151260D7D5}" type="presOf" srcId="{E74928B5-AAE7-4EE8-81D7-514794113F1A}" destId="{9A8BBF3E-80F7-4CDC-8949-9486CC82C37E}" srcOrd="0" destOrd="0" presId="urn:microsoft.com/office/officeart/2008/layout/HorizontalMultiLevelHierarchy"/>
    <dgm:cxn modelId="{EF89ECF3-7D1D-E340-ABAB-099666818481}" type="presOf" srcId="{F43AACF9-221E-4BD7-8472-436B58689816}" destId="{85DBA0F4-5A3C-4403-96FB-0B04850D1882}" srcOrd="0" destOrd="0" presId="urn:microsoft.com/office/officeart/2008/layout/HorizontalMultiLevelHierarchy"/>
    <dgm:cxn modelId="{6A7497B4-D058-014E-931B-0AD8BF712D0C}" type="presOf" srcId="{7AC16027-874A-4B00-9484-F5A42AA27E4F}" destId="{1127B8D7-3CD0-4F1D-9C2C-F99E8698E420}" srcOrd="0" destOrd="0" presId="urn:microsoft.com/office/officeart/2008/layout/HorizontalMultiLevelHierarchy"/>
    <dgm:cxn modelId="{F7D1C276-731B-6848-8137-8A564FA760C9}" type="presOf" srcId="{BE2240EA-4EA6-4066-ABD8-A340FBEBDE12}" destId="{C02522A6-04F2-4AE6-8CAF-62FE2C1A4E36}" srcOrd="0" destOrd="0" presId="urn:microsoft.com/office/officeart/2008/layout/HorizontalMultiLevelHierarchy"/>
    <dgm:cxn modelId="{A000E859-6DAE-4764-8F13-0C09E9756DB3}" srcId="{9F0DA4E6-6AB7-41FE-8070-50C4E5B8715E}" destId="{C9E29CE9-D9ED-4EB6-875D-B2713E1107BB}" srcOrd="8" destOrd="0" parTransId="{6752D7DA-2AC0-42AF-BBAE-E5D7A2A38F52}" sibTransId="{730FE39C-81A9-4009-B615-F5FB2F1E53FA}"/>
    <dgm:cxn modelId="{DDB4DF60-0C81-4CDF-8F93-171EA81F8B5E}" srcId="{9F0DA4E6-6AB7-41FE-8070-50C4E5B8715E}" destId="{BE2240EA-4EA6-4066-ABD8-A340FBEBDE12}" srcOrd="9" destOrd="0" parTransId="{F2AFAC63-15C8-4981-9A67-F1DE8DC0153F}" sibTransId="{FC920B73-D4CE-4900-BE63-E374A9D4F749}"/>
    <dgm:cxn modelId="{02C17182-7723-2E40-91B1-C9B57C54B540}" type="presOf" srcId="{7F9A3AFF-8CE4-4C74-A22E-97A3AB34FDCF}" destId="{50582FA0-BBE9-41F5-B774-DF272A2E7640}" srcOrd="0" destOrd="0" presId="urn:microsoft.com/office/officeart/2008/layout/HorizontalMultiLevelHierarchy"/>
    <dgm:cxn modelId="{A9AD9B0D-1DD7-734B-B9FB-D5DA5EE708F0}" type="presOf" srcId="{B6ADC0EF-4DE2-49AA-BC86-AD69D14FBB20}" destId="{F518CB70-8FC6-45C6-9986-0BCFA38267AE}" srcOrd="0" destOrd="0" presId="urn:microsoft.com/office/officeart/2008/layout/HorizontalMultiLevelHierarchy"/>
    <dgm:cxn modelId="{66385BB8-1A50-D14C-B144-9B7E46CD5C5A}" type="presOf" srcId="{1F2D1459-DF4F-4534-BD50-8CA02C19177D}" destId="{960E4D89-EE87-4C6C-A706-B7013A8D6463}" srcOrd="0" destOrd="0" presId="urn:microsoft.com/office/officeart/2008/layout/HorizontalMultiLevelHierarchy"/>
    <dgm:cxn modelId="{3575F1E6-C213-5047-AD0E-FD81E01AE5D9}" type="presOf" srcId="{14A1D4EB-D46A-4EAA-9058-A0F03BEE701D}" destId="{AEC6F2D4-95D5-48AD-82E9-6283D5B7C839}" srcOrd="0" destOrd="0" presId="urn:microsoft.com/office/officeart/2008/layout/HorizontalMultiLevelHierarchy"/>
    <dgm:cxn modelId="{955B39A1-70C7-C34A-AC88-04BE6158BCFE}" type="presOf" srcId="{3B38241B-4131-4EA3-9B03-5AA80B152DAA}" destId="{17ABBCEC-A837-48DB-99C5-BD19A8A746C1}" srcOrd="0" destOrd="0" presId="urn:microsoft.com/office/officeart/2008/layout/HorizontalMultiLevelHierarchy"/>
    <dgm:cxn modelId="{C8EDF35B-CA7E-44DC-90F0-B11F585F36EE}" srcId="{2AA0A808-362A-4E43-9B46-3F766B5220BB}" destId="{89904C7D-191B-44E6-8B73-8B4A4666B243}" srcOrd="0" destOrd="0" parTransId="{B3E97CCC-D8F2-4A81-991C-51C9BF2A6F43}" sibTransId="{BF480FDD-70EC-4CF5-B917-F2A20EDFA41C}"/>
    <dgm:cxn modelId="{9915CCC2-BE23-6644-87B5-6927257BBD66}" type="presOf" srcId="{C658F482-DF29-4B3B-A07B-AD14AD1D5C69}" destId="{5342639D-3AF5-4D66-A9BD-D9379B93D203}" srcOrd="1" destOrd="0" presId="urn:microsoft.com/office/officeart/2008/layout/HorizontalMultiLevelHierarchy"/>
    <dgm:cxn modelId="{49392F8A-5827-4703-A206-EE813B76B99F}" type="presOf" srcId="{D5D4FB50-B364-42DC-BEFD-E40B7198D856}" destId="{72636010-4576-474C-8CDC-44780E4BDC8F}" srcOrd="0" destOrd="0" presId="urn:microsoft.com/office/officeart/2008/layout/HorizontalMultiLevelHierarchy"/>
    <dgm:cxn modelId="{2F7DBFE0-4674-8949-A304-1295C95E5527}" type="presOf" srcId="{F9BB6BB1-7D55-459B-AF73-859533C8E860}" destId="{597BC5DD-74CC-47C5-AD40-3A868FED9E4F}" srcOrd="0" destOrd="0" presId="urn:microsoft.com/office/officeart/2008/layout/HorizontalMultiLevelHierarchy"/>
    <dgm:cxn modelId="{2C25C959-1D89-426B-A29E-D25B3D4BE695}" srcId="{2AA0A808-362A-4E43-9B46-3F766B5220BB}" destId="{F9BB6BB1-7D55-459B-AF73-859533C8E860}" srcOrd="2" destOrd="0" parTransId="{043607C2-812B-4762-B64A-5CD082B12B08}" sibTransId="{15206345-544A-4E5F-B86A-442B039EBF6E}"/>
    <dgm:cxn modelId="{744BF415-DFE7-A540-9B44-F7EBF0DC5126}" type="presOf" srcId="{F2AFAC63-15C8-4981-9A67-F1DE8DC0153F}" destId="{395AD0D9-A03B-44EE-82E5-6516F1FB7018}" srcOrd="1" destOrd="0" presId="urn:microsoft.com/office/officeart/2008/layout/HorizontalMultiLevelHierarchy"/>
    <dgm:cxn modelId="{6F3FE156-AB50-2243-BFC0-62970583D678}" type="presOf" srcId="{FE75DAA3-E36C-4224-AF68-160B569ADEA1}" destId="{9F40458A-8537-45BD-A0BA-E3C93C1910FD}" srcOrd="1" destOrd="0" presId="urn:microsoft.com/office/officeart/2008/layout/HorizontalMultiLevelHierarchy"/>
    <dgm:cxn modelId="{E8D22FCB-5A63-4907-BFED-7783A8C1003D}" srcId="{4F824936-EEAE-477A-94E1-085DAC5C9D3C}" destId="{F43AACF9-221E-4BD7-8472-436B58689816}" srcOrd="0" destOrd="0" parTransId="{1F2D1459-DF4F-4534-BD50-8CA02C19177D}" sibTransId="{49BED331-0427-4141-9934-E75AF2FB0D8E}"/>
    <dgm:cxn modelId="{76E5CBB8-4193-4A72-88F9-E72E043F7551}" srcId="{163272B5-FA91-4958-99F0-01272988D46C}" destId="{071AAAAD-8791-457E-8470-D878A59BD241}" srcOrd="1" destOrd="0" parTransId="{CC8DED40-504F-4A4D-B60D-0E822D5048E2}" sibTransId="{997C293A-EABB-40E8-8CA8-02553900164D}"/>
    <dgm:cxn modelId="{7EAA1C39-8BDB-46C2-A2F7-89A99F00C85F}" srcId="{CD8488F9-CA59-4E1E-B78A-7EDD09AFBBAA}" destId="{DB863807-68D1-48D1-835B-44DE16AEECF3}" srcOrd="0" destOrd="0" parTransId="{F8B7C80A-DFE3-4DC5-A260-772411889970}" sibTransId="{235ECEC0-A1BF-4B9B-807F-7AD239930831}"/>
    <dgm:cxn modelId="{C93636CD-E823-C140-B4B0-E1FC9AAA4C6C}" type="presOf" srcId="{15419740-8019-43E9-B6B0-C06F14B37B04}" destId="{D8521D54-7213-4694-BBC0-4F888AA592CD}" srcOrd="0" destOrd="0" presId="urn:microsoft.com/office/officeart/2008/layout/HorizontalMultiLevelHierarchy"/>
    <dgm:cxn modelId="{0D97F2FC-9758-495C-9242-532A07A3BC99}" srcId="{B8F951F1-0876-4D5D-8FDC-E1892E3FDD52}" destId="{D9CB76B7-43FE-49B8-A1A5-3F399C0DBC76}" srcOrd="2" destOrd="0" parTransId="{914F4210-5B9E-4980-97F7-9832C4DD30E8}" sibTransId="{91AA9908-8FEA-40CB-90F0-61CDC289A405}"/>
    <dgm:cxn modelId="{0C415215-62E8-C544-9AB0-7FA7268E154E}" type="presOf" srcId="{EB106A67-DB70-4226-8605-1052C09DA4E6}" destId="{7ECB0AE2-150A-4134-A298-5547C3F26CC0}" srcOrd="0" destOrd="0" presId="urn:microsoft.com/office/officeart/2008/layout/HorizontalMultiLevelHierarchy"/>
    <dgm:cxn modelId="{479F8002-7143-934B-B47A-803D37F0987F}" type="presOf" srcId="{7F9A3AFF-8CE4-4C74-A22E-97A3AB34FDCF}" destId="{9A9420DC-F1B7-4C0C-8BF0-C2E0C4CBC93F}" srcOrd="1" destOrd="0" presId="urn:microsoft.com/office/officeart/2008/layout/HorizontalMultiLevelHierarchy"/>
    <dgm:cxn modelId="{5BA426AA-A865-044C-8269-1EF873370E68}" type="presOf" srcId="{D9CB76B7-43FE-49B8-A1A5-3F399C0DBC76}" destId="{F3622D4E-BCD1-4B03-B6CA-2B65BC37B6F2}" srcOrd="0" destOrd="0" presId="urn:microsoft.com/office/officeart/2008/layout/HorizontalMultiLevelHierarchy"/>
    <dgm:cxn modelId="{53EAAD50-CFC1-46B5-A5F1-C64AA283344F}" srcId="{9F0DA4E6-6AB7-41FE-8070-50C4E5B8715E}" destId="{2AA0A808-362A-4E43-9B46-3F766B5220BB}" srcOrd="3" destOrd="0" parTransId="{7F9A3AFF-8CE4-4C74-A22E-97A3AB34FDCF}" sibTransId="{AED33D2D-88F7-4CEF-9FFC-6CECC09DB2F9}"/>
    <dgm:cxn modelId="{02EA3DB0-AB49-AE41-9589-4E486878AD37}" type="presOf" srcId="{DC379277-C327-44BA-8E38-7721D3680BBF}" destId="{D6B8B294-83DE-452C-825B-2D17F4DEC758}" srcOrd="1" destOrd="0" presId="urn:microsoft.com/office/officeart/2008/layout/HorizontalMultiLevelHierarchy"/>
    <dgm:cxn modelId="{33E231D4-1EAC-6F44-9D7D-DDC03FF1C47C}" type="presOf" srcId="{DFD75553-0E6E-46BA-A20F-4B82AE13638E}" destId="{FB2D46A2-1817-4DCE-B72E-E6F9B2BAE590}" srcOrd="1" destOrd="0" presId="urn:microsoft.com/office/officeart/2008/layout/HorizontalMultiLevelHierarchy"/>
    <dgm:cxn modelId="{A7A257E1-F1D0-4E4C-A436-168640F11B72}" type="presOf" srcId="{9DC8773C-3093-411F-BF47-518C239FBFCA}" destId="{9DB92DDD-27F6-4497-9884-A177005DC173}" srcOrd="1" destOrd="0" presId="urn:microsoft.com/office/officeart/2008/layout/HorizontalMultiLevelHierarchy"/>
    <dgm:cxn modelId="{25A7F818-6E81-494F-87CB-82ABDB128D21}" type="presOf" srcId="{10EC9B84-4143-4860-B9E4-8C811825C3C2}" destId="{3638F33C-3AFC-4822-AD4D-20D5F3841C21}" srcOrd="1" destOrd="0" presId="urn:microsoft.com/office/officeart/2008/layout/HorizontalMultiLevelHierarchy"/>
    <dgm:cxn modelId="{293522AA-0D73-4145-83AF-E6E749AEED05}" srcId="{163272B5-FA91-4958-99F0-01272988D46C}" destId="{14A1D4EB-D46A-4EAA-9058-A0F03BEE701D}" srcOrd="0" destOrd="0" parTransId="{71EF7A92-5EF4-4681-B8F2-D60279767D5E}" sibTransId="{BCAFF64B-EF41-42EA-B33A-3DEC990853FE}"/>
    <dgm:cxn modelId="{DB796B2A-F73F-7647-99FD-38A7E48FE862}" type="presOf" srcId="{02B85F9D-5D86-40C8-9FBB-51DBE1475DDB}" destId="{AA29A888-0A17-4B4C-870A-E5E95ABD4FAA}" srcOrd="0" destOrd="0" presId="urn:microsoft.com/office/officeart/2008/layout/HorizontalMultiLevelHierarchy"/>
    <dgm:cxn modelId="{52D8C112-B1E0-8B43-8CE1-C022A7B10D0F}" type="presOf" srcId="{CC8DED40-504F-4A4D-B60D-0E822D5048E2}" destId="{0B1934E3-BED7-41C6-8334-56CDE0C18457}" srcOrd="0" destOrd="0" presId="urn:microsoft.com/office/officeart/2008/layout/HorizontalMultiLevelHierarchy"/>
    <dgm:cxn modelId="{C3969536-9807-C247-AC84-F6F28E1AAC82}" type="presOf" srcId="{EFFFF2CC-B614-45BF-9375-15ED5B8AAFA3}" destId="{78B80AB1-7240-47D1-922D-C9649794E709}" srcOrd="0" destOrd="0" presId="urn:microsoft.com/office/officeart/2008/layout/HorizontalMultiLevelHierarchy"/>
    <dgm:cxn modelId="{AE0ED4C0-5CA1-491C-9168-CD39B6B8AF52}" srcId="{7AC16027-874A-4B00-9484-F5A42AA27E4F}" destId="{EA7CE3B7-DE08-411B-B462-44DB760A778C}" srcOrd="1" destOrd="0" parTransId="{74B95A49-6389-4C00-9037-4D593ECB2321}" sibTransId="{49FF4827-2986-47FC-A00F-1F8F5BDF0589}"/>
    <dgm:cxn modelId="{51F42BC1-CEB6-4CE2-98A6-E0909F09261E}" srcId="{2AA0A808-362A-4E43-9B46-3F766B5220BB}" destId="{662C0AE4-FF05-4D26-A34F-AF2104520F5D}" srcOrd="3" destOrd="0" parTransId="{8E358C9A-6C64-4EE5-9066-85B40192709A}" sibTransId="{BF932F64-EB13-4223-90E5-E183BCC55BF2}"/>
    <dgm:cxn modelId="{36BAC387-9D98-DD42-81A0-8BE5A6A3D39B}" type="presOf" srcId="{071AAAAD-8791-457E-8470-D878A59BD241}" destId="{0ED870BF-DE06-43B1-B8FD-733691756967}" srcOrd="0" destOrd="0" presId="urn:microsoft.com/office/officeart/2008/layout/HorizontalMultiLevelHierarchy"/>
    <dgm:cxn modelId="{8015D8A4-FF98-4BFE-9436-5EFE77F6E386}" type="presOf" srcId="{D6FEC866-8B8D-4B3F-9C64-E41CE3FA1A6B}" destId="{2258EE37-1D25-4656-A586-D82B3DE9DEE3}" srcOrd="1" destOrd="0" presId="urn:microsoft.com/office/officeart/2008/layout/HorizontalMultiLevelHierarchy"/>
    <dgm:cxn modelId="{1ADB41AE-EC9F-4DC1-A8CF-775E9467FDAD}" srcId="{04694563-0CDC-44CE-A9A0-707A504A5839}" destId="{C21B325D-FB32-4F11-BA86-37F754BB16FF}" srcOrd="0" destOrd="0" parTransId="{B6ADC0EF-4DE2-49AA-BC86-AD69D14FBB20}" sibTransId="{9D24EF50-F866-4C4A-BC09-91BD19701C81}"/>
    <dgm:cxn modelId="{732EDAB2-A5C5-4D9B-87DC-3693C946A119}" srcId="{9F0DA4E6-6AB7-41FE-8070-50C4E5B8715E}" destId="{B8F951F1-0876-4D5D-8FDC-E1892E3FDD52}" srcOrd="1" destOrd="0" parTransId="{DC379277-C327-44BA-8E38-7721D3680BBF}" sibTransId="{11BE97A4-CCE9-42B0-8556-8FAFCC3E3460}"/>
    <dgm:cxn modelId="{3B9A86FB-D8BE-5F42-A0CE-E1FEFE8A37F4}" type="presOf" srcId="{7A2808FA-D9CF-4A80-967D-2DB8C6585047}" destId="{4A680F8A-FBBC-4BF5-9FFF-0E20FF8A2653}" srcOrd="1" destOrd="0" presId="urn:microsoft.com/office/officeart/2008/layout/HorizontalMultiLevelHierarchy"/>
    <dgm:cxn modelId="{264FC139-193D-6F47-A644-9CD98EC673E7}" type="presOf" srcId="{6752D7DA-2AC0-42AF-BBAE-E5D7A2A38F52}" destId="{5D1B088A-A6CF-436C-847E-34048BAA346B}" srcOrd="1" destOrd="0" presId="urn:microsoft.com/office/officeart/2008/layout/HorizontalMultiLevelHierarchy"/>
    <dgm:cxn modelId="{752D9489-2D45-694C-97F8-EC932C53D6EF}" type="presOf" srcId="{682C0709-9E9D-41F8-B06D-3E7341C52348}" destId="{EDB39F50-E6A5-4BE9-B9EE-7CBD1C48E142}" srcOrd="0" destOrd="0" presId="urn:microsoft.com/office/officeart/2008/layout/HorizontalMultiLevelHierarchy"/>
    <dgm:cxn modelId="{08F2D9D2-265E-C645-A2BD-81C937B765AD}" type="presOf" srcId="{1F2D1459-DF4F-4534-BD50-8CA02C19177D}" destId="{F6EBD4E4-F1B7-411F-B620-3CCDA123E074}" srcOrd="1" destOrd="0" presId="urn:microsoft.com/office/officeart/2008/layout/HorizontalMultiLevelHierarchy"/>
    <dgm:cxn modelId="{F05E0773-AFF5-4E02-84C8-ACD3FFD00AE8}" srcId="{7AC16027-874A-4B00-9484-F5A42AA27E4F}" destId="{C20BB801-8511-462F-849B-48B8148621D5}" srcOrd="2" destOrd="0" parTransId="{965BA46E-FDDC-4058-922A-312962713AE0}" sibTransId="{394E5467-DA77-4BBF-966D-89A8582F2EE2}"/>
    <dgm:cxn modelId="{5C4B4B55-DE6E-6144-8D1B-D01B7175C77E}" type="presOf" srcId="{163272B5-FA91-4958-99F0-01272988D46C}" destId="{21F2160D-B234-45C3-831F-32DA92F9E092}" srcOrd="0" destOrd="0" presId="urn:microsoft.com/office/officeart/2008/layout/HorizontalMultiLevelHierarchy"/>
    <dgm:cxn modelId="{CA190054-CAC2-EB43-B66A-B1CD7304CD72}" type="presOf" srcId="{C21B325D-FB32-4F11-BA86-37F754BB16FF}" destId="{00C4BBE0-EBF3-4395-A6F4-1E6BC19228B5}" srcOrd="0" destOrd="0" presId="urn:microsoft.com/office/officeart/2008/layout/HorizontalMultiLevelHierarchy"/>
    <dgm:cxn modelId="{924F6D63-F7A6-204E-9BBD-7AF7F0E55627}" type="presOf" srcId="{3DD62CB5-CFDD-4840-B8F5-CF1D6DC06C6E}" destId="{C6F9E6C5-B465-4544-8E33-CD9BD0A1F830}" srcOrd="0" destOrd="0" presId="urn:microsoft.com/office/officeart/2008/layout/HorizontalMultiLevelHierarchy"/>
    <dgm:cxn modelId="{131DA9F6-3FAA-4D35-8337-D6BC1B7593EA}" srcId="{B8F951F1-0876-4D5D-8FDC-E1892E3FDD52}" destId="{31548E82-F2D1-424A-A955-20ADDF32729A}" srcOrd="1" destOrd="0" parTransId="{5540D525-2741-4CAB-A8BD-E9C7F6576A9A}" sibTransId="{64D465D4-903E-48AE-9E4E-CFE97F8FCAF1}"/>
    <dgm:cxn modelId="{CB2589E8-5888-CC4C-85CB-9DC71B50082C}" type="presOf" srcId="{682C0709-9E9D-41F8-B06D-3E7341C52348}" destId="{65F74B9C-4346-41F3-B001-FCEFA52E5536}" srcOrd="1" destOrd="0" presId="urn:microsoft.com/office/officeart/2008/layout/HorizontalMultiLevelHierarchy"/>
    <dgm:cxn modelId="{A6C99189-3149-6D41-8240-9D02828E0224}" type="presOf" srcId="{CC8DED40-504F-4A4D-B60D-0E822D5048E2}" destId="{BF296AFE-DE93-43D0-880D-C426CF8D691B}" srcOrd="1" destOrd="0" presId="urn:microsoft.com/office/officeart/2008/layout/HorizontalMultiLevelHierarchy"/>
    <dgm:cxn modelId="{7C359A38-98C4-CB4A-B509-7EA20F8B236E}" type="presOf" srcId="{10EC9B84-4143-4860-B9E4-8C811825C3C2}" destId="{576E1488-9ED3-4594-83C4-9410252E7C78}" srcOrd="0" destOrd="0" presId="urn:microsoft.com/office/officeart/2008/layout/HorizontalMultiLevelHierarchy"/>
    <dgm:cxn modelId="{99159092-FE9A-6147-B8D0-3FBB8B8D6E42}" type="presOf" srcId="{9DC8773C-3093-411F-BF47-518C239FBFCA}" destId="{E68CF398-FB37-46D5-AE40-35211BBBB345}" srcOrd="0" destOrd="0" presId="urn:microsoft.com/office/officeart/2008/layout/HorizontalMultiLevelHierarchy"/>
    <dgm:cxn modelId="{ED501062-AC6D-E649-8A2A-D5DAAB176D43}" type="presOf" srcId="{CD8488F9-CA59-4E1E-B78A-7EDD09AFBBAA}" destId="{170A78D5-93C1-4672-A2D6-72EF750020EB}" srcOrd="0" destOrd="0" presId="urn:microsoft.com/office/officeart/2008/layout/HorizontalMultiLevelHierarchy"/>
    <dgm:cxn modelId="{44A28936-3BCF-9D43-82D9-9694F8E7BC2D}" type="presOf" srcId="{F2AFAC63-15C8-4981-9A67-F1DE8DC0153F}" destId="{33744C96-8DA5-4082-B453-52DC4E69799B}" srcOrd="0" destOrd="0" presId="urn:microsoft.com/office/officeart/2008/layout/HorizontalMultiLevelHierarchy"/>
    <dgm:cxn modelId="{54DBAFE9-F531-4247-BC08-562CC0931D8F}" type="presOf" srcId="{7A2808FA-D9CF-4A80-967D-2DB8C6585047}" destId="{C3824F10-A10E-4549-B7A9-1C8ED929AE83}" srcOrd="0" destOrd="0" presId="urn:microsoft.com/office/officeart/2008/layout/HorizontalMultiLevelHierarchy"/>
    <dgm:cxn modelId="{2D64F9FD-34BA-D947-8A38-612CEF8B3528}" type="presOf" srcId="{2AA0A808-362A-4E43-9B46-3F766B5220BB}" destId="{5388DEAC-EED5-488A-BF01-C492E1548169}" srcOrd="0" destOrd="0" presId="urn:microsoft.com/office/officeart/2008/layout/HorizontalMultiLevelHierarchy"/>
    <dgm:cxn modelId="{0E941179-EE44-B04E-976B-036BF4E72389}" type="presOf" srcId="{241D139F-6324-4ACF-AA63-C03946F4B69B}" destId="{C3950836-6B16-410D-AB8D-A64C6FAB238C}" srcOrd="0" destOrd="0" presId="urn:microsoft.com/office/officeart/2008/layout/HorizontalMultiLevelHierarchy"/>
    <dgm:cxn modelId="{6897306E-1468-474F-8731-889C4CC5FFED}" type="presOf" srcId="{95228426-4069-4FD3-B1B6-2A6131818E5A}" destId="{1CE5CB39-D3E9-4A7B-9C67-A233A6D7A627}" srcOrd="0" destOrd="0" presId="urn:microsoft.com/office/officeart/2008/layout/HorizontalMultiLevelHierarchy"/>
    <dgm:cxn modelId="{004EDF0C-AA67-F14D-A2DE-E3D70DB164E9}" type="presOf" srcId="{B8F951F1-0876-4D5D-8FDC-E1892E3FDD52}" destId="{833AEC7A-B99D-48C0-871D-A4179B8964EB}" srcOrd="0" destOrd="0" presId="urn:microsoft.com/office/officeart/2008/layout/HorizontalMultiLevelHierarchy"/>
    <dgm:cxn modelId="{760AEE5A-8578-5545-B5BC-C5925587B026}" type="presOf" srcId="{EC7BC250-206D-4415-BEA1-374E010C5787}" destId="{CFF7D72D-25B0-47E4-B9D9-793E1490B4AC}" srcOrd="1" destOrd="0" presId="urn:microsoft.com/office/officeart/2008/layout/HorizontalMultiLevelHierarchy"/>
    <dgm:cxn modelId="{9421050C-BA42-4924-8C80-2E6E17056BB7}" srcId="{C9E29CE9-D9ED-4EB6-875D-B2713E1107BB}" destId="{EB106A67-DB70-4226-8605-1052C09DA4E6}" srcOrd="0" destOrd="0" parTransId="{EFFFF2CC-B614-45BF-9375-15ED5B8AAFA3}" sibTransId="{6946FADF-4963-43FB-9C7C-EA0810ED3671}"/>
    <dgm:cxn modelId="{926395EE-10CC-224A-B37B-0472C4CF9938}" type="presOf" srcId="{914F4210-5B9E-4980-97F7-9832C4DD30E8}" destId="{59EFD662-F5B9-4E51-96F1-5AF65A05E852}" srcOrd="0" destOrd="0" presId="urn:microsoft.com/office/officeart/2008/layout/HorizontalMultiLevelHierarchy"/>
    <dgm:cxn modelId="{313C53F2-2739-4CF3-AFE4-508CB6DB655D}" srcId="{7AC16027-874A-4B00-9484-F5A42AA27E4F}" destId="{241D139F-6324-4ACF-AA63-C03946F4B69B}" srcOrd="0" destOrd="0" parTransId="{FE75DAA3-E36C-4224-AF68-160B569ADEA1}" sibTransId="{A6B35C58-E779-4555-80A1-75FC4FA9BDB9}"/>
    <dgm:cxn modelId="{A4E2FD2A-5169-9C49-9F5A-0EE7D5790349}" type="presOf" srcId="{0657636B-EFF1-416F-9BD5-2691D2A75023}" destId="{4F5011DB-67AE-4DCB-A763-22674F8C3D79}" srcOrd="0" destOrd="0" presId="urn:microsoft.com/office/officeart/2008/layout/HorizontalMultiLevelHierarchy"/>
    <dgm:cxn modelId="{FDF9ACEC-1AB4-AB42-9D9A-39A1E68FA94C}" type="presOf" srcId="{8E358C9A-6C64-4EE5-9066-85B40192709A}" destId="{E6261245-03D0-4B1C-AF98-52998D9808BB}" srcOrd="1" destOrd="0" presId="urn:microsoft.com/office/officeart/2008/layout/HorizontalMultiLevelHierarchy"/>
    <dgm:cxn modelId="{479331D7-6E8B-764B-82FD-C0F01BA7A146}" type="presOf" srcId="{DC379277-C327-44BA-8E38-7721D3680BBF}" destId="{FFB10C08-8AB4-475C-A934-5DA1E07ACD7C}" srcOrd="0" destOrd="0" presId="urn:microsoft.com/office/officeart/2008/layout/HorizontalMultiLevelHierarchy"/>
    <dgm:cxn modelId="{8F1D3A68-C98D-9745-9A68-694858075BD8}" type="presOf" srcId="{3DD62CB5-CFDD-4840-B8F5-CF1D6DC06C6E}" destId="{81ECD647-6338-4A37-8423-A264D2E2EB4E}" srcOrd="1" destOrd="0" presId="urn:microsoft.com/office/officeart/2008/layout/HorizontalMultiLevelHierarchy"/>
    <dgm:cxn modelId="{EA8D1530-B3D9-420D-9E90-22211077F37E}" type="presOf" srcId="{11B4C912-86B2-426D-9B12-5566593C72E7}" destId="{6E490DE4-E453-43A4-ACC8-9745E76655F8}" srcOrd="1" destOrd="0" presId="urn:microsoft.com/office/officeart/2008/layout/HorizontalMultiLevelHierarchy"/>
    <dgm:cxn modelId="{994694AD-E806-B149-9F64-0D62A79735EB}" type="presOf" srcId="{C20BB801-8511-462F-849B-48B8148621D5}" destId="{4BB45888-D1DE-4D55-A070-864FDC435C39}" srcOrd="0" destOrd="0" presId="urn:microsoft.com/office/officeart/2008/layout/HorizontalMultiLevelHierarchy"/>
    <dgm:cxn modelId="{76278EDD-F595-9A40-8B1E-A7F663E4C878}" type="presOf" srcId="{EFFFF2CC-B614-45BF-9375-15ED5B8AAFA3}" destId="{002E5ACD-8ABF-455A-8C9E-D93151678682}" srcOrd="1" destOrd="0" presId="urn:microsoft.com/office/officeart/2008/layout/HorizontalMultiLevelHierarchy"/>
    <dgm:cxn modelId="{DC937197-F6AE-3E46-9F24-F40AB7333436}" type="presOf" srcId="{8E358C9A-6C64-4EE5-9066-85B40192709A}" destId="{EC21EC01-6866-4C21-816F-7D5367748A93}" srcOrd="0" destOrd="0" presId="urn:microsoft.com/office/officeart/2008/layout/HorizontalMultiLevelHierarchy"/>
    <dgm:cxn modelId="{940E342D-1F5A-AA49-81A5-B1C9F1D8876D}" type="presOf" srcId="{89904C7D-191B-44E6-8B73-8B4A4666B243}" destId="{C1DDE8C2-4167-4CB5-9227-79BD5883663D}" srcOrd="0" destOrd="0" presId="urn:microsoft.com/office/officeart/2008/layout/HorizontalMultiLevelHierarchy"/>
    <dgm:cxn modelId="{CDD21C30-81A7-4E96-B4EC-F4B46ECA8F69}" type="presOf" srcId="{64FB4822-5D01-405E-A2FC-6C9581874534}" destId="{ED81DF27-18D8-4CB1-B441-682B76EBC6C3}" srcOrd="0" destOrd="0" presId="urn:microsoft.com/office/officeart/2008/layout/HorizontalMultiLevelHierarchy"/>
    <dgm:cxn modelId="{B9901169-74C5-7646-ADD8-00E5BC462688}" type="presOf" srcId="{71EF7A92-5EF4-4681-B8F2-D60279767D5E}" destId="{E963BCA4-358F-4E84-A754-9B3BA2A663D7}" srcOrd="0" destOrd="0" presId="urn:microsoft.com/office/officeart/2008/layout/HorizontalMultiLevelHierarchy"/>
    <dgm:cxn modelId="{82115F23-FC0D-D04A-95FD-27148B1FAE1A}" type="presOf" srcId="{0E36E291-16E4-4737-92AE-1583297C9CA4}" destId="{B526AE86-C759-48C4-8513-9B514B692BF9}" srcOrd="0" destOrd="0" presId="urn:microsoft.com/office/officeart/2008/layout/HorizontalMultiLevelHierarchy"/>
    <dgm:cxn modelId="{DB0C5E18-CB39-4630-A95D-59AA84D13AD8}" srcId="{9F0DA4E6-6AB7-41FE-8070-50C4E5B8715E}" destId="{D5D4FB50-B364-42DC-BEFD-E40B7198D856}" srcOrd="6" destOrd="0" parTransId="{D6FEC866-8B8D-4B3F-9C64-E41CE3FA1A6B}" sibTransId="{8C948AF1-C6B4-4214-BE77-EE24898ACF3B}"/>
    <dgm:cxn modelId="{8FB655C4-E489-7942-8160-30F22E48A5A6}" type="presOf" srcId="{FE75DAA3-E36C-4224-AF68-160B569ADEA1}" destId="{80816A0F-AC68-4311-884A-5F8A58F08D7A}" srcOrd="0" destOrd="0" presId="urn:microsoft.com/office/officeart/2008/layout/HorizontalMultiLevelHierarchy"/>
    <dgm:cxn modelId="{A43378C3-C4FF-0F4C-860F-85E892B6FE78}" type="presOf" srcId="{74B95A49-6389-4C00-9037-4D593ECB2321}" destId="{641C7868-5C94-4B0C-AE68-14A543E74986}" srcOrd="0" destOrd="0" presId="urn:microsoft.com/office/officeart/2008/layout/HorizontalMultiLevelHierarchy"/>
    <dgm:cxn modelId="{C1AA2351-AE85-2548-83EF-834E5152E0EE}" type="presOf" srcId="{DB863807-68D1-48D1-835B-44DE16AEECF3}" destId="{1358FD25-A296-417B-8C32-0545935AECEA}" srcOrd="0" destOrd="0" presId="urn:microsoft.com/office/officeart/2008/layout/HorizontalMultiLevelHierarchy"/>
    <dgm:cxn modelId="{EB7BA310-A257-474C-848B-44F3DE65814D}" type="presParOf" srcId="{170A78D5-93C1-4672-A2D6-72EF750020EB}" destId="{02B8A451-AC2C-4436-84F6-65C3A7F002C7}" srcOrd="0" destOrd="0" presId="urn:microsoft.com/office/officeart/2008/layout/HorizontalMultiLevelHierarchy"/>
    <dgm:cxn modelId="{089933C0-6A7D-5D47-A788-4FEACBE03273}" type="presParOf" srcId="{02B8A451-AC2C-4436-84F6-65C3A7F002C7}" destId="{1358FD25-A296-417B-8C32-0545935AECEA}" srcOrd="0" destOrd="0" presId="urn:microsoft.com/office/officeart/2008/layout/HorizontalMultiLevelHierarchy"/>
    <dgm:cxn modelId="{19E03864-14F6-B44C-8A92-94ED03FE3DFB}" type="presParOf" srcId="{02B8A451-AC2C-4436-84F6-65C3A7F002C7}" destId="{664D5179-8A0A-40FC-BD45-DB24978D6F15}" srcOrd="1" destOrd="0" presId="urn:microsoft.com/office/officeart/2008/layout/HorizontalMultiLevelHierarchy"/>
    <dgm:cxn modelId="{9D4FE15F-6D20-B148-8909-EFF585FD0A52}" type="presParOf" srcId="{664D5179-8A0A-40FC-BD45-DB24978D6F15}" destId="{C3824F10-A10E-4549-B7A9-1C8ED929AE83}" srcOrd="0" destOrd="0" presId="urn:microsoft.com/office/officeart/2008/layout/HorizontalMultiLevelHierarchy"/>
    <dgm:cxn modelId="{70EE45D1-4AEE-B14C-80DC-FC5DD03DB373}" type="presParOf" srcId="{C3824F10-A10E-4549-B7A9-1C8ED929AE83}" destId="{4A680F8A-FBBC-4BF5-9FFF-0E20FF8A2653}" srcOrd="0" destOrd="0" presId="urn:microsoft.com/office/officeart/2008/layout/HorizontalMultiLevelHierarchy"/>
    <dgm:cxn modelId="{31E3F3F4-A431-F045-8C20-7D99049EABFB}" type="presParOf" srcId="{664D5179-8A0A-40FC-BD45-DB24978D6F15}" destId="{77664059-FFF8-416B-A751-CC7D3303F271}" srcOrd="1" destOrd="0" presId="urn:microsoft.com/office/officeart/2008/layout/HorizontalMultiLevelHierarchy"/>
    <dgm:cxn modelId="{8A9E6B73-A70A-8F4D-B77A-AA66ECBD3676}" type="presParOf" srcId="{77664059-FFF8-416B-A751-CC7D3303F271}" destId="{5950EC2C-60B2-40BD-A6A0-E7A8BAC442F1}" srcOrd="0" destOrd="0" presId="urn:microsoft.com/office/officeart/2008/layout/HorizontalMultiLevelHierarchy"/>
    <dgm:cxn modelId="{2AB034C4-AEA9-5348-B3FF-8551512FB3A7}" type="presParOf" srcId="{77664059-FFF8-416B-A751-CC7D3303F271}" destId="{72E62747-30D6-4D1D-BB89-7F1C84ED7D04}" srcOrd="1" destOrd="0" presId="urn:microsoft.com/office/officeart/2008/layout/HorizontalMultiLevelHierarchy"/>
    <dgm:cxn modelId="{29D10E91-8956-484A-A514-E11F3D66882D}" type="presParOf" srcId="{72E62747-30D6-4D1D-BB89-7F1C84ED7D04}" destId="{3EA92CF5-981D-4617-8805-BD784484C463}" srcOrd="0" destOrd="0" presId="urn:microsoft.com/office/officeart/2008/layout/HorizontalMultiLevelHierarchy"/>
    <dgm:cxn modelId="{7FD1A1A7-0FCD-0F43-8EEF-529BC3769DDF}" type="presParOf" srcId="{3EA92CF5-981D-4617-8805-BD784484C463}" destId="{15DEE82D-2EBD-424B-B4D5-9B60623B048E}" srcOrd="0" destOrd="0" presId="urn:microsoft.com/office/officeart/2008/layout/HorizontalMultiLevelHierarchy"/>
    <dgm:cxn modelId="{CBA3CD64-52EB-D14D-B371-2AA052A5D1BC}" type="presParOf" srcId="{72E62747-30D6-4D1D-BB89-7F1C84ED7D04}" destId="{FB3B054B-D947-42FD-B51F-11DF716CC292}" srcOrd="1" destOrd="0" presId="urn:microsoft.com/office/officeart/2008/layout/HorizontalMultiLevelHierarchy"/>
    <dgm:cxn modelId="{D53B38BA-026D-A64E-AF10-8589B3143D52}" type="presParOf" srcId="{FB3B054B-D947-42FD-B51F-11DF716CC292}" destId="{20D5FBEA-911F-425D-A3CA-BF1B3A8EE1DA}" srcOrd="0" destOrd="0" presId="urn:microsoft.com/office/officeart/2008/layout/HorizontalMultiLevelHierarchy"/>
    <dgm:cxn modelId="{473C3656-98BF-824F-9CBD-2CA37E0F71DB}" type="presParOf" srcId="{FB3B054B-D947-42FD-B51F-11DF716CC292}" destId="{EA19026D-C0E9-45E3-A915-A80C3D7913FE}" srcOrd="1" destOrd="0" presId="urn:microsoft.com/office/officeart/2008/layout/HorizontalMultiLevelHierarchy"/>
    <dgm:cxn modelId="{108ADEB8-81C3-3C43-AF41-D1A8C07F44FA}" type="presParOf" srcId="{EA19026D-C0E9-45E3-A915-A80C3D7913FE}" destId="{AA29A888-0A17-4B4C-870A-E5E95ABD4FAA}" srcOrd="0" destOrd="0" presId="urn:microsoft.com/office/officeart/2008/layout/HorizontalMultiLevelHierarchy"/>
    <dgm:cxn modelId="{12CD1D27-BCF9-A149-B25C-9C34F7FDDF6E}" type="presParOf" srcId="{AA29A888-0A17-4B4C-870A-E5E95ABD4FAA}" destId="{15F6125B-B568-4421-B0DC-F55286F024FF}" srcOrd="0" destOrd="0" presId="urn:microsoft.com/office/officeart/2008/layout/HorizontalMultiLevelHierarchy"/>
    <dgm:cxn modelId="{251B1F45-03FD-C043-B19E-11A49678442A}" type="presParOf" srcId="{EA19026D-C0E9-45E3-A915-A80C3D7913FE}" destId="{ABD03198-5AE2-48C0-9398-1BD6BBCB5F91}" srcOrd="1" destOrd="0" presId="urn:microsoft.com/office/officeart/2008/layout/HorizontalMultiLevelHierarchy"/>
    <dgm:cxn modelId="{49B9E86B-004A-234C-8F8F-6DCC04B70CEA}" type="presParOf" srcId="{ABD03198-5AE2-48C0-9398-1BD6BBCB5F91}" destId="{034CFA1F-7B89-45F2-B399-AD34489603B2}" srcOrd="0" destOrd="0" presId="urn:microsoft.com/office/officeart/2008/layout/HorizontalMultiLevelHierarchy"/>
    <dgm:cxn modelId="{9ECBECD8-CD62-2644-B6C7-7126AAB385E8}" type="presParOf" srcId="{ABD03198-5AE2-48C0-9398-1BD6BBCB5F91}" destId="{FAD9C84A-4DDD-4965-8A9B-D38BF2A2E54F}" srcOrd="1" destOrd="0" presId="urn:microsoft.com/office/officeart/2008/layout/HorizontalMultiLevelHierarchy"/>
    <dgm:cxn modelId="{AA81B573-7F61-4444-BA27-66C7A914FE6A}" type="presParOf" srcId="{72E62747-30D6-4D1D-BB89-7F1C84ED7D04}" destId="{FFB10C08-8AB4-475C-A934-5DA1E07ACD7C}" srcOrd="2" destOrd="0" presId="urn:microsoft.com/office/officeart/2008/layout/HorizontalMultiLevelHierarchy"/>
    <dgm:cxn modelId="{BFA968B1-1F03-5C4C-9979-5DC9E8D690C7}" type="presParOf" srcId="{FFB10C08-8AB4-475C-A934-5DA1E07ACD7C}" destId="{D6B8B294-83DE-452C-825B-2D17F4DEC758}" srcOrd="0" destOrd="0" presId="urn:microsoft.com/office/officeart/2008/layout/HorizontalMultiLevelHierarchy"/>
    <dgm:cxn modelId="{EE966AC8-1FA2-A846-A717-D00C55094836}" type="presParOf" srcId="{72E62747-30D6-4D1D-BB89-7F1C84ED7D04}" destId="{4D9D6197-5B45-4EFC-A55B-31EBB68AF734}" srcOrd="3" destOrd="0" presId="urn:microsoft.com/office/officeart/2008/layout/HorizontalMultiLevelHierarchy"/>
    <dgm:cxn modelId="{6BCEB538-246D-F346-8568-D6B5169E211A}" type="presParOf" srcId="{4D9D6197-5B45-4EFC-A55B-31EBB68AF734}" destId="{833AEC7A-B99D-48C0-871D-A4179B8964EB}" srcOrd="0" destOrd="0" presId="urn:microsoft.com/office/officeart/2008/layout/HorizontalMultiLevelHierarchy"/>
    <dgm:cxn modelId="{99F57696-AEBC-6E44-8BB2-7720307621AD}" type="presParOf" srcId="{4D9D6197-5B45-4EFC-A55B-31EBB68AF734}" destId="{89BF7422-43E5-4A9C-A905-CB23037EBDA7}" srcOrd="1" destOrd="0" presId="urn:microsoft.com/office/officeart/2008/layout/HorizontalMultiLevelHierarchy"/>
    <dgm:cxn modelId="{4B9A8A71-BB3C-2941-8347-03A3F4FF3A16}" type="presParOf" srcId="{89BF7422-43E5-4A9C-A905-CB23037EBDA7}" destId="{145B8CA3-BB26-4DB4-AC81-AFBE26AF21EB}" srcOrd="0" destOrd="0" presId="urn:microsoft.com/office/officeart/2008/layout/HorizontalMultiLevelHierarchy"/>
    <dgm:cxn modelId="{902ADFD2-9DFE-B443-82B5-CDA4E4BDF342}" type="presParOf" srcId="{145B8CA3-BB26-4DB4-AC81-AFBE26AF21EB}" destId="{FB2D46A2-1817-4DCE-B72E-E6F9B2BAE590}" srcOrd="0" destOrd="0" presId="urn:microsoft.com/office/officeart/2008/layout/HorizontalMultiLevelHierarchy"/>
    <dgm:cxn modelId="{7F7C602C-9D12-0647-B52F-CC2F14DDF482}" type="presParOf" srcId="{89BF7422-43E5-4A9C-A905-CB23037EBDA7}" destId="{0D133FD9-9FB5-4731-AAA7-5998ADA5A215}" srcOrd="1" destOrd="0" presId="urn:microsoft.com/office/officeart/2008/layout/HorizontalMultiLevelHierarchy"/>
    <dgm:cxn modelId="{02CB3DC5-6E61-9E42-8F62-D85521CCBE1A}" type="presParOf" srcId="{0D133FD9-9FB5-4731-AAA7-5998ADA5A215}" destId="{2CBD4155-2ED1-46FA-83BC-97CAA04F9980}" srcOrd="0" destOrd="0" presId="urn:microsoft.com/office/officeart/2008/layout/HorizontalMultiLevelHierarchy"/>
    <dgm:cxn modelId="{3DCEA077-E54C-454C-B6F8-460347EAE936}" type="presParOf" srcId="{0D133FD9-9FB5-4731-AAA7-5998ADA5A215}" destId="{46160B20-8915-4EF2-87A0-097E2222A302}" srcOrd="1" destOrd="0" presId="urn:microsoft.com/office/officeart/2008/layout/HorizontalMultiLevelHierarchy"/>
    <dgm:cxn modelId="{587DFB38-69CB-3E49-B131-DFF21767927E}" type="presParOf" srcId="{89BF7422-43E5-4A9C-A905-CB23037EBDA7}" destId="{A4E749FA-28E1-4471-ACD8-81F784E93244}" srcOrd="2" destOrd="0" presId="urn:microsoft.com/office/officeart/2008/layout/HorizontalMultiLevelHierarchy"/>
    <dgm:cxn modelId="{0CCCE8A6-69C9-0543-9271-8232BE9FE85B}" type="presParOf" srcId="{A4E749FA-28E1-4471-ACD8-81F784E93244}" destId="{1A97882B-88EC-4ACB-9DC7-C524B4434DD2}" srcOrd="0" destOrd="0" presId="urn:microsoft.com/office/officeart/2008/layout/HorizontalMultiLevelHierarchy"/>
    <dgm:cxn modelId="{8ECCED17-6BAF-B64D-8060-1AF82DC25D48}" type="presParOf" srcId="{89BF7422-43E5-4A9C-A905-CB23037EBDA7}" destId="{83F0C548-B70F-4C1A-8A80-4CA15A5E11B7}" srcOrd="3" destOrd="0" presId="urn:microsoft.com/office/officeart/2008/layout/HorizontalMultiLevelHierarchy"/>
    <dgm:cxn modelId="{99376B66-4AEF-5547-A91C-6D9275B418D3}" type="presParOf" srcId="{83F0C548-B70F-4C1A-8A80-4CA15A5E11B7}" destId="{32191076-4C62-4EFB-974A-465CDC7D6560}" srcOrd="0" destOrd="0" presId="urn:microsoft.com/office/officeart/2008/layout/HorizontalMultiLevelHierarchy"/>
    <dgm:cxn modelId="{C9043345-DBE0-C048-BB33-F63B7DFD3683}" type="presParOf" srcId="{83F0C548-B70F-4C1A-8A80-4CA15A5E11B7}" destId="{24B49978-767C-4836-91E7-8A773EAEB142}" srcOrd="1" destOrd="0" presId="urn:microsoft.com/office/officeart/2008/layout/HorizontalMultiLevelHierarchy"/>
    <dgm:cxn modelId="{6BB40DEE-57B7-BA4F-8AD9-2EC1C55F9795}" type="presParOf" srcId="{89BF7422-43E5-4A9C-A905-CB23037EBDA7}" destId="{59EFD662-F5B9-4E51-96F1-5AF65A05E852}" srcOrd="4" destOrd="0" presId="urn:microsoft.com/office/officeart/2008/layout/HorizontalMultiLevelHierarchy"/>
    <dgm:cxn modelId="{F2071271-238C-794F-A187-2BEB02305599}" type="presParOf" srcId="{59EFD662-F5B9-4E51-96F1-5AF65A05E852}" destId="{57EACCEA-F453-4574-9F35-453FAAE65FAE}" srcOrd="0" destOrd="0" presId="urn:microsoft.com/office/officeart/2008/layout/HorizontalMultiLevelHierarchy"/>
    <dgm:cxn modelId="{4E691674-0A4D-5543-8970-5D84A73FC0BF}" type="presParOf" srcId="{89BF7422-43E5-4A9C-A905-CB23037EBDA7}" destId="{C5C4D434-5A0F-431C-8080-57B36CD346AE}" srcOrd="5" destOrd="0" presId="urn:microsoft.com/office/officeart/2008/layout/HorizontalMultiLevelHierarchy"/>
    <dgm:cxn modelId="{842B0C5D-DBD4-8247-9DBB-D3674F10127A}" type="presParOf" srcId="{C5C4D434-5A0F-431C-8080-57B36CD346AE}" destId="{F3622D4E-BCD1-4B03-B6CA-2B65BC37B6F2}" srcOrd="0" destOrd="0" presId="urn:microsoft.com/office/officeart/2008/layout/HorizontalMultiLevelHierarchy"/>
    <dgm:cxn modelId="{F37D90E3-EC17-7043-95DE-92E46C972CFB}" type="presParOf" srcId="{C5C4D434-5A0F-431C-8080-57B36CD346AE}" destId="{F1BB4D31-91E7-4BDA-B802-D657606724B6}" srcOrd="1" destOrd="0" presId="urn:microsoft.com/office/officeart/2008/layout/HorizontalMultiLevelHierarchy"/>
    <dgm:cxn modelId="{15845327-BCAF-BA4F-A756-BE44154EE698}" type="presParOf" srcId="{72E62747-30D6-4D1D-BB89-7F1C84ED7D04}" destId="{C8FC8D5D-30F7-471E-B8B8-5F224FEE8B53}" srcOrd="4" destOrd="0" presId="urn:microsoft.com/office/officeart/2008/layout/HorizontalMultiLevelHierarchy"/>
    <dgm:cxn modelId="{ED807CC4-42F5-F546-BAD6-63663E9D87AD}" type="presParOf" srcId="{C8FC8D5D-30F7-471E-B8B8-5F224FEE8B53}" destId="{5342639D-3AF5-4D66-A9BD-D9379B93D203}" srcOrd="0" destOrd="0" presId="urn:microsoft.com/office/officeart/2008/layout/HorizontalMultiLevelHierarchy"/>
    <dgm:cxn modelId="{68952CF7-74CB-F643-B3CB-C5D22C3B6A99}" type="presParOf" srcId="{72E62747-30D6-4D1D-BB89-7F1C84ED7D04}" destId="{1E8EBB80-319D-4E65-BF00-32ABDA32C187}" srcOrd="5" destOrd="0" presId="urn:microsoft.com/office/officeart/2008/layout/HorizontalMultiLevelHierarchy"/>
    <dgm:cxn modelId="{914E6B00-09D7-A84C-B4CB-6D3D1D0E99B8}" type="presParOf" srcId="{1E8EBB80-319D-4E65-BF00-32ABDA32C187}" destId="{1127B8D7-3CD0-4F1D-9C2C-F99E8698E420}" srcOrd="0" destOrd="0" presId="urn:microsoft.com/office/officeart/2008/layout/HorizontalMultiLevelHierarchy"/>
    <dgm:cxn modelId="{18B64B9E-DDD0-AE45-9B20-94019CE682EA}" type="presParOf" srcId="{1E8EBB80-319D-4E65-BF00-32ABDA32C187}" destId="{82C4B51F-C124-4830-802D-9567EFF4261B}" srcOrd="1" destOrd="0" presId="urn:microsoft.com/office/officeart/2008/layout/HorizontalMultiLevelHierarchy"/>
    <dgm:cxn modelId="{73A59E78-2A83-574E-84F4-4433773A39B1}" type="presParOf" srcId="{82C4B51F-C124-4830-802D-9567EFF4261B}" destId="{80816A0F-AC68-4311-884A-5F8A58F08D7A}" srcOrd="0" destOrd="0" presId="urn:microsoft.com/office/officeart/2008/layout/HorizontalMultiLevelHierarchy"/>
    <dgm:cxn modelId="{CC05B8D9-AD85-C649-A42A-057131218590}" type="presParOf" srcId="{80816A0F-AC68-4311-884A-5F8A58F08D7A}" destId="{9F40458A-8537-45BD-A0BA-E3C93C1910FD}" srcOrd="0" destOrd="0" presId="urn:microsoft.com/office/officeart/2008/layout/HorizontalMultiLevelHierarchy"/>
    <dgm:cxn modelId="{BA38C52E-97F9-5D44-B8CC-9C86FE63BE80}" type="presParOf" srcId="{82C4B51F-C124-4830-802D-9567EFF4261B}" destId="{41B9F395-6A34-4E93-BE57-D9FA94787FDB}" srcOrd="1" destOrd="0" presId="urn:microsoft.com/office/officeart/2008/layout/HorizontalMultiLevelHierarchy"/>
    <dgm:cxn modelId="{D7FC4E5F-8461-0742-AA8D-39F53D9D0B3E}" type="presParOf" srcId="{41B9F395-6A34-4E93-BE57-D9FA94787FDB}" destId="{C3950836-6B16-410D-AB8D-A64C6FAB238C}" srcOrd="0" destOrd="0" presId="urn:microsoft.com/office/officeart/2008/layout/HorizontalMultiLevelHierarchy"/>
    <dgm:cxn modelId="{BD00ABDE-FAB4-604C-BC22-235814950CE6}" type="presParOf" srcId="{41B9F395-6A34-4E93-BE57-D9FA94787FDB}" destId="{CC44E0EF-F249-43A4-88BF-09221F711D61}" srcOrd="1" destOrd="0" presId="urn:microsoft.com/office/officeart/2008/layout/HorizontalMultiLevelHierarchy"/>
    <dgm:cxn modelId="{6E1F91E0-8E49-7C48-9AC0-4A733B03212C}" type="presParOf" srcId="{82C4B51F-C124-4830-802D-9567EFF4261B}" destId="{641C7868-5C94-4B0C-AE68-14A543E74986}" srcOrd="2" destOrd="0" presId="urn:microsoft.com/office/officeart/2008/layout/HorizontalMultiLevelHierarchy"/>
    <dgm:cxn modelId="{44AC0A03-A3EE-F340-AFE2-8060747E27F8}" type="presParOf" srcId="{641C7868-5C94-4B0C-AE68-14A543E74986}" destId="{E2616EF7-4194-4236-85F9-832BC8793282}" srcOrd="0" destOrd="0" presId="urn:microsoft.com/office/officeart/2008/layout/HorizontalMultiLevelHierarchy"/>
    <dgm:cxn modelId="{594C6BC0-5695-6F48-A1D1-C7B567F1320F}" type="presParOf" srcId="{82C4B51F-C124-4830-802D-9567EFF4261B}" destId="{C123B81C-35F4-4152-8BBF-E13B02C20AE1}" srcOrd="3" destOrd="0" presId="urn:microsoft.com/office/officeart/2008/layout/HorizontalMultiLevelHierarchy"/>
    <dgm:cxn modelId="{174EEA3A-F2A9-EC4C-A8B2-4432D0E6346B}" type="presParOf" srcId="{C123B81C-35F4-4152-8BBF-E13B02C20AE1}" destId="{1933C373-9436-497B-AC32-4A55FA51135A}" srcOrd="0" destOrd="0" presId="urn:microsoft.com/office/officeart/2008/layout/HorizontalMultiLevelHierarchy"/>
    <dgm:cxn modelId="{AFA08451-6D23-7442-9D39-D6BD2DCBD06C}" type="presParOf" srcId="{C123B81C-35F4-4152-8BBF-E13B02C20AE1}" destId="{D3A7C383-13FD-45DD-8991-5911F2B4C3F6}" srcOrd="1" destOrd="0" presId="urn:microsoft.com/office/officeart/2008/layout/HorizontalMultiLevelHierarchy"/>
    <dgm:cxn modelId="{9222BC17-0566-E84D-9B62-834CAF8013AD}" type="presParOf" srcId="{82C4B51F-C124-4830-802D-9567EFF4261B}" destId="{0690BAF6-2E3E-48F7-B419-76D80DEF1285}" srcOrd="4" destOrd="0" presId="urn:microsoft.com/office/officeart/2008/layout/HorizontalMultiLevelHierarchy"/>
    <dgm:cxn modelId="{324DF109-29E7-7C40-9A01-4133DD4A353C}" type="presParOf" srcId="{0690BAF6-2E3E-48F7-B419-76D80DEF1285}" destId="{644B0916-88CC-4E2D-8F8B-61CB7AB19F11}" srcOrd="0" destOrd="0" presId="urn:microsoft.com/office/officeart/2008/layout/HorizontalMultiLevelHierarchy"/>
    <dgm:cxn modelId="{9B294737-AA2D-CF41-8E96-73B33D24ECED}" type="presParOf" srcId="{82C4B51F-C124-4830-802D-9567EFF4261B}" destId="{68694253-D1E0-407A-B177-0918469B193A}" srcOrd="5" destOrd="0" presId="urn:microsoft.com/office/officeart/2008/layout/HorizontalMultiLevelHierarchy"/>
    <dgm:cxn modelId="{C7B5DE19-4F80-EB41-83D8-E7397A8BD80F}" type="presParOf" srcId="{68694253-D1E0-407A-B177-0918469B193A}" destId="{4BB45888-D1DE-4D55-A070-864FDC435C39}" srcOrd="0" destOrd="0" presId="urn:microsoft.com/office/officeart/2008/layout/HorizontalMultiLevelHierarchy"/>
    <dgm:cxn modelId="{4BE168FA-465B-D249-AAE3-79444557BA53}" type="presParOf" srcId="{68694253-D1E0-407A-B177-0918469B193A}" destId="{3689A1F5-2C46-45BB-83EF-65EF9225403F}" srcOrd="1" destOrd="0" presId="urn:microsoft.com/office/officeart/2008/layout/HorizontalMultiLevelHierarchy"/>
    <dgm:cxn modelId="{2B2629CC-F179-894D-BCAE-943B3F5B1A29}" type="presParOf" srcId="{72E62747-30D6-4D1D-BB89-7F1C84ED7D04}" destId="{50582FA0-BBE9-41F5-B774-DF272A2E7640}" srcOrd="6" destOrd="0" presId="urn:microsoft.com/office/officeart/2008/layout/HorizontalMultiLevelHierarchy"/>
    <dgm:cxn modelId="{6C04DF12-075E-5543-92AD-42A8BB92924C}" type="presParOf" srcId="{50582FA0-BBE9-41F5-B774-DF272A2E7640}" destId="{9A9420DC-F1B7-4C0C-8BF0-C2E0C4CBC93F}" srcOrd="0" destOrd="0" presId="urn:microsoft.com/office/officeart/2008/layout/HorizontalMultiLevelHierarchy"/>
    <dgm:cxn modelId="{0FC12866-6030-5F48-BC33-AF2E45235B04}" type="presParOf" srcId="{72E62747-30D6-4D1D-BB89-7F1C84ED7D04}" destId="{AABEFBD3-3754-4F01-A1BF-46CB69D73338}" srcOrd="7" destOrd="0" presId="urn:microsoft.com/office/officeart/2008/layout/HorizontalMultiLevelHierarchy"/>
    <dgm:cxn modelId="{EE14FD1D-1BEA-BF4B-B700-561EE2F09B9B}" type="presParOf" srcId="{AABEFBD3-3754-4F01-A1BF-46CB69D73338}" destId="{5388DEAC-EED5-488A-BF01-C492E1548169}" srcOrd="0" destOrd="0" presId="urn:microsoft.com/office/officeart/2008/layout/HorizontalMultiLevelHierarchy"/>
    <dgm:cxn modelId="{2DA381D8-CE69-364C-AFB8-298E1EF9AC07}" type="presParOf" srcId="{AABEFBD3-3754-4F01-A1BF-46CB69D73338}" destId="{BA78D691-3734-4953-AAF8-5F3F17A404FF}" srcOrd="1" destOrd="0" presId="urn:microsoft.com/office/officeart/2008/layout/HorizontalMultiLevelHierarchy"/>
    <dgm:cxn modelId="{AE6E2BEF-BC28-7F42-919D-9026040AC74A}" type="presParOf" srcId="{BA78D691-3734-4953-AAF8-5F3F17A404FF}" destId="{85680CD6-D861-4B8C-B4BB-D395BF852CF2}" srcOrd="0" destOrd="0" presId="urn:microsoft.com/office/officeart/2008/layout/HorizontalMultiLevelHierarchy"/>
    <dgm:cxn modelId="{56186CA9-AF50-C347-9FEF-5D81900F0431}" type="presParOf" srcId="{85680CD6-D861-4B8C-B4BB-D395BF852CF2}" destId="{BC6A27C1-C76C-49EA-979A-2A521D1FCCEF}" srcOrd="0" destOrd="0" presId="urn:microsoft.com/office/officeart/2008/layout/HorizontalMultiLevelHierarchy"/>
    <dgm:cxn modelId="{EE75745B-1502-5447-8102-65ACC04F9F75}" type="presParOf" srcId="{BA78D691-3734-4953-AAF8-5F3F17A404FF}" destId="{CC37B35B-BD55-4306-8506-765DE81C5E17}" srcOrd="1" destOrd="0" presId="urn:microsoft.com/office/officeart/2008/layout/HorizontalMultiLevelHierarchy"/>
    <dgm:cxn modelId="{5E1A127A-ECD3-E043-AAF2-2EC9AD57D234}" type="presParOf" srcId="{CC37B35B-BD55-4306-8506-765DE81C5E17}" destId="{C1DDE8C2-4167-4CB5-9227-79BD5883663D}" srcOrd="0" destOrd="0" presId="urn:microsoft.com/office/officeart/2008/layout/HorizontalMultiLevelHierarchy"/>
    <dgm:cxn modelId="{82EA732B-696C-0C41-A03C-D5484BFBC151}" type="presParOf" srcId="{CC37B35B-BD55-4306-8506-765DE81C5E17}" destId="{162417E9-3DE1-4B42-91DD-63E08D47F6E5}" srcOrd="1" destOrd="0" presId="urn:microsoft.com/office/officeart/2008/layout/HorizontalMultiLevelHierarchy"/>
    <dgm:cxn modelId="{08AF483D-9856-3448-9E59-7E6CD4E7797E}" type="presParOf" srcId="{BA78D691-3734-4953-AAF8-5F3F17A404FF}" destId="{D8521D54-7213-4694-BBC0-4F888AA592CD}" srcOrd="2" destOrd="0" presId="urn:microsoft.com/office/officeart/2008/layout/HorizontalMultiLevelHierarchy"/>
    <dgm:cxn modelId="{ECA67E05-3F5A-AA4D-8031-613AE922C64C}" type="presParOf" srcId="{D8521D54-7213-4694-BBC0-4F888AA592CD}" destId="{12E003C6-4AFF-4D58-B542-ECD9CE0A59CB}" srcOrd="0" destOrd="0" presId="urn:microsoft.com/office/officeart/2008/layout/HorizontalMultiLevelHierarchy"/>
    <dgm:cxn modelId="{95F3A3CB-8AC7-B445-A92E-BA7B5FDFE362}" type="presParOf" srcId="{BA78D691-3734-4953-AAF8-5F3F17A404FF}" destId="{DC900C20-41B6-4088-B8D1-CC6AD8650876}" srcOrd="3" destOrd="0" presId="urn:microsoft.com/office/officeart/2008/layout/HorizontalMultiLevelHierarchy"/>
    <dgm:cxn modelId="{12CADE00-520F-F242-8C57-6DE8490FB86B}" type="presParOf" srcId="{DC900C20-41B6-4088-B8D1-CC6AD8650876}" destId="{9A8BBF3E-80F7-4CDC-8949-9486CC82C37E}" srcOrd="0" destOrd="0" presId="urn:microsoft.com/office/officeart/2008/layout/HorizontalMultiLevelHierarchy"/>
    <dgm:cxn modelId="{E4444B68-87E3-AE46-B5BC-88E19BDA74A9}" type="presParOf" srcId="{DC900C20-41B6-4088-B8D1-CC6AD8650876}" destId="{764B40F7-0EE1-4AB5-9EFB-EBF4DBFF85F9}" srcOrd="1" destOrd="0" presId="urn:microsoft.com/office/officeart/2008/layout/HorizontalMultiLevelHierarchy"/>
    <dgm:cxn modelId="{EC1DBE2E-B8D0-3944-9FE2-EE2253D6249D}" type="presParOf" srcId="{BA78D691-3734-4953-AAF8-5F3F17A404FF}" destId="{F33BF1B9-AED9-42A3-BD05-2C4D658A0E82}" srcOrd="4" destOrd="0" presId="urn:microsoft.com/office/officeart/2008/layout/HorizontalMultiLevelHierarchy"/>
    <dgm:cxn modelId="{C9B1BC3D-F17D-D44B-890E-D5D7AAD59800}" type="presParOf" srcId="{F33BF1B9-AED9-42A3-BD05-2C4D658A0E82}" destId="{4CFC7A54-D56C-4532-BDF0-561B996C1A7B}" srcOrd="0" destOrd="0" presId="urn:microsoft.com/office/officeart/2008/layout/HorizontalMultiLevelHierarchy"/>
    <dgm:cxn modelId="{DAA62C98-C424-CD4C-A7EF-B9FDCECB0787}" type="presParOf" srcId="{BA78D691-3734-4953-AAF8-5F3F17A404FF}" destId="{76AFCB5B-F3DE-41B1-AD17-6323C40DFC6B}" srcOrd="5" destOrd="0" presId="urn:microsoft.com/office/officeart/2008/layout/HorizontalMultiLevelHierarchy"/>
    <dgm:cxn modelId="{B4C9AEAF-1A78-C84E-BAEB-58E15B6F0DD7}" type="presParOf" srcId="{76AFCB5B-F3DE-41B1-AD17-6323C40DFC6B}" destId="{597BC5DD-74CC-47C5-AD40-3A868FED9E4F}" srcOrd="0" destOrd="0" presId="urn:microsoft.com/office/officeart/2008/layout/HorizontalMultiLevelHierarchy"/>
    <dgm:cxn modelId="{3924F3DB-84DA-2F42-8C2C-3624420B1E92}" type="presParOf" srcId="{76AFCB5B-F3DE-41B1-AD17-6323C40DFC6B}" destId="{65790AFD-0455-43D4-8705-9562D4BB16FA}" srcOrd="1" destOrd="0" presId="urn:microsoft.com/office/officeart/2008/layout/HorizontalMultiLevelHierarchy"/>
    <dgm:cxn modelId="{0FAE946C-3489-F64C-A90B-03AAF60183AE}" type="presParOf" srcId="{BA78D691-3734-4953-AAF8-5F3F17A404FF}" destId="{EC21EC01-6866-4C21-816F-7D5367748A93}" srcOrd="6" destOrd="0" presId="urn:microsoft.com/office/officeart/2008/layout/HorizontalMultiLevelHierarchy"/>
    <dgm:cxn modelId="{402E0CBE-4E66-C443-BC74-844D919362B6}" type="presParOf" srcId="{EC21EC01-6866-4C21-816F-7D5367748A93}" destId="{E6261245-03D0-4B1C-AF98-52998D9808BB}" srcOrd="0" destOrd="0" presId="urn:microsoft.com/office/officeart/2008/layout/HorizontalMultiLevelHierarchy"/>
    <dgm:cxn modelId="{59D5DE9F-1793-204E-9564-5BB08CBF9D65}" type="presParOf" srcId="{BA78D691-3734-4953-AAF8-5F3F17A404FF}" destId="{C92D9193-E447-41C0-953C-7061B22064FF}" srcOrd="7" destOrd="0" presId="urn:microsoft.com/office/officeart/2008/layout/HorizontalMultiLevelHierarchy"/>
    <dgm:cxn modelId="{EA9172D3-5694-9245-8101-5A81AF85549A}" type="presParOf" srcId="{C92D9193-E447-41C0-953C-7061B22064FF}" destId="{D95317B9-76BE-4111-8A76-04456BE5B4E4}" srcOrd="0" destOrd="0" presId="urn:microsoft.com/office/officeart/2008/layout/HorizontalMultiLevelHierarchy"/>
    <dgm:cxn modelId="{437C5729-A0BA-694C-9398-41671B78B1A0}" type="presParOf" srcId="{C92D9193-E447-41C0-953C-7061B22064FF}" destId="{923D969F-C806-4309-8ACC-CA58FDDC5F77}" srcOrd="1" destOrd="0" presId="urn:microsoft.com/office/officeart/2008/layout/HorizontalMultiLevelHierarchy"/>
    <dgm:cxn modelId="{0D049E0C-BAAA-F145-8ADB-7A37F54DA0B2}" type="presParOf" srcId="{BA78D691-3734-4953-AAF8-5F3F17A404FF}" destId="{E68CF398-FB37-46D5-AE40-35211BBBB345}" srcOrd="8" destOrd="0" presId="urn:microsoft.com/office/officeart/2008/layout/HorizontalMultiLevelHierarchy"/>
    <dgm:cxn modelId="{E940CEED-8B33-F042-B2D5-267D093822AA}" type="presParOf" srcId="{E68CF398-FB37-46D5-AE40-35211BBBB345}" destId="{9DB92DDD-27F6-4497-9884-A177005DC173}" srcOrd="0" destOrd="0" presId="urn:microsoft.com/office/officeart/2008/layout/HorizontalMultiLevelHierarchy"/>
    <dgm:cxn modelId="{5A45E589-95AF-6D43-AA0D-57B6BAE1B3F9}" type="presParOf" srcId="{BA78D691-3734-4953-AAF8-5F3F17A404FF}" destId="{C250F5E4-B080-4565-B1E2-BEF4540A6EC8}" srcOrd="9" destOrd="0" presId="urn:microsoft.com/office/officeart/2008/layout/HorizontalMultiLevelHierarchy"/>
    <dgm:cxn modelId="{3134682B-4D01-724E-A547-AD65EF9B785D}" type="presParOf" srcId="{C250F5E4-B080-4565-B1E2-BEF4540A6EC8}" destId="{D2BED35C-0932-451D-A00D-15E358B75803}" srcOrd="0" destOrd="0" presId="urn:microsoft.com/office/officeart/2008/layout/HorizontalMultiLevelHierarchy"/>
    <dgm:cxn modelId="{5C266F96-64BA-EE46-812D-CD83ADF1EDEE}" type="presParOf" srcId="{C250F5E4-B080-4565-B1E2-BEF4540A6EC8}" destId="{B1CE47C3-124A-44CE-AE01-A2EB8BF68428}" srcOrd="1" destOrd="0" presId="urn:microsoft.com/office/officeart/2008/layout/HorizontalMultiLevelHierarchy"/>
    <dgm:cxn modelId="{564B4300-042D-FC46-999D-2E94C2867129}" type="presParOf" srcId="{72E62747-30D6-4D1D-BB89-7F1C84ED7D04}" destId="{EDB39F50-E6A5-4BE9-B9EE-7CBD1C48E142}" srcOrd="8" destOrd="0" presId="urn:microsoft.com/office/officeart/2008/layout/HorizontalMultiLevelHierarchy"/>
    <dgm:cxn modelId="{7A73D2C9-9BDC-274C-83D2-B014809CF986}" type="presParOf" srcId="{EDB39F50-E6A5-4BE9-B9EE-7CBD1C48E142}" destId="{65F74B9C-4346-41F3-B001-FCEFA52E5536}" srcOrd="0" destOrd="0" presId="urn:microsoft.com/office/officeart/2008/layout/HorizontalMultiLevelHierarchy"/>
    <dgm:cxn modelId="{7AF15F4F-E6F9-374E-B3D6-386FB2093AE3}" type="presParOf" srcId="{72E62747-30D6-4D1D-BB89-7F1C84ED7D04}" destId="{A60DB8F9-6EF7-497F-B504-A3903AE671B1}" srcOrd="9" destOrd="0" presId="urn:microsoft.com/office/officeart/2008/layout/HorizontalMultiLevelHierarchy"/>
    <dgm:cxn modelId="{136E26BD-BFEC-134E-AD96-475069E70AF1}" type="presParOf" srcId="{A60DB8F9-6EF7-497F-B504-A3903AE671B1}" destId="{21F2160D-B234-45C3-831F-32DA92F9E092}" srcOrd="0" destOrd="0" presId="urn:microsoft.com/office/officeart/2008/layout/HorizontalMultiLevelHierarchy"/>
    <dgm:cxn modelId="{A0E856F0-A11F-BA48-AFF7-9FB40DC5654D}" type="presParOf" srcId="{A60DB8F9-6EF7-497F-B504-A3903AE671B1}" destId="{BB2206FB-670A-4D16-8ACF-B793FDFD8F30}" srcOrd="1" destOrd="0" presId="urn:microsoft.com/office/officeart/2008/layout/HorizontalMultiLevelHierarchy"/>
    <dgm:cxn modelId="{0AB5B27E-4DA6-AF40-AEF6-574E7A051707}" type="presParOf" srcId="{BB2206FB-670A-4D16-8ACF-B793FDFD8F30}" destId="{E963BCA4-358F-4E84-A754-9B3BA2A663D7}" srcOrd="0" destOrd="0" presId="urn:microsoft.com/office/officeart/2008/layout/HorizontalMultiLevelHierarchy"/>
    <dgm:cxn modelId="{35729D8D-49E6-E641-BC7D-F80210604DDC}" type="presParOf" srcId="{E963BCA4-358F-4E84-A754-9B3BA2A663D7}" destId="{B761E77C-728A-4EC0-A339-32A91B1D0DA7}" srcOrd="0" destOrd="0" presId="urn:microsoft.com/office/officeart/2008/layout/HorizontalMultiLevelHierarchy"/>
    <dgm:cxn modelId="{5CCFC0D4-F94F-1041-9C3D-99D5C924EC91}" type="presParOf" srcId="{BB2206FB-670A-4D16-8ACF-B793FDFD8F30}" destId="{83451D17-F717-4767-9525-2BC49CA719EE}" srcOrd="1" destOrd="0" presId="urn:microsoft.com/office/officeart/2008/layout/HorizontalMultiLevelHierarchy"/>
    <dgm:cxn modelId="{65EE2E63-C8FB-A348-AB46-1DB77A2C2758}" type="presParOf" srcId="{83451D17-F717-4767-9525-2BC49CA719EE}" destId="{AEC6F2D4-95D5-48AD-82E9-6283D5B7C839}" srcOrd="0" destOrd="0" presId="urn:microsoft.com/office/officeart/2008/layout/HorizontalMultiLevelHierarchy"/>
    <dgm:cxn modelId="{FEC218AB-221B-EA4B-813B-75BD905F4A77}" type="presParOf" srcId="{83451D17-F717-4767-9525-2BC49CA719EE}" destId="{F4D2FF32-6AD0-40FA-8337-382547582211}" srcOrd="1" destOrd="0" presId="urn:microsoft.com/office/officeart/2008/layout/HorizontalMultiLevelHierarchy"/>
    <dgm:cxn modelId="{25610EAC-5A74-3944-A37D-2B3AB91D8DF8}" type="presParOf" srcId="{BB2206FB-670A-4D16-8ACF-B793FDFD8F30}" destId="{0B1934E3-BED7-41C6-8334-56CDE0C18457}" srcOrd="2" destOrd="0" presId="urn:microsoft.com/office/officeart/2008/layout/HorizontalMultiLevelHierarchy"/>
    <dgm:cxn modelId="{FCE30D30-7377-CB49-8281-5C18FB1044F0}" type="presParOf" srcId="{0B1934E3-BED7-41C6-8334-56CDE0C18457}" destId="{BF296AFE-DE93-43D0-880D-C426CF8D691B}" srcOrd="0" destOrd="0" presId="urn:microsoft.com/office/officeart/2008/layout/HorizontalMultiLevelHierarchy"/>
    <dgm:cxn modelId="{5AC1D932-054D-4547-B409-D5A93A38B22B}" type="presParOf" srcId="{BB2206FB-670A-4D16-8ACF-B793FDFD8F30}" destId="{255222B5-2B81-40BD-886F-B2A617096CED}" srcOrd="3" destOrd="0" presId="urn:microsoft.com/office/officeart/2008/layout/HorizontalMultiLevelHierarchy"/>
    <dgm:cxn modelId="{D6179FD7-6225-8D49-834B-5F1ACC6BA116}" type="presParOf" srcId="{255222B5-2B81-40BD-886F-B2A617096CED}" destId="{0ED870BF-DE06-43B1-B8FD-733691756967}" srcOrd="0" destOrd="0" presId="urn:microsoft.com/office/officeart/2008/layout/HorizontalMultiLevelHierarchy"/>
    <dgm:cxn modelId="{16112DC3-D268-3B44-91FA-1C01B7857B7D}" type="presParOf" srcId="{255222B5-2B81-40BD-886F-B2A617096CED}" destId="{7282136F-CB13-49A8-B751-63F79A8A2202}" srcOrd="1" destOrd="0" presId="urn:microsoft.com/office/officeart/2008/layout/HorizontalMultiLevelHierarchy"/>
    <dgm:cxn modelId="{C49EC8B4-C12B-3D47-A92C-468F87F05DA1}" type="presParOf" srcId="{72E62747-30D6-4D1D-BB89-7F1C84ED7D04}" destId="{1CE5CB39-D3E9-4A7B-9C67-A233A6D7A627}" srcOrd="10" destOrd="0" presId="urn:microsoft.com/office/officeart/2008/layout/HorizontalMultiLevelHierarchy"/>
    <dgm:cxn modelId="{8EE7C4EB-6BC4-1949-B7B4-D0205AACB563}" type="presParOf" srcId="{1CE5CB39-D3E9-4A7B-9C67-A233A6D7A627}" destId="{F5E475E5-8A42-4579-B194-FAF922E7809E}" srcOrd="0" destOrd="0" presId="urn:microsoft.com/office/officeart/2008/layout/HorizontalMultiLevelHierarchy"/>
    <dgm:cxn modelId="{EF24F2DC-1C54-A944-90A4-BD1B05F01BF0}" type="presParOf" srcId="{72E62747-30D6-4D1D-BB89-7F1C84ED7D04}" destId="{763EAE49-7C61-4605-A145-5FBC1B89EEA3}" srcOrd="11" destOrd="0" presId="urn:microsoft.com/office/officeart/2008/layout/HorizontalMultiLevelHierarchy"/>
    <dgm:cxn modelId="{76018908-C21C-784D-9597-7ADADA46E0D7}" type="presParOf" srcId="{763EAE49-7C61-4605-A145-5FBC1B89EEA3}" destId="{B3C580F2-FB1F-46D6-A574-03FF7B6D6BE1}" srcOrd="0" destOrd="0" presId="urn:microsoft.com/office/officeart/2008/layout/HorizontalMultiLevelHierarchy"/>
    <dgm:cxn modelId="{E47F1CC8-7270-ED4A-A006-31357B5B8096}" type="presParOf" srcId="{763EAE49-7C61-4605-A145-5FBC1B89EEA3}" destId="{C1BEBA0A-CC87-4654-8400-27B248D42296}" srcOrd="1" destOrd="0" presId="urn:microsoft.com/office/officeart/2008/layout/HorizontalMultiLevelHierarchy"/>
    <dgm:cxn modelId="{4614F793-A2D7-7D4E-99A2-BCBDF306CFE6}" type="presParOf" srcId="{C1BEBA0A-CC87-4654-8400-27B248D42296}" destId="{960E4D89-EE87-4C6C-A706-B7013A8D6463}" srcOrd="0" destOrd="0" presId="urn:microsoft.com/office/officeart/2008/layout/HorizontalMultiLevelHierarchy"/>
    <dgm:cxn modelId="{9455BA67-37B0-164B-8F11-AF701A0766B4}" type="presParOf" srcId="{960E4D89-EE87-4C6C-A706-B7013A8D6463}" destId="{F6EBD4E4-F1B7-411F-B620-3CCDA123E074}" srcOrd="0" destOrd="0" presId="urn:microsoft.com/office/officeart/2008/layout/HorizontalMultiLevelHierarchy"/>
    <dgm:cxn modelId="{CC5BE0A3-32C3-0145-8320-6F524D14177D}" type="presParOf" srcId="{C1BEBA0A-CC87-4654-8400-27B248D42296}" destId="{CD587DE8-D871-4BCB-9F6C-0DE8AFDD2E56}" srcOrd="1" destOrd="0" presId="urn:microsoft.com/office/officeart/2008/layout/HorizontalMultiLevelHierarchy"/>
    <dgm:cxn modelId="{4DA55902-0E21-2440-95DD-23E9A75ABC07}" type="presParOf" srcId="{CD587DE8-D871-4BCB-9F6C-0DE8AFDD2E56}" destId="{85DBA0F4-5A3C-4403-96FB-0B04850D1882}" srcOrd="0" destOrd="0" presId="urn:microsoft.com/office/officeart/2008/layout/HorizontalMultiLevelHierarchy"/>
    <dgm:cxn modelId="{1108154A-1395-6A4A-A951-769B9D6734C9}" type="presParOf" srcId="{CD587DE8-D871-4BCB-9F6C-0DE8AFDD2E56}" destId="{483EE9A9-C493-4CEC-BD2D-92DEE641C1D6}" srcOrd="1" destOrd="0" presId="urn:microsoft.com/office/officeart/2008/layout/HorizontalMultiLevelHierarchy"/>
    <dgm:cxn modelId="{EB320021-D117-4FE0-B6CA-7116247E0C12}" type="presParOf" srcId="{72E62747-30D6-4D1D-BB89-7F1C84ED7D04}" destId="{2FCF096E-BB8B-4040-A659-ADA3B7C0E269}" srcOrd="12" destOrd="0" presId="urn:microsoft.com/office/officeart/2008/layout/HorizontalMultiLevelHierarchy"/>
    <dgm:cxn modelId="{C951C746-25FA-4D99-9F85-62A657E11D87}" type="presParOf" srcId="{2FCF096E-BB8B-4040-A659-ADA3B7C0E269}" destId="{2258EE37-1D25-4656-A586-D82B3DE9DEE3}" srcOrd="0" destOrd="0" presId="urn:microsoft.com/office/officeart/2008/layout/HorizontalMultiLevelHierarchy"/>
    <dgm:cxn modelId="{94A3E467-2AA6-474F-8BEC-9100A4619B9C}" type="presParOf" srcId="{72E62747-30D6-4D1D-BB89-7F1C84ED7D04}" destId="{F8568201-E9E4-4241-84FC-66092235000D}" srcOrd="13" destOrd="0" presId="urn:microsoft.com/office/officeart/2008/layout/HorizontalMultiLevelHierarchy"/>
    <dgm:cxn modelId="{02C0F9A0-C355-4FA6-A655-B553E9BD26D1}" type="presParOf" srcId="{F8568201-E9E4-4241-84FC-66092235000D}" destId="{72636010-4576-474C-8CDC-44780E4BDC8F}" srcOrd="0" destOrd="0" presId="urn:microsoft.com/office/officeart/2008/layout/HorizontalMultiLevelHierarchy"/>
    <dgm:cxn modelId="{813A9FB8-18AD-4FFC-86B9-6C71F73442A5}" type="presParOf" srcId="{F8568201-E9E4-4241-84FC-66092235000D}" destId="{BEEF8E53-0025-4912-9C49-78ACDA0A8A00}" srcOrd="1" destOrd="0" presId="urn:microsoft.com/office/officeart/2008/layout/HorizontalMultiLevelHierarchy"/>
    <dgm:cxn modelId="{0DAA074E-17F8-47CE-BADC-7A623B6024B1}" type="presParOf" srcId="{BEEF8E53-0025-4912-9C49-78ACDA0A8A00}" destId="{E9416659-BBF5-4BD3-BE43-3B132573EE58}" srcOrd="0" destOrd="0" presId="urn:microsoft.com/office/officeart/2008/layout/HorizontalMultiLevelHierarchy"/>
    <dgm:cxn modelId="{6B391855-4F0B-475D-9C32-F14A1E54268C}" type="presParOf" srcId="{E9416659-BBF5-4BD3-BE43-3B132573EE58}" destId="{6E490DE4-E453-43A4-ACC8-9745E76655F8}" srcOrd="0" destOrd="0" presId="urn:microsoft.com/office/officeart/2008/layout/HorizontalMultiLevelHierarchy"/>
    <dgm:cxn modelId="{841F24E7-D0A4-49BC-909C-3DB44B6602F9}" type="presParOf" srcId="{BEEF8E53-0025-4912-9C49-78ACDA0A8A00}" destId="{E96CC648-9DC1-4423-A3C0-2C7D1D2A3F3B}" srcOrd="1" destOrd="0" presId="urn:microsoft.com/office/officeart/2008/layout/HorizontalMultiLevelHierarchy"/>
    <dgm:cxn modelId="{3A014CED-6749-432E-A5D8-8AEB2DA9FE24}" type="presParOf" srcId="{E96CC648-9DC1-4423-A3C0-2C7D1D2A3F3B}" destId="{ED81DF27-18D8-4CB1-B441-682B76EBC6C3}" srcOrd="0" destOrd="0" presId="urn:microsoft.com/office/officeart/2008/layout/HorizontalMultiLevelHierarchy"/>
    <dgm:cxn modelId="{DA697F70-C1EE-4665-B102-89760F2B1410}" type="presParOf" srcId="{E96CC648-9DC1-4423-A3C0-2C7D1D2A3F3B}" destId="{42C27B3A-1770-4990-9723-93C951B08088}" srcOrd="1" destOrd="0" presId="urn:microsoft.com/office/officeart/2008/layout/HorizontalMultiLevelHierarchy"/>
    <dgm:cxn modelId="{DD63DEF9-5127-7948-9441-43569F10F55B}" type="presParOf" srcId="{72E62747-30D6-4D1D-BB89-7F1C84ED7D04}" destId="{576E1488-9ED3-4594-83C4-9410252E7C78}" srcOrd="14" destOrd="0" presId="urn:microsoft.com/office/officeart/2008/layout/HorizontalMultiLevelHierarchy"/>
    <dgm:cxn modelId="{EB894442-8F55-364D-B8E1-2E6B1F4E6845}" type="presParOf" srcId="{576E1488-9ED3-4594-83C4-9410252E7C78}" destId="{3638F33C-3AFC-4822-AD4D-20D5F3841C21}" srcOrd="0" destOrd="0" presId="urn:microsoft.com/office/officeart/2008/layout/HorizontalMultiLevelHierarchy"/>
    <dgm:cxn modelId="{4259ED5B-38F5-CB49-AA01-E0057DC60AE8}" type="presParOf" srcId="{72E62747-30D6-4D1D-BB89-7F1C84ED7D04}" destId="{B5EB13AC-85C5-45A6-8002-140E68E0250C}" srcOrd="15" destOrd="0" presId="urn:microsoft.com/office/officeart/2008/layout/HorizontalMultiLevelHierarchy"/>
    <dgm:cxn modelId="{86F22063-ED15-1C4E-88E0-EB8143C24236}" type="presParOf" srcId="{B5EB13AC-85C5-45A6-8002-140E68E0250C}" destId="{41832CCF-0117-4FEC-B465-24629687F834}" srcOrd="0" destOrd="0" presId="urn:microsoft.com/office/officeart/2008/layout/HorizontalMultiLevelHierarchy"/>
    <dgm:cxn modelId="{67F13629-A15A-B449-81BF-E35D0D6C8AA8}" type="presParOf" srcId="{B5EB13AC-85C5-45A6-8002-140E68E0250C}" destId="{13F3CDB7-7F17-401D-B8F8-E2751E77BB8F}" srcOrd="1" destOrd="0" presId="urn:microsoft.com/office/officeart/2008/layout/HorizontalMultiLevelHierarchy"/>
    <dgm:cxn modelId="{7B21C4EB-F825-1145-80A4-CC34141ED3A7}" type="presParOf" srcId="{13F3CDB7-7F17-401D-B8F8-E2751E77BB8F}" destId="{F518CB70-8FC6-45C6-9986-0BCFA38267AE}" srcOrd="0" destOrd="0" presId="urn:microsoft.com/office/officeart/2008/layout/HorizontalMultiLevelHierarchy"/>
    <dgm:cxn modelId="{ADF2DF7D-3629-7D46-90F3-42C62525EBFF}" type="presParOf" srcId="{F518CB70-8FC6-45C6-9986-0BCFA38267AE}" destId="{1C9106B8-FEA9-4C06-B02A-4FC549A768D8}" srcOrd="0" destOrd="0" presId="urn:microsoft.com/office/officeart/2008/layout/HorizontalMultiLevelHierarchy"/>
    <dgm:cxn modelId="{93CB6F7E-3D5A-7048-B1D0-DF723BF91D51}" type="presParOf" srcId="{13F3CDB7-7F17-401D-B8F8-E2751E77BB8F}" destId="{F839E571-6132-40A8-A084-BC9BABC7B794}" srcOrd="1" destOrd="0" presId="urn:microsoft.com/office/officeart/2008/layout/HorizontalMultiLevelHierarchy"/>
    <dgm:cxn modelId="{D5F038C1-B717-1848-B3AE-1B7CCB46E2BA}" type="presParOf" srcId="{F839E571-6132-40A8-A084-BC9BABC7B794}" destId="{00C4BBE0-EBF3-4395-A6F4-1E6BC19228B5}" srcOrd="0" destOrd="0" presId="urn:microsoft.com/office/officeart/2008/layout/HorizontalMultiLevelHierarchy"/>
    <dgm:cxn modelId="{C3639D7B-AE20-5644-B356-FD8E31AD9890}" type="presParOf" srcId="{F839E571-6132-40A8-A084-BC9BABC7B794}" destId="{A4EC0461-9E2D-40DA-9A11-EC98094CA867}" srcOrd="1" destOrd="0" presId="urn:microsoft.com/office/officeart/2008/layout/HorizontalMultiLevelHierarchy"/>
    <dgm:cxn modelId="{B15939F0-BE61-CD41-9165-08271D5D4B9D}" type="presParOf" srcId="{72E62747-30D6-4D1D-BB89-7F1C84ED7D04}" destId="{6BCA1F02-8423-418F-9214-DC6DF4276FFE}" srcOrd="16" destOrd="0" presId="urn:microsoft.com/office/officeart/2008/layout/HorizontalMultiLevelHierarchy"/>
    <dgm:cxn modelId="{EB0F7634-270E-A540-98D1-83625D5F7699}" type="presParOf" srcId="{6BCA1F02-8423-418F-9214-DC6DF4276FFE}" destId="{5D1B088A-A6CF-436C-847E-34048BAA346B}" srcOrd="0" destOrd="0" presId="urn:microsoft.com/office/officeart/2008/layout/HorizontalMultiLevelHierarchy"/>
    <dgm:cxn modelId="{9D6D9953-1A8C-5346-8443-7976C6BCEBC4}" type="presParOf" srcId="{72E62747-30D6-4D1D-BB89-7F1C84ED7D04}" destId="{396B2AA2-6C08-4E7A-A836-7AEB28A67016}" srcOrd="17" destOrd="0" presId="urn:microsoft.com/office/officeart/2008/layout/HorizontalMultiLevelHierarchy"/>
    <dgm:cxn modelId="{440B80E0-5EC4-B44F-90C2-D1C2B176527D}" type="presParOf" srcId="{396B2AA2-6C08-4E7A-A836-7AEB28A67016}" destId="{61CF67B4-D647-467C-824B-AF05E62F23FB}" srcOrd="0" destOrd="0" presId="urn:microsoft.com/office/officeart/2008/layout/HorizontalMultiLevelHierarchy"/>
    <dgm:cxn modelId="{D4EF3B5B-63B6-F242-9150-5A5B870344FE}" type="presParOf" srcId="{396B2AA2-6C08-4E7A-A836-7AEB28A67016}" destId="{A75CC12B-0811-443A-915D-ACFDF90823DB}" srcOrd="1" destOrd="0" presId="urn:microsoft.com/office/officeart/2008/layout/HorizontalMultiLevelHierarchy"/>
    <dgm:cxn modelId="{4FD06D7C-6285-D346-90EA-762A06A5D712}" type="presParOf" srcId="{A75CC12B-0811-443A-915D-ACFDF90823DB}" destId="{78B80AB1-7240-47D1-922D-C9649794E709}" srcOrd="0" destOrd="0" presId="urn:microsoft.com/office/officeart/2008/layout/HorizontalMultiLevelHierarchy"/>
    <dgm:cxn modelId="{3F07A506-8FC8-FF47-A458-A9FDD03C5F4E}" type="presParOf" srcId="{78B80AB1-7240-47D1-922D-C9649794E709}" destId="{002E5ACD-8ABF-455A-8C9E-D93151678682}" srcOrd="0" destOrd="0" presId="urn:microsoft.com/office/officeart/2008/layout/HorizontalMultiLevelHierarchy"/>
    <dgm:cxn modelId="{BA096E13-715A-E941-B18F-38D321158645}" type="presParOf" srcId="{A75CC12B-0811-443A-915D-ACFDF90823DB}" destId="{076FDF0A-567C-43B7-8744-615E84133173}" srcOrd="1" destOrd="0" presId="urn:microsoft.com/office/officeart/2008/layout/HorizontalMultiLevelHierarchy"/>
    <dgm:cxn modelId="{C20A8394-03CE-1242-9A12-CD72C8463A48}" type="presParOf" srcId="{076FDF0A-567C-43B7-8744-615E84133173}" destId="{7ECB0AE2-150A-4134-A298-5547C3F26CC0}" srcOrd="0" destOrd="0" presId="urn:microsoft.com/office/officeart/2008/layout/HorizontalMultiLevelHierarchy"/>
    <dgm:cxn modelId="{1C6B8C10-3B0C-3A45-ADFB-6576D513FA50}" type="presParOf" srcId="{076FDF0A-567C-43B7-8744-615E84133173}" destId="{A737CAAA-B37D-4951-A10B-3E1CE4C783CF}" srcOrd="1" destOrd="0" presId="urn:microsoft.com/office/officeart/2008/layout/HorizontalMultiLevelHierarchy"/>
    <dgm:cxn modelId="{7C24D67D-0C21-F14E-A6EE-376F0B346967}" type="presParOf" srcId="{72E62747-30D6-4D1D-BB89-7F1C84ED7D04}" destId="{33744C96-8DA5-4082-B453-52DC4E69799B}" srcOrd="18" destOrd="0" presId="urn:microsoft.com/office/officeart/2008/layout/HorizontalMultiLevelHierarchy"/>
    <dgm:cxn modelId="{8937A145-F152-0E49-BEF2-437C40E3E1C2}" type="presParOf" srcId="{33744C96-8DA5-4082-B453-52DC4E69799B}" destId="{395AD0D9-A03B-44EE-82E5-6516F1FB7018}" srcOrd="0" destOrd="0" presId="urn:microsoft.com/office/officeart/2008/layout/HorizontalMultiLevelHierarchy"/>
    <dgm:cxn modelId="{AB3B20C8-EB66-A24C-9028-D6D553C0716E}" type="presParOf" srcId="{72E62747-30D6-4D1D-BB89-7F1C84ED7D04}" destId="{92D70978-EB02-49BF-89EE-74845B611F58}" srcOrd="19" destOrd="0" presId="urn:microsoft.com/office/officeart/2008/layout/HorizontalMultiLevelHierarchy"/>
    <dgm:cxn modelId="{D14F054C-5FA9-E64A-9379-ECE150DB08D7}" type="presParOf" srcId="{92D70978-EB02-49BF-89EE-74845B611F58}" destId="{C02522A6-04F2-4AE6-8CAF-62FE2C1A4E36}" srcOrd="0" destOrd="0" presId="urn:microsoft.com/office/officeart/2008/layout/HorizontalMultiLevelHierarchy"/>
    <dgm:cxn modelId="{EBD71DF4-2C67-CB4A-9248-E2779F8E3C4A}" type="presParOf" srcId="{92D70978-EB02-49BF-89EE-74845B611F58}" destId="{43AF969D-AD8B-419B-9197-222F9B5EE5CD}" srcOrd="1" destOrd="0" presId="urn:microsoft.com/office/officeart/2008/layout/HorizontalMultiLevelHierarchy"/>
    <dgm:cxn modelId="{63319F73-2E83-784E-BC18-9B30901AB755}" type="presParOf" srcId="{43AF969D-AD8B-419B-9197-222F9B5EE5CD}" destId="{AAB712C3-60DD-4845-987A-871BB6E7CBC6}" srcOrd="0" destOrd="0" presId="urn:microsoft.com/office/officeart/2008/layout/HorizontalMultiLevelHierarchy"/>
    <dgm:cxn modelId="{F1E87113-1B6E-6D48-8884-9DD501DFCF87}" type="presParOf" srcId="{AAB712C3-60DD-4845-987A-871BB6E7CBC6}" destId="{52AB65B6-28A3-4533-A9EF-7617A8BF08E3}" srcOrd="0" destOrd="0" presId="urn:microsoft.com/office/officeart/2008/layout/HorizontalMultiLevelHierarchy"/>
    <dgm:cxn modelId="{6E45C3ED-8D27-DB4D-B541-9809AC6DC562}" type="presParOf" srcId="{43AF969D-AD8B-419B-9197-222F9B5EE5CD}" destId="{1ED3D240-D738-488A-8D27-E1C77EC10FE8}" srcOrd="1" destOrd="0" presId="urn:microsoft.com/office/officeart/2008/layout/HorizontalMultiLevelHierarchy"/>
    <dgm:cxn modelId="{B702B7A0-647F-A34C-9905-82F485B52AD5}" type="presParOf" srcId="{1ED3D240-D738-488A-8D27-E1C77EC10FE8}" destId="{4F5011DB-67AE-4DCB-A763-22674F8C3D79}" srcOrd="0" destOrd="0" presId="urn:microsoft.com/office/officeart/2008/layout/HorizontalMultiLevelHierarchy"/>
    <dgm:cxn modelId="{9FE2A59F-D204-0E44-A94B-9DC384C5103A}" type="presParOf" srcId="{1ED3D240-D738-488A-8D27-E1C77EC10FE8}" destId="{8C45CDFC-9AD9-4E56-8356-EAE71E0568C7}" srcOrd="1" destOrd="0" presId="urn:microsoft.com/office/officeart/2008/layout/HorizontalMultiLevelHierarchy"/>
    <dgm:cxn modelId="{35CD5CC2-7478-5148-BA9A-8B6A60CC558C}" type="presParOf" srcId="{664D5179-8A0A-40FC-BD45-DB24978D6F15}" destId="{C6F9E6C5-B465-4544-8E33-CD9BD0A1F830}" srcOrd="2" destOrd="0" presId="urn:microsoft.com/office/officeart/2008/layout/HorizontalMultiLevelHierarchy"/>
    <dgm:cxn modelId="{F4170F68-F509-CA41-B491-0B7FD643C4C7}" type="presParOf" srcId="{C6F9E6C5-B465-4544-8E33-CD9BD0A1F830}" destId="{81ECD647-6338-4A37-8423-A264D2E2EB4E}" srcOrd="0" destOrd="0" presId="urn:microsoft.com/office/officeart/2008/layout/HorizontalMultiLevelHierarchy"/>
    <dgm:cxn modelId="{52B1625A-4D7D-C64B-A120-6EF7EC77061A}" type="presParOf" srcId="{664D5179-8A0A-40FC-BD45-DB24978D6F15}" destId="{88F5CEF5-0C27-464B-B6BD-9E09561C064D}" srcOrd="3" destOrd="0" presId="urn:microsoft.com/office/officeart/2008/layout/HorizontalMultiLevelHierarchy"/>
    <dgm:cxn modelId="{EB62E252-1E31-0B48-B310-F4EAE60C2CC5}" type="presParOf" srcId="{88F5CEF5-0C27-464B-B6BD-9E09561C064D}" destId="{17ABBCEC-A837-48DB-99C5-BD19A8A746C1}" srcOrd="0" destOrd="0" presId="urn:microsoft.com/office/officeart/2008/layout/HorizontalMultiLevelHierarchy"/>
    <dgm:cxn modelId="{5541E177-78FF-4348-A473-78116A8B283C}" type="presParOf" srcId="{88F5CEF5-0C27-464B-B6BD-9E09561C064D}" destId="{B847E7E4-4A05-4B83-8B59-BEBC0C50AB29}" srcOrd="1" destOrd="0" presId="urn:microsoft.com/office/officeart/2008/layout/HorizontalMultiLevelHierarchy"/>
    <dgm:cxn modelId="{9E8CB81F-9011-C146-AFE2-CC02D830CE92}" type="presParOf" srcId="{664D5179-8A0A-40FC-BD45-DB24978D6F15}" destId="{830B9FBE-FD6D-4E41-8F80-CDFE00D42519}" srcOrd="4" destOrd="0" presId="urn:microsoft.com/office/officeart/2008/layout/HorizontalMultiLevelHierarchy"/>
    <dgm:cxn modelId="{AB5DDAF0-F6FF-8C4C-8D08-A165E3DA5460}" type="presParOf" srcId="{830B9FBE-FD6D-4E41-8F80-CDFE00D42519}" destId="{CFF7D72D-25B0-47E4-B9D9-793E1490B4AC}" srcOrd="0" destOrd="0" presId="urn:microsoft.com/office/officeart/2008/layout/HorizontalMultiLevelHierarchy"/>
    <dgm:cxn modelId="{07668CFC-12BB-D74C-B961-F490EB54FC35}" type="presParOf" srcId="{664D5179-8A0A-40FC-BD45-DB24978D6F15}" destId="{8DC67C18-53C7-422A-B9E1-68B09239E91A}" srcOrd="5" destOrd="0" presId="urn:microsoft.com/office/officeart/2008/layout/HorizontalMultiLevelHierarchy"/>
    <dgm:cxn modelId="{935F8958-E5E5-CC46-AABC-5F0CCD9B1A05}" type="presParOf" srcId="{8DC67C18-53C7-422A-B9E1-68B09239E91A}" destId="{B526AE86-C759-48C4-8513-9B514B692BF9}" srcOrd="0" destOrd="0" presId="urn:microsoft.com/office/officeart/2008/layout/HorizontalMultiLevelHierarchy"/>
    <dgm:cxn modelId="{423B231A-7BC1-5549-85E8-566B4D526546}" type="presParOf" srcId="{8DC67C18-53C7-422A-B9E1-68B09239E91A}" destId="{1D96A57B-F3F1-4163-88AD-354FCB61DAA9}" srcOrd="1" destOrd="0" presId="urn:microsoft.com/office/officeart/2008/layout/HorizontalMultiLevelHierarchy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30B9FBE-FD6D-4E41-8F80-CDFE00D42519}">
      <dsp:nvSpPr>
        <dsp:cNvPr id="0" name=""/>
        <dsp:cNvSpPr/>
      </dsp:nvSpPr>
      <dsp:spPr>
        <a:xfrm>
          <a:off x="852400" y="4213141"/>
          <a:ext cx="172026" cy="92605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926050"/>
              </a:lnTo>
              <a:lnTo>
                <a:pt x="172026" y="926050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914866" y="4652619"/>
        <a:ext cx="47094" cy="47094"/>
      </dsp:txXfrm>
    </dsp:sp>
    <dsp:sp modelId="{C6F9E6C5-B465-4544-8E33-CD9BD0A1F830}">
      <dsp:nvSpPr>
        <dsp:cNvPr id="0" name=""/>
        <dsp:cNvSpPr/>
      </dsp:nvSpPr>
      <dsp:spPr>
        <a:xfrm>
          <a:off x="852400" y="3628622"/>
          <a:ext cx="172026" cy="584518"/>
        </a:xfrm>
        <a:custGeom>
          <a:avLst/>
          <a:gdLst/>
          <a:ahLst/>
          <a:cxnLst/>
          <a:rect l="0" t="0" r="0" b="0"/>
          <a:pathLst>
            <a:path>
              <a:moveTo>
                <a:pt x="0" y="584518"/>
              </a:moveTo>
              <a:lnTo>
                <a:pt x="86013" y="584518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923181" y="3905649"/>
        <a:ext cx="30465" cy="30465"/>
      </dsp:txXfrm>
    </dsp:sp>
    <dsp:sp modelId="{AAB712C3-60DD-4845-987A-871BB6E7CBC6}">
      <dsp:nvSpPr>
        <dsp:cNvPr id="0" name=""/>
        <dsp:cNvSpPr/>
      </dsp:nvSpPr>
      <dsp:spPr>
        <a:xfrm>
          <a:off x="4722217" y="4744538"/>
          <a:ext cx="162539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81269" y="45720"/>
              </a:lnTo>
              <a:lnTo>
                <a:pt x="81269" y="47115"/>
              </a:lnTo>
              <a:lnTo>
                <a:pt x="162539" y="47115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799423" y="4786195"/>
        <a:ext cx="8127" cy="8127"/>
      </dsp:txXfrm>
    </dsp:sp>
    <dsp:sp modelId="{33744C96-8DA5-4082-B453-52DC4E69799B}">
      <dsp:nvSpPr>
        <dsp:cNvPr id="0" name=""/>
        <dsp:cNvSpPr/>
      </dsp:nvSpPr>
      <dsp:spPr>
        <a:xfrm>
          <a:off x="3035250" y="2702572"/>
          <a:ext cx="218860" cy="208768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109430" y="0"/>
              </a:lnTo>
              <a:lnTo>
                <a:pt x="109430" y="2087686"/>
              </a:lnTo>
              <a:lnTo>
                <a:pt x="218860" y="208768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700" kern="1200"/>
        </a:p>
      </dsp:txBody>
      <dsp:txXfrm>
        <a:off x="3092202" y="3693937"/>
        <a:ext cx="104956" cy="104956"/>
      </dsp:txXfrm>
    </dsp:sp>
    <dsp:sp modelId="{78B80AB1-7240-47D1-922D-C9649794E709}">
      <dsp:nvSpPr>
        <dsp:cNvPr id="0" name=""/>
        <dsp:cNvSpPr/>
      </dsp:nvSpPr>
      <dsp:spPr>
        <a:xfrm>
          <a:off x="5292098" y="5201996"/>
          <a:ext cx="209485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209485" y="4572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5391603" y="5242479"/>
        <a:ext cx="10474" cy="10474"/>
      </dsp:txXfrm>
    </dsp:sp>
    <dsp:sp modelId="{6BCA1F02-8423-418F-9214-DC6DF4276FFE}">
      <dsp:nvSpPr>
        <dsp:cNvPr id="0" name=""/>
        <dsp:cNvSpPr/>
      </dsp:nvSpPr>
      <dsp:spPr>
        <a:xfrm>
          <a:off x="3035250" y="2702572"/>
          <a:ext cx="209493" cy="254514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104746" y="0"/>
              </a:lnTo>
              <a:lnTo>
                <a:pt x="104746" y="2545144"/>
              </a:lnTo>
              <a:lnTo>
                <a:pt x="209493" y="2545144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900" kern="1200"/>
        </a:p>
      </dsp:txBody>
      <dsp:txXfrm>
        <a:off x="3076153" y="3911300"/>
        <a:ext cx="127687" cy="127687"/>
      </dsp:txXfrm>
    </dsp:sp>
    <dsp:sp modelId="{F518CB70-8FC6-45C6-9986-0BCFA38267AE}">
      <dsp:nvSpPr>
        <dsp:cNvPr id="0" name=""/>
        <dsp:cNvSpPr/>
      </dsp:nvSpPr>
      <dsp:spPr>
        <a:xfrm>
          <a:off x="4875871" y="4340119"/>
          <a:ext cx="172026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172026" y="4572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957584" y="4381538"/>
        <a:ext cx="8601" cy="8601"/>
      </dsp:txXfrm>
    </dsp:sp>
    <dsp:sp modelId="{576E1488-9ED3-4594-83C4-9410252E7C78}">
      <dsp:nvSpPr>
        <dsp:cNvPr id="0" name=""/>
        <dsp:cNvSpPr/>
      </dsp:nvSpPr>
      <dsp:spPr>
        <a:xfrm>
          <a:off x="3035250" y="2702572"/>
          <a:ext cx="172026" cy="16832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1683267"/>
              </a:lnTo>
              <a:lnTo>
                <a:pt x="172026" y="168326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600" kern="1200"/>
        </a:p>
      </dsp:txBody>
      <dsp:txXfrm>
        <a:off x="3078963" y="3501905"/>
        <a:ext cx="84601" cy="84601"/>
      </dsp:txXfrm>
    </dsp:sp>
    <dsp:sp modelId="{E9416659-BBF5-4BD3-BE43-3B132573EE58}">
      <dsp:nvSpPr>
        <dsp:cNvPr id="0" name=""/>
        <dsp:cNvSpPr/>
      </dsp:nvSpPr>
      <dsp:spPr>
        <a:xfrm>
          <a:off x="4385407" y="4056522"/>
          <a:ext cx="172026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172026" y="4572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467120" y="4097942"/>
        <a:ext cx="8601" cy="8601"/>
      </dsp:txXfrm>
    </dsp:sp>
    <dsp:sp modelId="{2FCF096E-BB8B-4040-A659-ADA3B7C0E269}">
      <dsp:nvSpPr>
        <dsp:cNvPr id="0" name=""/>
        <dsp:cNvSpPr/>
      </dsp:nvSpPr>
      <dsp:spPr>
        <a:xfrm>
          <a:off x="3035250" y="2702572"/>
          <a:ext cx="172026" cy="139967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1399670"/>
              </a:lnTo>
              <a:lnTo>
                <a:pt x="172026" y="139967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3086008" y="3367152"/>
        <a:ext cx="70510" cy="70510"/>
      </dsp:txXfrm>
    </dsp:sp>
    <dsp:sp modelId="{960E4D89-EE87-4C6C-A706-B7013A8D6463}">
      <dsp:nvSpPr>
        <dsp:cNvPr id="0" name=""/>
        <dsp:cNvSpPr/>
      </dsp:nvSpPr>
      <dsp:spPr>
        <a:xfrm>
          <a:off x="4067408" y="3780820"/>
          <a:ext cx="172026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172026" y="4572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149120" y="3822239"/>
        <a:ext cx="8601" cy="8601"/>
      </dsp:txXfrm>
    </dsp:sp>
    <dsp:sp modelId="{1CE5CB39-D3E9-4A7B-9C67-A233A6D7A627}">
      <dsp:nvSpPr>
        <dsp:cNvPr id="0" name=""/>
        <dsp:cNvSpPr/>
      </dsp:nvSpPr>
      <dsp:spPr>
        <a:xfrm>
          <a:off x="3035250" y="2702572"/>
          <a:ext cx="172026" cy="112396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1123968"/>
              </a:lnTo>
              <a:lnTo>
                <a:pt x="172026" y="1123968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3092837" y="3236129"/>
        <a:ext cx="56852" cy="56852"/>
      </dsp:txXfrm>
    </dsp:sp>
    <dsp:sp modelId="{0B1934E3-BED7-41C6-8334-56CDE0C18457}">
      <dsp:nvSpPr>
        <dsp:cNvPr id="0" name=""/>
        <dsp:cNvSpPr/>
      </dsp:nvSpPr>
      <dsp:spPr>
        <a:xfrm>
          <a:off x="4468694" y="3216218"/>
          <a:ext cx="172026" cy="16389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163896"/>
              </a:lnTo>
              <a:lnTo>
                <a:pt x="172026" y="16389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548767" y="3292226"/>
        <a:ext cx="11880" cy="11880"/>
      </dsp:txXfrm>
    </dsp:sp>
    <dsp:sp modelId="{E963BCA4-358F-4E84-A754-9B3BA2A663D7}">
      <dsp:nvSpPr>
        <dsp:cNvPr id="0" name=""/>
        <dsp:cNvSpPr/>
      </dsp:nvSpPr>
      <dsp:spPr>
        <a:xfrm>
          <a:off x="4468694" y="3052321"/>
          <a:ext cx="172026" cy="163896"/>
        </a:xfrm>
        <a:custGeom>
          <a:avLst/>
          <a:gdLst/>
          <a:ahLst/>
          <a:cxnLst/>
          <a:rect l="0" t="0" r="0" b="0"/>
          <a:pathLst>
            <a:path>
              <a:moveTo>
                <a:pt x="0" y="163896"/>
              </a:moveTo>
              <a:lnTo>
                <a:pt x="86013" y="163896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548767" y="3128329"/>
        <a:ext cx="11880" cy="11880"/>
      </dsp:txXfrm>
    </dsp:sp>
    <dsp:sp modelId="{EDB39F50-E6A5-4BE9-B9EE-7CBD1C48E142}">
      <dsp:nvSpPr>
        <dsp:cNvPr id="0" name=""/>
        <dsp:cNvSpPr/>
      </dsp:nvSpPr>
      <dsp:spPr>
        <a:xfrm>
          <a:off x="3035250" y="2702572"/>
          <a:ext cx="172026" cy="51364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513645"/>
              </a:lnTo>
              <a:lnTo>
                <a:pt x="172026" y="513645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3107721" y="2945852"/>
        <a:ext cx="27084" cy="27084"/>
      </dsp:txXfrm>
    </dsp:sp>
    <dsp:sp modelId="{E68CF398-FB37-46D5-AE40-35211BBBB345}">
      <dsp:nvSpPr>
        <dsp:cNvPr id="0" name=""/>
        <dsp:cNvSpPr/>
      </dsp:nvSpPr>
      <dsp:spPr>
        <a:xfrm>
          <a:off x="5724511" y="2605895"/>
          <a:ext cx="172026" cy="65558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655587"/>
              </a:lnTo>
              <a:lnTo>
                <a:pt x="172026" y="65558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5793580" y="2916745"/>
        <a:ext cx="33889" cy="33889"/>
      </dsp:txXfrm>
    </dsp:sp>
    <dsp:sp modelId="{EC21EC01-6866-4C21-816F-7D5367748A93}">
      <dsp:nvSpPr>
        <dsp:cNvPr id="0" name=""/>
        <dsp:cNvSpPr/>
      </dsp:nvSpPr>
      <dsp:spPr>
        <a:xfrm>
          <a:off x="5724511" y="2605895"/>
          <a:ext cx="172026" cy="32779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327793"/>
              </a:lnTo>
              <a:lnTo>
                <a:pt x="172026" y="32779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5801270" y="2760538"/>
        <a:ext cx="18509" cy="18509"/>
      </dsp:txXfrm>
    </dsp:sp>
    <dsp:sp modelId="{F33BF1B9-AED9-42A3-BD05-2C4D658A0E82}">
      <dsp:nvSpPr>
        <dsp:cNvPr id="0" name=""/>
        <dsp:cNvSpPr/>
      </dsp:nvSpPr>
      <dsp:spPr>
        <a:xfrm>
          <a:off x="5724511" y="2560175"/>
          <a:ext cx="172026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172026" y="4572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5806224" y="2601595"/>
        <a:ext cx="8601" cy="8601"/>
      </dsp:txXfrm>
    </dsp:sp>
    <dsp:sp modelId="{D8521D54-7213-4694-BBC0-4F888AA592CD}">
      <dsp:nvSpPr>
        <dsp:cNvPr id="0" name=""/>
        <dsp:cNvSpPr/>
      </dsp:nvSpPr>
      <dsp:spPr>
        <a:xfrm>
          <a:off x="5724511" y="2278101"/>
          <a:ext cx="172026" cy="327793"/>
        </a:xfrm>
        <a:custGeom>
          <a:avLst/>
          <a:gdLst/>
          <a:ahLst/>
          <a:cxnLst/>
          <a:rect l="0" t="0" r="0" b="0"/>
          <a:pathLst>
            <a:path>
              <a:moveTo>
                <a:pt x="0" y="327793"/>
              </a:moveTo>
              <a:lnTo>
                <a:pt x="86013" y="327793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5801270" y="2432744"/>
        <a:ext cx="18509" cy="18509"/>
      </dsp:txXfrm>
    </dsp:sp>
    <dsp:sp modelId="{85680CD6-D861-4B8C-B4BB-D395BF852CF2}">
      <dsp:nvSpPr>
        <dsp:cNvPr id="0" name=""/>
        <dsp:cNvSpPr/>
      </dsp:nvSpPr>
      <dsp:spPr>
        <a:xfrm>
          <a:off x="5724511" y="1950307"/>
          <a:ext cx="172026" cy="655587"/>
        </a:xfrm>
        <a:custGeom>
          <a:avLst/>
          <a:gdLst/>
          <a:ahLst/>
          <a:cxnLst/>
          <a:rect l="0" t="0" r="0" b="0"/>
          <a:pathLst>
            <a:path>
              <a:moveTo>
                <a:pt x="0" y="655587"/>
              </a:moveTo>
              <a:lnTo>
                <a:pt x="86013" y="655587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5793580" y="2261157"/>
        <a:ext cx="33889" cy="33889"/>
      </dsp:txXfrm>
    </dsp:sp>
    <dsp:sp modelId="{50582FA0-BBE9-41F5-B774-DF272A2E7640}">
      <dsp:nvSpPr>
        <dsp:cNvPr id="0" name=""/>
        <dsp:cNvSpPr/>
      </dsp:nvSpPr>
      <dsp:spPr>
        <a:xfrm>
          <a:off x="3035250" y="2605895"/>
          <a:ext cx="172026" cy="96676"/>
        </a:xfrm>
        <a:custGeom>
          <a:avLst/>
          <a:gdLst/>
          <a:ahLst/>
          <a:cxnLst/>
          <a:rect l="0" t="0" r="0" b="0"/>
          <a:pathLst>
            <a:path>
              <a:moveTo>
                <a:pt x="0" y="96676"/>
              </a:moveTo>
              <a:lnTo>
                <a:pt x="86013" y="96676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3116330" y="2649300"/>
        <a:ext cx="9866" cy="9866"/>
      </dsp:txXfrm>
    </dsp:sp>
    <dsp:sp modelId="{0690BAF6-2E3E-48F7-B419-76D80DEF1285}">
      <dsp:nvSpPr>
        <dsp:cNvPr id="0" name=""/>
        <dsp:cNvSpPr/>
      </dsp:nvSpPr>
      <dsp:spPr>
        <a:xfrm>
          <a:off x="4269427" y="1950307"/>
          <a:ext cx="172026" cy="32779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327793"/>
              </a:lnTo>
              <a:lnTo>
                <a:pt x="172026" y="32779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346185" y="2104950"/>
        <a:ext cx="18509" cy="18509"/>
      </dsp:txXfrm>
    </dsp:sp>
    <dsp:sp modelId="{641C7868-5C94-4B0C-AE68-14A543E74986}">
      <dsp:nvSpPr>
        <dsp:cNvPr id="0" name=""/>
        <dsp:cNvSpPr/>
      </dsp:nvSpPr>
      <dsp:spPr>
        <a:xfrm>
          <a:off x="4269427" y="1904587"/>
          <a:ext cx="172026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172026" y="4572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351140" y="1946007"/>
        <a:ext cx="8601" cy="8601"/>
      </dsp:txXfrm>
    </dsp:sp>
    <dsp:sp modelId="{80816A0F-AC68-4311-884A-5F8A58F08D7A}">
      <dsp:nvSpPr>
        <dsp:cNvPr id="0" name=""/>
        <dsp:cNvSpPr/>
      </dsp:nvSpPr>
      <dsp:spPr>
        <a:xfrm>
          <a:off x="4269427" y="1622513"/>
          <a:ext cx="172026" cy="327793"/>
        </a:xfrm>
        <a:custGeom>
          <a:avLst/>
          <a:gdLst/>
          <a:ahLst/>
          <a:cxnLst/>
          <a:rect l="0" t="0" r="0" b="0"/>
          <a:pathLst>
            <a:path>
              <a:moveTo>
                <a:pt x="0" y="327793"/>
              </a:moveTo>
              <a:lnTo>
                <a:pt x="86013" y="327793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346185" y="1777156"/>
        <a:ext cx="18509" cy="18509"/>
      </dsp:txXfrm>
    </dsp:sp>
    <dsp:sp modelId="{C8FC8D5D-30F7-471E-B8B8-5F224FEE8B53}">
      <dsp:nvSpPr>
        <dsp:cNvPr id="0" name=""/>
        <dsp:cNvSpPr/>
      </dsp:nvSpPr>
      <dsp:spPr>
        <a:xfrm>
          <a:off x="3035250" y="1950307"/>
          <a:ext cx="172026" cy="752264"/>
        </a:xfrm>
        <a:custGeom>
          <a:avLst/>
          <a:gdLst/>
          <a:ahLst/>
          <a:cxnLst/>
          <a:rect l="0" t="0" r="0" b="0"/>
          <a:pathLst>
            <a:path>
              <a:moveTo>
                <a:pt x="0" y="752264"/>
              </a:moveTo>
              <a:lnTo>
                <a:pt x="86013" y="752264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3101971" y="2307147"/>
        <a:ext cx="38584" cy="38584"/>
      </dsp:txXfrm>
    </dsp:sp>
    <dsp:sp modelId="{59EFD662-F5B9-4E51-96F1-5AF65A05E852}">
      <dsp:nvSpPr>
        <dsp:cNvPr id="0" name=""/>
        <dsp:cNvSpPr/>
      </dsp:nvSpPr>
      <dsp:spPr>
        <a:xfrm>
          <a:off x="4543654" y="966925"/>
          <a:ext cx="172026" cy="327793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86013" y="0"/>
              </a:lnTo>
              <a:lnTo>
                <a:pt x="86013" y="327793"/>
              </a:lnTo>
              <a:lnTo>
                <a:pt x="172026" y="327793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620412" y="1121568"/>
        <a:ext cx="18509" cy="18509"/>
      </dsp:txXfrm>
    </dsp:sp>
    <dsp:sp modelId="{A4E749FA-28E1-4471-ACD8-81F784E93244}">
      <dsp:nvSpPr>
        <dsp:cNvPr id="0" name=""/>
        <dsp:cNvSpPr/>
      </dsp:nvSpPr>
      <dsp:spPr>
        <a:xfrm>
          <a:off x="4543654" y="921205"/>
          <a:ext cx="172026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172026" y="4572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625367" y="962625"/>
        <a:ext cx="8601" cy="8601"/>
      </dsp:txXfrm>
    </dsp:sp>
    <dsp:sp modelId="{145B8CA3-BB26-4DB4-AC81-AFBE26AF21EB}">
      <dsp:nvSpPr>
        <dsp:cNvPr id="0" name=""/>
        <dsp:cNvSpPr/>
      </dsp:nvSpPr>
      <dsp:spPr>
        <a:xfrm>
          <a:off x="4543654" y="639131"/>
          <a:ext cx="172026" cy="327793"/>
        </a:xfrm>
        <a:custGeom>
          <a:avLst/>
          <a:gdLst/>
          <a:ahLst/>
          <a:cxnLst/>
          <a:rect l="0" t="0" r="0" b="0"/>
          <a:pathLst>
            <a:path>
              <a:moveTo>
                <a:pt x="0" y="327793"/>
              </a:moveTo>
              <a:lnTo>
                <a:pt x="86013" y="327793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620412" y="793774"/>
        <a:ext cx="18509" cy="18509"/>
      </dsp:txXfrm>
    </dsp:sp>
    <dsp:sp modelId="{FFB10C08-8AB4-475C-A934-5DA1E07ACD7C}">
      <dsp:nvSpPr>
        <dsp:cNvPr id="0" name=""/>
        <dsp:cNvSpPr/>
      </dsp:nvSpPr>
      <dsp:spPr>
        <a:xfrm>
          <a:off x="3035250" y="966925"/>
          <a:ext cx="172026" cy="1735646"/>
        </a:xfrm>
        <a:custGeom>
          <a:avLst/>
          <a:gdLst/>
          <a:ahLst/>
          <a:cxnLst/>
          <a:rect l="0" t="0" r="0" b="0"/>
          <a:pathLst>
            <a:path>
              <a:moveTo>
                <a:pt x="0" y="1735646"/>
              </a:moveTo>
              <a:lnTo>
                <a:pt x="86013" y="1735646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600" kern="1200"/>
        </a:p>
      </dsp:txBody>
      <dsp:txXfrm>
        <a:off x="3077660" y="1791145"/>
        <a:ext cx="87207" cy="87207"/>
      </dsp:txXfrm>
    </dsp:sp>
    <dsp:sp modelId="{AA29A888-0A17-4B4C-870A-E5E95ABD4FAA}">
      <dsp:nvSpPr>
        <dsp:cNvPr id="0" name=""/>
        <dsp:cNvSpPr/>
      </dsp:nvSpPr>
      <dsp:spPr>
        <a:xfrm>
          <a:off x="4378776" y="265617"/>
          <a:ext cx="172026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172026" y="4572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4460488" y="307037"/>
        <a:ext cx="8601" cy="8601"/>
      </dsp:txXfrm>
    </dsp:sp>
    <dsp:sp modelId="{3EA92CF5-981D-4617-8805-BD784484C463}">
      <dsp:nvSpPr>
        <dsp:cNvPr id="0" name=""/>
        <dsp:cNvSpPr/>
      </dsp:nvSpPr>
      <dsp:spPr>
        <a:xfrm>
          <a:off x="3035250" y="311337"/>
          <a:ext cx="172026" cy="2391234"/>
        </a:xfrm>
        <a:custGeom>
          <a:avLst/>
          <a:gdLst/>
          <a:ahLst/>
          <a:cxnLst/>
          <a:rect l="0" t="0" r="0" b="0"/>
          <a:pathLst>
            <a:path>
              <a:moveTo>
                <a:pt x="0" y="2391234"/>
              </a:moveTo>
              <a:lnTo>
                <a:pt x="86013" y="2391234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800" kern="1200"/>
        </a:p>
      </dsp:txBody>
      <dsp:txXfrm>
        <a:off x="3061328" y="1447019"/>
        <a:ext cx="119870" cy="119870"/>
      </dsp:txXfrm>
    </dsp:sp>
    <dsp:sp modelId="{C3824F10-A10E-4549-B7A9-1C8ED929AE83}">
      <dsp:nvSpPr>
        <dsp:cNvPr id="0" name=""/>
        <dsp:cNvSpPr/>
      </dsp:nvSpPr>
      <dsp:spPr>
        <a:xfrm>
          <a:off x="852400" y="2702572"/>
          <a:ext cx="172026" cy="1510569"/>
        </a:xfrm>
        <a:custGeom>
          <a:avLst/>
          <a:gdLst/>
          <a:ahLst/>
          <a:cxnLst/>
          <a:rect l="0" t="0" r="0" b="0"/>
          <a:pathLst>
            <a:path>
              <a:moveTo>
                <a:pt x="0" y="1510569"/>
              </a:moveTo>
              <a:lnTo>
                <a:pt x="86013" y="1510569"/>
              </a:lnTo>
              <a:lnTo>
                <a:pt x="86013" y="0"/>
              </a:lnTo>
              <a:lnTo>
                <a:pt x="172026" y="0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" kern="1200"/>
        </a:p>
      </dsp:txBody>
      <dsp:txXfrm>
        <a:off x="900405" y="3419848"/>
        <a:ext cx="76016" cy="76016"/>
      </dsp:txXfrm>
    </dsp:sp>
    <dsp:sp modelId="{1358FD25-A296-417B-8C32-0545935AECEA}">
      <dsp:nvSpPr>
        <dsp:cNvPr id="0" name=""/>
        <dsp:cNvSpPr/>
      </dsp:nvSpPr>
      <dsp:spPr>
        <a:xfrm rot="16200000">
          <a:off x="31190" y="4082023"/>
          <a:ext cx="1380185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500" kern="1200" dirty="0" smtClean="0">
              <a:latin typeface="Arial" panose="020B0604020202020204" pitchFamily="34" charset="0"/>
              <a:cs typeface="Arial" panose="020B0604020202020204" pitchFamily="34" charset="0"/>
            </a:rPr>
            <a:t>50 </a:t>
          </a:r>
          <a:r>
            <a:rPr lang="en-US" sz="1500" kern="1200" dirty="0">
              <a:latin typeface="Arial" panose="020B0604020202020204" pitchFamily="34" charset="0"/>
              <a:cs typeface="Arial" panose="020B0604020202020204" pitchFamily="34" charset="0"/>
            </a:rPr>
            <a:t>unique trials</a:t>
          </a:r>
        </a:p>
      </dsp:txBody>
      <dsp:txXfrm>
        <a:off x="31190" y="4082023"/>
        <a:ext cx="1380185" cy="262235"/>
      </dsp:txXfrm>
    </dsp:sp>
    <dsp:sp modelId="{5950EC2C-60B2-40BD-A6A0-E7A8BAC442F1}">
      <dsp:nvSpPr>
        <dsp:cNvPr id="0" name=""/>
        <dsp:cNvSpPr/>
      </dsp:nvSpPr>
      <dsp:spPr>
        <a:xfrm>
          <a:off x="1024426" y="2542683"/>
          <a:ext cx="2010823" cy="31977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17 indications</a:t>
          </a:r>
        </a:p>
      </dsp:txBody>
      <dsp:txXfrm>
        <a:off x="1024426" y="2542683"/>
        <a:ext cx="2010823" cy="319777"/>
      </dsp:txXfrm>
    </dsp:sp>
    <dsp:sp modelId="{20D5FBEA-911F-425D-A3CA-BF1B3A8EE1DA}">
      <dsp:nvSpPr>
        <dsp:cNvPr id="0" name=""/>
        <dsp:cNvSpPr/>
      </dsp:nvSpPr>
      <dsp:spPr>
        <a:xfrm>
          <a:off x="3207277" y="4813"/>
          <a:ext cx="1171499" cy="613048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Achromatopia CNGA3 (2); CNGB3 (2)</a:t>
          </a:r>
        </a:p>
      </dsp:txBody>
      <dsp:txXfrm>
        <a:off x="3207277" y="4813"/>
        <a:ext cx="1171499" cy="613048"/>
      </dsp:txXfrm>
    </dsp:sp>
    <dsp:sp modelId="{034CFA1F-7B89-45F2-B399-AD34489603B2}">
      <dsp:nvSpPr>
        <dsp:cNvPr id="0" name=""/>
        <dsp:cNvSpPr/>
      </dsp:nvSpPr>
      <dsp:spPr>
        <a:xfrm>
          <a:off x="4550802" y="180220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/2</a:t>
          </a:r>
        </a:p>
      </dsp:txBody>
      <dsp:txXfrm>
        <a:off x="4550802" y="180220"/>
        <a:ext cx="860131" cy="262235"/>
      </dsp:txXfrm>
    </dsp:sp>
    <dsp:sp modelId="{833AEC7A-B99D-48C0-871D-A4179B8964EB}">
      <dsp:nvSpPr>
        <dsp:cNvPr id="0" name=""/>
        <dsp:cNvSpPr/>
      </dsp:nvSpPr>
      <dsp:spPr>
        <a:xfrm>
          <a:off x="3207277" y="835808"/>
          <a:ext cx="1336377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Choroideremia (8)</a:t>
          </a:r>
        </a:p>
      </dsp:txBody>
      <dsp:txXfrm>
        <a:off x="3207277" y="835808"/>
        <a:ext cx="1336377" cy="262235"/>
      </dsp:txXfrm>
    </dsp:sp>
    <dsp:sp modelId="{2CBD4155-2ED1-46FA-83BC-97CAA04F9980}">
      <dsp:nvSpPr>
        <dsp:cNvPr id="0" name=""/>
        <dsp:cNvSpPr/>
      </dsp:nvSpPr>
      <dsp:spPr>
        <a:xfrm>
          <a:off x="4715680" y="508014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/2 (3)</a:t>
          </a:r>
        </a:p>
      </dsp:txBody>
      <dsp:txXfrm>
        <a:off x="4715680" y="508014"/>
        <a:ext cx="860131" cy="262235"/>
      </dsp:txXfrm>
    </dsp:sp>
    <dsp:sp modelId="{32191076-4C62-4EFB-974A-465CDC7D6560}">
      <dsp:nvSpPr>
        <dsp:cNvPr id="0" name=""/>
        <dsp:cNvSpPr/>
      </dsp:nvSpPr>
      <dsp:spPr>
        <a:xfrm>
          <a:off x="4715680" y="835808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2 (4)</a:t>
          </a:r>
        </a:p>
      </dsp:txBody>
      <dsp:txXfrm>
        <a:off x="4715680" y="835808"/>
        <a:ext cx="860131" cy="262235"/>
      </dsp:txXfrm>
    </dsp:sp>
    <dsp:sp modelId="{F3622D4E-BCD1-4B03-B6CA-2B65BC37B6F2}">
      <dsp:nvSpPr>
        <dsp:cNvPr id="0" name=""/>
        <dsp:cNvSpPr/>
      </dsp:nvSpPr>
      <dsp:spPr>
        <a:xfrm>
          <a:off x="4715680" y="1163602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3 (1)</a:t>
          </a:r>
        </a:p>
      </dsp:txBody>
      <dsp:txXfrm>
        <a:off x="4715680" y="1163602"/>
        <a:ext cx="860131" cy="262235"/>
      </dsp:txXfrm>
    </dsp:sp>
    <dsp:sp modelId="{1127B8D7-3CD0-4F1D-9C2C-F99E8698E420}">
      <dsp:nvSpPr>
        <dsp:cNvPr id="0" name=""/>
        <dsp:cNvSpPr/>
      </dsp:nvSpPr>
      <dsp:spPr>
        <a:xfrm>
          <a:off x="3207277" y="1819190"/>
          <a:ext cx="1062150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LCA RPE65 (9); CEP290 (1)</a:t>
          </a:r>
        </a:p>
      </dsp:txBody>
      <dsp:txXfrm>
        <a:off x="3207277" y="1819190"/>
        <a:ext cx="1062150" cy="262235"/>
      </dsp:txXfrm>
    </dsp:sp>
    <dsp:sp modelId="{C3950836-6B16-410D-AB8D-A64C6FAB238C}">
      <dsp:nvSpPr>
        <dsp:cNvPr id="0" name=""/>
        <dsp:cNvSpPr/>
      </dsp:nvSpPr>
      <dsp:spPr>
        <a:xfrm>
          <a:off x="4441453" y="1491396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 (3)</a:t>
          </a:r>
        </a:p>
      </dsp:txBody>
      <dsp:txXfrm>
        <a:off x="4441453" y="1491396"/>
        <a:ext cx="860131" cy="262235"/>
      </dsp:txXfrm>
    </dsp:sp>
    <dsp:sp modelId="{1933C373-9436-497B-AC32-4A55FA51135A}">
      <dsp:nvSpPr>
        <dsp:cNvPr id="0" name=""/>
        <dsp:cNvSpPr/>
      </dsp:nvSpPr>
      <dsp:spPr>
        <a:xfrm>
          <a:off x="4441453" y="1819190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/2 (5)</a:t>
          </a:r>
        </a:p>
      </dsp:txBody>
      <dsp:txXfrm>
        <a:off x="4441453" y="1819190"/>
        <a:ext cx="860131" cy="262235"/>
      </dsp:txXfrm>
    </dsp:sp>
    <dsp:sp modelId="{4BB45888-D1DE-4D55-A070-864FDC435C39}">
      <dsp:nvSpPr>
        <dsp:cNvPr id="0" name=""/>
        <dsp:cNvSpPr/>
      </dsp:nvSpPr>
      <dsp:spPr>
        <a:xfrm>
          <a:off x="4441453" y="2146984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3 (1)</a:t>
          </a:r>
        </a:p>
      </dsp:txBody>
      <dsp:txXfrm>
        <a:off x="4441453" y="2146984"/>
        <a:ext cx="860131" cy="262235"/>
      </dsp:txXfrm>
    </dsp:sp>
    <dsp:sp modelId="{5388DEAC-EED5-488A-BF01-C492E1548169}">
      <dsp:nvSpPr>
        <dsp:cNvPr id="0" name=""/>
        <dsp:cNvSpPr/>
      </dsp:nvSpPr>
      <dsp:spPr>
        <a:xfrm>
          <a:off x="3207277" y="2474778"/>
          <a:ext cx="2517234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LHON (8)</a:t>
          </a:r>
        </a:p>
      </dsp:txBody>
      <dsp:txXfrm>
        <a:off x="3207277" y="2474778"/>
        <a:ext cx="2517234" cy="262235"/>
      </dsp:txXfrm>
    </dsp:sp>
    <dsp:sp modelId="{C1DDE8C2-4167-4CB5-9227-79BD5883663D}">
      <dsp:nvSpPr>
        <dsp:cNvPr id="0" name=""/>
        <dsp:cNvSpPr/>
      </dsp:nvSpPr>
      <dsp:spPr>
        <a:xfrm>
          <a:off x="5896538" y="1819190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 (1)</a:t>
          </a:r>
        </a:p>
      </dsp:txBody>
      <dsp:txXfrm>
        <a:off x="5896538" y="1819190"/>
        <a:ext cx="860131" cy="262235"/>
      </dsp:txXfrm>
    </dsp:sp>
    <dsp:sp modelId="{9A8BBF3E-80F7-4CDC-8949-9486CC82C37E}">
      <dsp:nvSpPr>
        <dsp:cNvPr id="0" name=""/>
        <dsp:cNvSpPr/>
      </dsp:nvSpPr>
      <dsp:spPr>
        <a:xfrm>
          <a:off x="5896538" y="2146984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/2 (2)</a:t>
          </a:r>
        </a:p>
      </dsp:txBody>
      <dsp:txXfrm>
        <a:off x="5896538" y="2146984"/>
        <a:ext cx="860131" cy="262235"/>
      </dsp:txXfrm>
    </dsp:sp>
    <dsp:sp modelId="{597BC5DD-74CC-47C5-AD40-3A868FED9E4F}">
      <dsp:nvSpPr>
        <dsp:cNvPr id="0" name=""/>
        <dsp:cNvSpPr/>
      </dsp:nvSpPr>
      <dsp:spPr>
        <a:xfrm>
          <a:off x="5896538" y="2474778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2/3 (1)</a:t>
          </a:r>
        </a:p>
      </dsp:txBody>
      <dsp:txXfrm>
        <a:off x="5896538" y="2474778"/>
        <a:ext cx="860131" cy="262235"/>
      </dsp:txXfrm>
    </dsp:sp>
    <dsp:sp modelId="{D95317B9-76BE-4111-8A76-04456BE5B4E4}">
      <dsp:nvSpPr>
        <dsp:cNvPr id="0" name=""/>
        <dsp:cNvSpPr/>
      </dsp:nvSpPr>
      <dsp:spPr>
        <a:xfrm>
          <a:off x="5896538" y="2802572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3 (3)</a:t>
          </a:r>
        </a:p>
      </dsp:txBody>
      <dsp:txXfrm>
        <a:off x="5896538" y="2802572"/>
        <a:ext cx="860131" cy="262235"/>
      </dsp:txXfrm>
    </dsp:sp>
    <dsp:sp modelId="{D2BED35C-0932-451D-A00D-15E358B75803}">
      <dsp:nvSpPr>
        <dsp:cNvPr id="0" name=""/>
        <dsp:cNvSpPr/>
      </dsp:nvSpPr>
      <dsp:spPr>
        <a:xfrm>
          <a:off x="5896538" y="3130366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Unspecified (2)</a:t>
          </a:r>
        </a:p>
      </dsp:txBody>
      <dsp:txXfrm>
        <a:off x="5896538" y="3130366"/>
        <a:ext cx="860131" cy="262235"/>
      </dsp:txXfrm>
    </dsp:sp>
    <dsp:sp modelId="{21F2160D-B234-45C3-831F-32DA92F9E092}">
      <dsp:nvSpPr>
        <dsp:cNvPr id="0" name=""/>
        <dsp:cNvSpPr/>
      </dsp:nvSpPr>
      <dsp:spPr>
        <a:xfrm>
          <a:off x="3207277" y="2802572"/>
          <a:ext cx="1261417" cy="827291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RP RPGR (3); MERTK (1); PDE6</a:t>
          </a:r>
          <a:r>
            <a:rPr lang="el-GR" sz="900" kern="1200">
              <a:latin typeface="Arial" panose="020B0604020202020204" pitchFamily="34" charset="0"/>
              <a:cs typeface="Arial" panose="020B0604020202020204" pitchFamily="34" charset="0"/>
            </a:rPr>
            <a:t>β</a:t>
          </a:r>
          <a:r>
            <a:rPr lang="en-GB" sz="900" kern="1200">
              <a:latin typeface="Arial" panose="020B0604020202020204" pitchFamily="34" charset="0"/>
              <a:cs typeface="Arial" panose="020B0604020202020204" pitchFamily="34" charset="0"/>
            </a:rPr>
            <a:t> (1); RLBP1 (1); Non-syndromic (1); Advanced RP (1)</a:t>
          </a:r>
          <a:endParaRPr lang="en-US" sz="900" kern="120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3207277" y="2802572"/>
        <a:ext cx="1261417" cy="827291"/>
      </dsp:txXfrm>
    </dsp:sp>
    <dsp:sp modelId="{AEC6F2D4-95D5-48AD-82E9-6283D5B7C839}">
      <dsp:nvSpPr>
        <dsp:cNvPr id="0" name=""/>
        <dsp:cNvSpPr/>
      </dsp:nvSpPr>
      <dsp:spPr>
        <a:xfrm>
          <a:off x="4640720" y="2921203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 (1)</a:t>
          </a:r>
        </a:p>
      </dsp:txBody>
      <dsp:txXfrm>
        <a:off x="4640720" y="2921203"/>
        <a:ext cx="860131" cy="262235"/>
      </dsp:txXfrm>
    </dsp:sp>
    <dsp:sp modelId="{0ED870BF-DE06-43B1-B8FD-733691756967}">
      <dsp:nvSpPr>
        <dsp:cNvPr id="0" name=""/>
        <dsp:cNvSpPr/>
      </dsp:nvSpPr>
      <dsp:spPr>
        <a:xfrm>
          <a:off x="4640720" y="3248997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/2 ()</a:t>
          </a:r>
        </a:p>
      </dsp:txBody>
      <dsp:txXfrm>
        <a:off x="4640720" y="3248997"/>
        <a:ext cx="860131" cy="262235"/>
      </dsp:txXfrm>
    </dsp:sp>
    <dsp:sp modelId="{B3C580F2-FB1F-46D6-A574-03FF7B6D6BE1}">
      <dsp:nvSpPr>
        <dsp:cNvPr id="0" name=""/>
        <dsp:cNvSpPr/>
      </dsp:nvSpPr>
      <dsp:spPr>
        <a:xfrm>
          <a:off x="3207277" y="3695422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err="1" smtClean="0">
              <a:latin typeface="Arial" panose="020B0604020202020204" pitchFamily="34" charset="0"/>
              <a:cs typeface="Arial" panose="020B0604020202020204" pitchFamily="34" charset="0"/>
            </a:rPr>
            <a:t>Stagardts</a:t>
          </a: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 (1)</a:t>
          </a:r>
          <a:endParaRPr lang="en-US" sz="9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3207277" y="3695422"/>
        <a:ext cx="860131" cy="262235"/>
      </dsp:txXfrm>
    </dsp:sp>
    <dsp:sp modelId="{85DBA0F4-5A3C-4403-96FB-0B04850D1882}">
      <dsp:nvSpPr>
        <dsp:cNvPr id="0" name=""/>
        <dsp:cNvSpPr/>
      </dsp:nvSpPr>
      <dsp:spPr>
        <a:xfrm>
          <a:off x="4239434" y="3703317"/>
          <a:ext cx="860131" cy="246446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Phase 1/2</a:t>
          </a:r>
        </a:p>
      </dsp:txBody>
      <dsp:txXfrm>
        <a:off x="4239434" y="3703317"/>
        <a:ext cx="860131" cy="246446"/>
      </dsp:txXfrm>
    </dsp:sp>
    <dsp:sp modelId="{72636010-4576-474C-8CDC-44780E4BDC8F}">
      <dsp:nvSpPr>
        <dsp:cNvPr id="0" name=""/>
        <dsp:cNvSpPr/>
      </dsp:nvSpPr>
      <dsp:spPr>
        <a:xfrm>
          <a:off x="3207277" y="4031641"/>
          <a:ext cx="1178130" cy="141203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Gyrate atrophy (1)</a:t>
          </a:r>
          <a:endParaRPr lang="en-US" sz="9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3207277" y="4031641"/>
        <a:ext cx="1178130" cy="141203"/>
      </dsp:txXfrm>
    </dsp:sp>
    <dsp:sp modelId="{ED81DF27-18D8-4CB1-B441-682B76EBC6C3}">
      <dsp:nvSpPr>
        <dsp:cNvPr id="0" name=""/>
        <dsp:cNvSpPr/>
      </dsp:nvSpPr>
      <dsp:spPr>
        <a:xfrm>
          <a:off x="4557433" y="4015322"/>
          <a:ext cx="860131" cy="173840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Phase I</a:t>
          </a:r>
          <a:endParaRPr lang="en-US" sz="9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4557433" y="4015322"/>
        <a:ext cx="860131" cy="173840"/>
      </dsp:txXfrm>
    </dsp:sp>
    <dsp:sp modelId="{41832CCF-0117-4FEC-B465-24629687F834}">
      <dsp:nvSpPr>
        <dsp:cNvPr id="0" name=""/>
        <dsp:cNvSpPr/>
      </dsp:nvSpPr>
      <dsp:spPr>
        <a:xfrm>
          <a:off x="3207277" y="4254721"/>
          <a:ext cx="1668594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X-linked retinoschisis (1)</a:t>
          </a:r>
        </a:p>
      </dsp:txBody>
      <dsp:txXfrm>
        <a:off x="3207277" y="4254721"/>
        <a:ext cx="1668594" cy="262235"/>
      </dsp:txXfrm>
    </dsp:sp>
    <dsp:sp modelId="{00C4BBE0-EBF3-4395-A6F4-1E6BC19228B5}">
      <dsp:nvSpPr>
        <dsp:cNvPr id="0" name=""/>
        <dsp:cNvSpPr/>
      </dsp:nvSpPr>
      <dsp:spPr>
        <a:xfrm>
          <a:off x="5047898" y="4254721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/2</a:t>
          </a:r>
        </a:p>
      </dsp:txBody>
      <dsp:txXfrm>
        <a:off x="5047898" y="4254721"/>
        <a:ext cx="860131" cy="262235"/>
      </dsp:txXfrm>
    </dsp:sp>
    <dsp:sp modelId="{61CF67B4-D647-467C-824B-AF05E62F23FB}">
      <dsp:nvSpPr>
        <dsp:cNvPr id="0" name=""/>
        <dsp:cNvSpPr/>
      </dsp:nvSpPr>
      <dsp:spPr>
        <a:xfrm>
          <a:off x="3244744" y="5022722"/>
          <a:ext cx="2047353" cy="449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AMD dry (1); </a:t>
          </a:r>
          <a:r>
            <a:rPr lang="en-US" sz="900" kern="1200" dirty="0" err="1">
              <a:latin typeface="Arial" panose="020B0604020202020204" pitchFamily="34" charset="0"/>
              <a:cs typeface="Arial" panose="020B0604020202020204" pitchFamily="34" charset="0"/>
            </a:rPr>
            <a:t>neovascular</a:t>
          </a: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 (4)</a:t>
          </a:r>
        </a:p>
      </dsp:txBody>
      <dsp:txXfrm>
        <a:off x="3244744" y="5022722"/>
        <a:ext cx="2047353" cy="449987"/>
      </dsp:txXfrm>
    </dsp:sp>
    <dsp:sp modelId="{7ECB0AE2-150A-4134-A298-5547C3F26CC0}">
      <dsp:nvSpPr>
        <dsp:cNvPr id="0" name=""/>
        <dsp:cNvSpPr/>
      </dsp:nvSpPr>
      <dsp:spPr>
        <a:xfrm>
          <a:off x="5501583" y="5116598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 (5)</a:t>
          </a:r>
        </a:p>
      </dsp:txBody>
      <dsp:txXfrm>
        <a:off x="5501583" y="5116598"/>
        <a:ext cx="860131" cy="262235"/>
      </dsp:txXfrm>
    </dsp:sp>
    <dsp:sp modelId="{C02522A6-04F2-4AE6-8CAF-62FE2C1A4E36}">
      <dsp:nvSpPr>
        <dsp:cNvPr id="0" name=""/>
        <dsp:cNvSpPr/>
      </dsp:nvSpPr>
      <dsp:spPr>
        <a:xfrm>
          <a:off x="3254111" y="4639124"/>
          <a:ext cx="1468106" cy="302268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Ushers syndrome 1B</a:t>
          </a:r>
        </a:p>
      </dsp:txBody>
      <dsp:txXfrm>
        <a:off x="3254111" y="4639124"/>
        <a:ext cx="1468106" cy="302268"/>
      </dsp:txXfrm>
    </dsp:sp>
    <dsp:sp modelId="{4F5011DB-67AE-4DCB-A763-22674F8C3D79}">
      <dsp:nvSpPr>
        <dsp:cNvPr id="0" name=""/>
        <dsp:cNvSpPr/>
      </dsp:nvSpPr>
      <dsp:spPr>
        <a:xfrm>
          <a:off x="4884756" y="4660536"/>
          <a:ext cx="860131" cy="262235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>
              <a:latin typeface="Arial" panose="020B0604020202020204" pitchFamily="34" charset="0"/>
              <a:cs typeface="Arial" panose="020B0604020202020204" pitchFamily="34" charset="0"/>
            </a:rPr>
            <a:t>Phase 1/2</a:t>
          </a:r>
        </a:p>
      </dsp:txBody>
      <dsp:txXfrm>
        <a:off x="4884756" y="4660536"/>
        <a:ext cx="860131" cy="262235"/>
      </dsp:txXfrm>
    </dsp:sp>
    <dsp:sp modelId="{17ABBCEC-A837-48DB-99C5-BD19A8A746C1}">
      <dsp:nvSpPr>
        <dsp:cNvPr id="0" name=""/>
        <dsp:cNvSpPr/>
      </dsp:nvSpPr>
      <dsp:spPr>
        <a:xfrm>
          <a:off x="1024426" y="2928019"/>
          <a:ext cx="2004562" cy="1401206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Not yet recruiting (2)</a:t>
          </a:r>
          <a:b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Recruiting (</a:t>
          </a: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24)</a:t>
          </a: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/>
          </a:r>
          <a:b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Active (13)</a:t>
          </a:r>
          <a:b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Completed </a:t>
          </a: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(11)</a:t>
          </a:r>
          <a:endParaRPr lang="en-US" sz="9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24426" y="2928019"/>
        <a:ext cx="2004562" cy="1401206"/>
      </dsp:txXfrm>
    </dsp:sp>
    <dsp:sp modelId="{B526AE86-C759-48C4-8513-9B514B692BF9}">
      <dsp:nvSpPr>
        <dsp:cNvPr id="0" name=""/>
        <dsp:cNvSpPr/>
      </dsp:nvSpPr>
      <dsp:spPr>
        <a:xfrm>
          <a:off x="1024426" y="4394785"/>
          <a:ext cx="1992477" cy="1488814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715" tIns="5715" rIns="5715" bIns="5715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Europe (</a:t>
          </a: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13)</a:t>
          </a: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/>
          </a:r>
          <a:b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North America </a:t>
          </a: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(21)</a:t>
          </a: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/>
          </a:r>
          <a:b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Cross-continent </a:t>
          </a: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(10)</a:t>
          </a: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/>
          </a:r>
          <a:b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No details (2)</a:t>
          </a:r>
          <a:b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</a:br>
          <a:r>
            <a:rPr lang="en-US" sz="900" kern="1200" dirty="0">
              <a:latin typeface="Arial" panose="020B0604020202020204" pitchFamily="34" charset="0"/>
              <a:cs typeface="Arial" panose="020B0604020202020204" pitchFamily="34" charset="0"/>
            </a:rPr>
            <a:t>Other </a:t>
          </a:r>
          <a:r>
            <a:rPr lang="en-US" sz="900" kern="1200" dirty="0" smtClean="0">
              <a:latin typeface="Arial" panose="020B0604020202020204" pitchFamily="34" charset="0"/>
              <a:cs typeface="Arial" panose="020B0604020202020204" pitchFamily="34" charset="0"/>
            </a:rPr>
            <a:t>(4)</a:t>
          </a:r>
          <a:endParaRPr lang="en-US" sz="9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1024426" y="4394785"/>
        <a:ext cx="1992477" cy="148881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8/layout/HorizontalMultiLevelHierarchy">
  <dgm:title val=""/>
  <dgm:desc val=""/>
  <dgm:catLst>
    <dgm:cat type="hierarchy" pri="46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</dgm:cxnLst>
      <dgm:bg/>
      <dgm:whole/>
    </dgm:dataModel>
  </dgm:sampData>
  <dgm:style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</dgm:cxnLst>
      <dgm:bg/>
      <dgm:whole/>
    </dgm:dataModel>
  </dgm:styleData>
  <dgm:clr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</dgm:cxnLst>
      <dgm:bg/>
      <dgm:whole/>
    </dgm:dataModel>
  </dgm:clrData>
  <dgm:layoutNode name="Name0">
    <dgm:varLst>
      <dgm:chPref val="1"/>
      <dgm:dir/>
      <dgm:animOne val="branch"/>
      <dgm:animLvl val="lvl"/>
      <dgm:resizeHandles val="exact"/>
    </dgm:varLst>
    <dgm:choose name="Name1">
      <dgm:if name="Name2" func="var" arg="dir" op="equ" val="norm">
        <dgm:alg type="hierChild">
          <dgm:param type="linDir" val="fromT"/>
          <dgm:param type="chAlign" val="l"/>
        </dgm:alg>
      </dgm:if>
      <dgm:else name="Name3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des" forName="LevelOneTextNode" refType="h"/>
      <dgm:constr type="w" for="des" forName="LevelOneTextNode" refType="h" refFor="des" refForName="LevelOneTextNode" fact="0.19"/>
      <dgm:constr type="h" for="des" forName="LevelTwoTextNode" refType="w" refFor="des" refForName="LevelOneTextNode"/>
      <dgm:constr type="w" for="des" forName="LevelTwoTextNode" refType="h" refFor="des" refForName="LevelTwoTextNode" fact="3.28"/>
      <dgm:constr type="sibSp" refType="h" refFor="des" refForName="LevelTwoTextNode" op="equ" fact="0.25"/>
      <dgm:constr type="sibSp" for="des" forName="level2hierChild" refType="h" refFor="des" refForName="LevelTwoTextNode" op="equ" fact="0.25"/>
      <dgm:constr type="sibSp" for="des" forName="level3hierChild" refType="h" refFor="des" refForName="LevelTwoTextNode" op="equ" fact="0.25"/>
      <dgm:constr type="sp" for="des" forName="root1" refType="w" refFor="des" refForName="LevelTwoTextNode" fact="0.2"/>
      <dgm:constr type="sp" for="des" forName="root2" refType="sp" refFor="des" refForName="root1" op="equ"/>
      <dgm:constr type="primFontSz" for="des" forName="LevelOneTextNode" op="equ" val="65"/>
      <dgm:constr type="primFontSz" for="des" forName="LevelTwoTextNode" op="equ" val="65"/>
      <dgm:constr type="primFontSz" for="des" forName="LevelTwoTextNode" refType="primFontSz" refFor="des" refForName="LevelOneTextNode" op="lte"/>
      <dgm:constr type="primFontSz" for="des" forName="connTx" op="equ" val="50"/>
      <dgm:constr type="primFontSz" for="des" forName="connTx" refType="primFontSz" refFor="des" refForName="LevelOneTextNode" op="lte" fact="0.78"/>
    </dgm:constrLst>
    <dgm:forEach name="Name4" axis="ch">
      <dgm:forEach name="Name5" axis="self" ptType="node">
        <dgm:layoutNode name="root1">
          <dgm:choose name="Name6">
            <dgm:if name="Name7" func="var" arg="dir" op="equ" val="norm">
              <dgm:alg type="hierRoot">
                <dgm:param type="hierAlign" val="lCtrCh"/>
              </dgm:alg>
            </dgm:if>
            <dgm:else name="Name8">
              <dgm:alg type="hierRoot">
                <dgm:param type="hierAlign" val="rCtrCh"/>
              </dgm:alg>
            </dgm:else>
          </dgm:choose>
          <dgm:shape xmlns:r="http://schemas.openxmlformats.org/officeDocument/2006/relationships" r:blip="">
            <dgm:adjLst/>
          </dgm:shape>
          <dgm:presOf/>
          <dgm:layoutNode name="LevelOneTextNode" styleLbl="node0">
            <dgm:varLst>
              <dgm:chPref val="3"/>
            </dgm:varLst>
            <dgm:alg type="tx">
              <dgm:param type="autoTxRot" val="grav"/>
            </dgm:alg>
            <dgm:choose name="Name9">
              <dgm:if name="Name10" func="var" arg="dir" op="equ" val="norm">
                <dgm:shape xmlns:r="http://schemas.openxmlformats.org/officeDocument/2006/relationships" rot="270" type="rect" r:blip="">
                  <dgm:adjLst/>
                </dgm:shape>
              </dgm:if>
              <dgm:else name="Name11">
                <dgm:shape xmlns:r="http://schemas.openxmlformats.org/officeDocument/2006/relationships" rot="90" type="rect" r:blip="">
                  <dgm:adjLst/>
                </dgm:shape>
              </dgm:else>
            </dgm:choose>
            <dgm:presOf axis="self"/>
            <dgm:constrLst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2" fact="NaN" max="NaN"/>
            </dgm:ruleLst>
          </dgm:layoutNode>
          <dgm:layoutNode name="level2hierChild">
            <dgm:choose name="Name12">
              <dgm:if name="Name13" func="var" arg="dir" op="equ" val="norm">
                <dgm:alg type="hierChild">
                  <dgm:param type="linDir" val="fromT"/>
                  <dgm:param type="chAlign" val="l"/>
                </dgm:alg>
              </dgm:if>
              <dgm:else name="Name14">
                <dgm:alg type="hierChild">
                  <dgm:param type="linDir" val="fromT"/>
                  <dgm:param type="chAlign" val="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forEach name="repeat" axis="ch">
              <dgm:forEach name="Name15" axis="self" ptType="parTrans" cnt="1">
                <dgm:layoutNode name="conn2-1">
                  <dgm:choose name="Name16">
                    <dgm:if name="Name17" func="var" arg="dir" op="equ" val="norm">
                      <dgm:alg type="conn">
                        <dgm:param type="dim" val="1D"/>
                        <dgm:param type="begPts" val="midR"/>
                        <dgm:param type="endPts" val="midL"/>
                        <dgm:param type="endSty" val="noArr"/>
                        <dgm:param type="connRout" val="bend"/>
                      </dgm:alg>
                    </dgm:if>
                    <dgm:else name="Name18">
                      <dgm:alg type="conn">
                        <dgm:param type="dim" val="1D"/>
                        <dgm:param type="begPts" val="midL"/>
                        <dgm:param type="endPts" val="midR"/>
                        <dgm:param type="endSty" val="noArr"/>
                        <dgm:param type="connRout" val="bend"/>
                      </dgm:alg>
                    </dgm:else>
                  </dgm:choose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w" val="1"/>
                    <dgm:constr type="h" val="5"/>
                    <dgm:constr type="connDist"/>
                    <dgm:constr type="begPad"/>
                    <dgm:constr type="endPad"/>
                    <dgm:constr type="userA" for="ch" refType="connDist"/>
                  </dgm:constrLst>
                  <dgm:layoutNode name="connTx">
                    <dgm:alg type="tx">
                      <dgm:param type="autoTxRot" val="grav"/>
                    </dgm:alg>
                    <dgm:shape xmlns:r="http://schemas.openxmlformats.org/officeDocument/2006/relationships" type="rect" r:blip="" hideGeom="1">
                      <dgm:adjLst/>
                    </dgm:shape>
                    <dgm:presOf axis="self"/>
                    <dgm:constrLst>
                      <dgm:constr type="userA"/>
                      <dgm:constr type="w" refType="userA" fact="0.05"/>
                      <dgm:constr type="h" refType="userA" fact="0.05"/>
                      <dgm:constr type="lMarg" val="1"/>
                      <dgm:constr type="rMarg" val="1"/>
                      <dgm:constr type="tMarg"/>
                      <dgm:constr type="bMarg"/>
                    </dgm:constrLst>
                    <dgm:ruleLst>
                      <dgm:rule type="h" val="NaN" fact="0.25" max="NaN"/>
                      <dgm:rule type="w" val="NaN" fact="0.8" max="NaN"/>
                      <dgm:rule type="primFontSz" val="5" fact="NaN" max="NaN"/>
                    </dgm:ruleLst>
                  </dgm:layoutNode>
                </dgm:layoutNode>
              </dgm:forEach>
              <dgm:forEach name="Name19" axis="self" ptType="node">
                <dgm:layoutNode name="root2">
                  <dgm:choose name="Name20">
                    <dgm:if name="Name21" func="var" arg="dir" op="equ" val="norm">
                      <dgm:alg type="hierRoot">
                        <dgm:param type="hierAlign" val="lCtrCh"/>
                      </dgm:alg>
                    </dgm:if>
                    <dgm:else name="Name22">
                      <dgm:alg type="hierRoot">
                        <dgm:param type="hierAlign" val="rCtrCh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layoutNode name="LevelTwoTextNode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/>
                    <dgm:constrLst>
                      <dgm:constr type="tMarg" refType="primFontSz" fact="0.05"/>
                      <dgm:constr type="bMarg" refType="primFontSz" fact="0.05"/>
                      <dgm:constr type="lMarg" refType="primFontSz" fact="0.05"/>
                      <dgm:constr type="rMarg" refType="primFontSz" fact="0.05"/>
                    </dgm:constrLst>
                    <dgm:ruleLst>
                      <dgm:rule type="primFontSz" val="2" fact="NaN" max="NaN"/>
                    </dgm:ruleLst>
                  </dgm:layoutNode>
                  <dgm:layoutNode name="level3hierChild">
                    <dgm:choose name="Name23">
                      <dgm:if name="Name24" func="var" arg="dir" op="equ" val="norm">
                        <dgm:alg type="hierChild">
                          <dgm:param type="linDir" val="fromT"/>
                          <dgm:param type="chAlign" val="l"/>
                        </dgm:alg>
                      </dgm:if>
                      <dgm:else name="Name25">
                        <dgm:alg type="hierChild">
                          <dgm:param type="linDir" val="fromT"/>
                          <dgm:param type="chAlign" val="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forEach name="Name26" ref="repeat"/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172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225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516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7306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0264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5692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823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6598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8750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336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3196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2FB538-F7EC-4223-95CB-A416CA811097}" type="datetimeFigureOut">
              <a:rPr lang="en-GB" smtClean="0"/>
              <a:t>24/1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1F2CA1-C297-4C01-964D-01456E3D4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64203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/>
          <p:nvPr>
            <p:extLst>
              <p:ext uri="{D42A27DB-BD31-4B8C-83A1-F6EECF244321}">
                <p14:modId xmlns:p14="http://schemas.microsoft.com/office/powerpoint/2010/main" val="1999325076"/>
              </p:ext>
            </p:extLst>
          </p:nvPr>
        </p:nvGraphicFramePr>
        <p:xfrm>
          <a:off x="855055" y="452582"/>
          <a:ext cx="7346835" cy="588841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67553" y="600635"/>
            <a:ext cx="2904565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ary of details found for gene therapy human clinical trials detailing location, indication and trial phas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23719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192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sleen Jolly</dc:creator>
  <cp:lastModifiedBy>Jasleen Jolly</cp:lastModifiedBy>
  <cp:revision>5</cp:revision>
  <dcterms:created xsi:type="dcterms:W3CDTF">2018-06-24T22:35:54Z</dcterms:created>
  <dcterms:modified xsi:type="dcterms:W3CDTF">2018-12-24T22:38:11Z</dcterms:modified>
</cp:coreProperties>
</file>